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60" r:id="rId2"/>
  </p:sldIdLst>
  <p:sldSz cx="13320713" cy="83153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9" userDrawn="1">
          <p15:clr>
            <a:srgbClr val="A4A3A4"/>
          </p15:clr>
        </p15:guide>
        <p15:guide id="2" pos="41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8000"/>
    <a:srgbClr val="AD07E3"/>
    <a:srgbClr val="0000FF"/>
    <a:srgbClr val="CC66FF"/>
    <a:srgbClr val="FC4E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4" d="100"/>
          <a:sy n="94" d="100"/>
        </p:scale>
        <p:origin x="900" y="102"/>
      </p:cViewPr>
      <p:guideLst>
        <p:guide orient="horz" pos="2619"/>
        <p:guide pos="4196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OSBOIS Cloé" userId="5f57a020-64f6-4ab3-8391-eb78b3388ff7" providerId="ADAL" clId="{04CEA349-5FBF-4870-AB25-B4AC333B31C8}"/>
    <pc:docChg chg="modSld">
      <pc:chgData name="GROSBOIS Cloé" userId="5f57a020-64f6-4ab3-8391-eb78b3388ff7" providerId="ADAL" clId="{04CEA349-5FBF-4870-AB25-B4AC333B31C8}" dt="2024-11-13T15:18:05.993" v="87" actId="20577"/>
      <pc:docMkLst>
        <pc:docMk/>
      </pc:docMkLst>
      <pc:sldChg chg="modSp mod">
        <pc:chgData name="GROSBOIS Cloé" userId="5f57a020-64f6-4ab3-8391-eb78b3388ff7" providerId="ADAL" clId="{04CEA349-5FBF-4870-AB25-B4AC333B31C8}" dt="2024-11-13T15:18:05.993" v="87" actId="20577"/>
        <pc:sldMkLst>
          <pc:docMk/>
          <pc:sldMk cId="1004786018" sldId="260"/>
        </pc:sldMkLst>
        <pc:spChg chg="mod">
          <ac:chgData name="GROSBOIS Cloé" userId="5f57a020-64f6-4ab3-8391-eb78b3388ff7" providerId="ADAL" clId="{04CEA349-5FBF-4870-AB25-B4AC333B31C8}" dt="2024-11-13T15:12:41.734" v="5" actId="20577"/>
          <ac:spMkLst>
            <pc:docMk/>
            <pc:sldMk cId="1004786018" sldId="260"/>
            <ac:spMk id="2" creationId="{68C2C617-BB3B-50C5-0FB6-7A7A18CBA56A}"/>
          </ac:spMkLst>
        </pc:spChg>
        <pc:spChg chg="mod">
          <ac:chgData name="GROSBOIS Cloé" userId="5f57a020-64f6-4ab3-8391-eb78b3388ff7" providerId="ADAL" clId="{04CEA349-5FBF-4870-AB25-B4AC333B31C8}" dt="2024-11-13T15:12:45.426" v="7" actId="20577"/>
          <ac:spMkLst>
            <pc:docMk/>
            <pc:sldMk cId="1004786018" sldId="260"/>
            <ac:spMk id="3" creationId="{5C90947D-B2C4-7AEB-2523-731F4D319E29}"/>
          </ac:spMkLst>
        </pc:spChg>
        <pc:spChg chg="mod">
          <ac:chgData name="GROSBOIS Cloé" userId="5f57a020-64f6-4ab3-8391-eb78b3388ff7" providerId="ADAL" clId="{04CEA349-5FBF-4870-AB25-B4AC333B31C8}" dt="2024-11-13T15:12:48.857" v="9" actId="20577"/>
          <ac:spMkLst>
            <pc:docMk/>
            <pc:sldMk cId="1004786018" sldId="260"/>
            <ac:spMk id="4" creationId="{75CC009F-9892-7A7E-E131-2B69B5A9EC14}"/>
          </ac:spMkLst>
        </pc:spChg>
        <pc:spChg chg="mod">
          <ac:chgData name="GROSBOIS Cloé" userId="5f57a020-64f6-4ab3-8391-eb78b3388ff7" providerId="ADAL" clId="{04CEA349-5FBF-4870-AB25-B4AC333B31C8}" dt="2024-11-13T15:12:52.541" v="11" actId="20577"/>
          <ac:spMkLst>
            <pc:docMk/>
            <pc:sldMk cId="1004786018" sldId="260"/>
            <ac:spMk id="5" creationId="{42474194-5220-D193-93F9-03C84AA2CF11}"/>
          </ac:spMkLst>
        </pc:spChg>
        <pc:spChg chg="mod">
          <ac:chgData name="GROSBOIS Cloé" userId="5f57a020-64f6-4ab3-8391-eb78b3388ff7" providerId="ADAL" clId="{04CEA349-5FBF-4870-AB25-B4AC333B31C8}" dt="2024-11-13T15:13:22.490" v="29" actId="20577"/>
          <ac:spMkLst>
            <pc:docMk/>
            <pc:sldMk cId="1004786018" sldId="260"/>
            <ac:spMk id="115" creationId="{35B7D5CD-65FE-41B0-AE17-C70CDB1F0679}"/>
          </ac:spMkLst>
        </pc:spChg>
        <pc:spChg chg="mod">
          <ac:chgData name="GROSBOIS Cloé" userId="5f57a020-64f6-4ab3-8391-eb78b3388ff7" providerId="ADAL" clId="{04CEA349-5FBF-4870-AB25-B4AC333B31C8}" dt="2024-11-13T15:13:25.247" v="31" actId="20577"/>
          <ac:spMkLst>
            <pc:docMk/>
            <pc:sldMk cId="1004786018" sldId="260"/>
            <ac:spMk id="121" creationId="{70BDEEEC-9366-4F7E-8DF6-A7B6D723E573}"/>
          </ac:spMkLst>
        </pc:spChg>
        <pc:spChg chg="mod">
          <ac:chgData name="GROSBOIS Cloé" userId="5f57a020-64f6-4ab3-8391-eb78b3388ff7" providerId="ADAL" clId="{04CEA349-5FBF-4870-AB25-B4AC333B31C8}" dt="2024-11-13T15:13:28.538" v="33" actId="20577"/>
          <ac:spMkLst>
            <pc:docMk/>
            <pc:sldMk cId="1004786018" sldId="260"/>
            <ac:spMk id="127" creationId="{ABC9DFF2-F778-4006-89D0-88AE23970467}"/>
          </ac:spMkLst>
        </pc:spChg>
        <pc:spChg chg="mod">
          <ac:chgData name="GROSBOIS Cloé" userId="5f57a020-64f6-4ab3-8391-eb78b3388ff7" providerId="ADAL" clId="{04CEA349-5FBF-4870-AB25-B4AC333B31C8}" dt="2024-11-13T15:13:31.341" v="35" actId="20577"/>
          <ac:spMkLst>
            <pc:docMk/>
            <pc:sldMk cId="1004786018" sldId="260"/>
            <ac:spMk id="133" creationId="{9A841BDB-C4E0-4A24-8217-7028AC8DB693}"/>
          </ac:spMkLst>
        </pc:spChg>
        <pc:spChg chg="mod">
          <ac:chgData name="GROSBOIS Cloé" userId="5f57a020-64f6-4ab3-8391-eb78b3388ff7" providerId="ADAL" clId="{04CEA349-5FBF-4870-AB25-B4AC333B31C8}" dt="2024-11-13T15:13:10.385" v="21" actId="20577"/>
          <ac:spMkLst>
            <pc:docMk/>
            <pc:sldMk cId="1004786018" sldId="260"/>
            <ac:spMk id="137" creationId="{CD5AD4CB-CB06-43BA-ADFD-C6F44D551FAB}"/>
          </ac:spMkLst>
        </pc:spChg>
        <pc:spChg chg="mod">
          <ac:chgData name="GROSBOIS Cloé" userId="5f57a020-64f6-4ab3-8391-eb78b3388ff7" providerId="ADAL" clId="{04CEA349-5FBF-4870-AB25-B4AC333B31C8}" dt="2024-11-13T15:13:13.194" v="23" actId="20577"/>
          <ac:spMkLst>
            <pc:docMk/>
            <pc:sldMk cId="1004786018" sldId="260"/>
            <ac:spMk id="138" creationId="{3A1C1F08-7C23-46A5-B358-7CCE0E016B85}"/>
          </ac:spMkLst>
        </pc:spChg>
        <pc:spChg chg="mod">
          <ac:chgData name="GROSBOIS Cloé" userId="5f57a020-64f6-4ab3-8391-eb78b3388ff7" providerId="ADAL" clId="{04CEA349-5FBF-4870-AB25-B4AC333B31C8}" dt="2024-11-13T15:13:15.890" v="25" actId="20577"/>
          <ac:spMkLst>
            <pc:docMk/>
            <pc:sldMk cId="1004786018" sldId="260"/>
            <ac:spMk id="139" creationId="{F48834C8-9224-4D85-91F5-C587C628B385}"/>
          </ac:spMkLst>
        </pc:spChg>
        <pc:spChg chg="mod">
          <ac:chgData name="GROSBOIS Cloé" userId="5f57a020-64f6-4ab3-8391-eb78b3388ff7" providerId="ADAL" clId="{04CEA349-5FBF-4870-AB25-B4AC333B31C8}" dt="2024-11-13T15:13:18.593" v="27" actId="20577"/>
          <ac:spMkLst>
            <pc:docMk/>
            <pc:sldMk cId="1004786018" sldId="260"/>
            <ac:spMk id="140" creationId="{01AC262C-8AA8-4179-B25F-0F5BBBB30F61}"/>
          </ac:spMkLst>
        </pc:spChg>
        <pc:spChg chg="mod">
          <ac:chgData name="GROSBOIS Cloé" userId="5f57a020-64f6-4ab3-8391-eb78b3388ff7" providerId="ADAL" clId="{04CEA349-5FBF-4870-AB25-B4AC333B31C8}" dt="2024-11-13T15:13:38.105" v="37" actId="20577"/>
          <ac:spMkLst>
            <pc:docMk/>
            <pc:sldMk cId="1004786018" sldId="260"/>
            <ac:spMk id="186" creationId="{82835029-29D4-4A1A-9833-5E928DB8BC0B}"/>
          </ac:spMkLst>
        </pc:spChg>
        <pc:spChg chg="mod">
          <ac:chgData name="GROSBOIS Cloé" userId="5f57a020-64f6-4ab3-8391-eb78b3388ff7" providerId="ADAL" clId="{04CEA349-5FBF-4870-AB25-B4AC333B31C8}" dt="2024-11-13T15:13:41.211" v="39" actId="20577"/>
          <ac:spMkLst>
            <pc:docMk/>
            <pc:sldMk cId="1004786018" sldId="260"/>
            <ac:spMk id="192" creationId="{FF3CD022-09B0-4302-8D47-CB64EE5847DB}"/>
          </ac:spMkLst>
        </pc:spChg>
        <pc:spChg chg="mod">
          <ac:chgData name="GROSBOIS Cloé" userId="5f57a020-64f6-4ab3-8391-eb78b3388ff7" providerId="ADAL" clId="{04CEA349-5FBF-4870-AB25-B4AC333B31C8}" dt="2024-11-13T15:13:43.918" v="41" actId="20577"/>
          <ac:spMkLst>
            <pc:docMk/>
            <pc:sldMk cId="1004786018" sldId="260"/>
            <ac:spMk id="198" creationId="{64F71EEE-F111-4277-A224-9B86D0E30756}"/>
          </ac:spMkLst>
        </pc:spChg>
        <pc:spChg chg="mod">
          <ac:chgData name="GROSBOIS Cloé" userId="5f57a020-64f6-4ab3-8391-eb78b3388ff7" providerId="ADAL" clId="{04CEA349-5FBF-4870-AB25-B4AC333B31C8}" dt="2024-11-13T15:13:46.501" v="43" actId="20577"/>
          <ac:spMkLst>
            <pc:docMk/>
            <pc:sldMk cId="1004786018" sldId="260"/>
            <ac:spMk id="205" creationId="{7D266B1B-C94B-4E9A-9196-CA3AD62DD164}"/>
          </ac:spMkLst>
        </pc:spChg>
        <pc:spChg chg="mod">
          <ac:chgData name="GROSBOIS Cloé" userId="5f57a020-64f6-4ab3-8391-eb78b3388ff7" providerId="ADAL" clId="{04CEA349-5FBF-4870-AB25-B4AC333B31C8}" dt="2024-11-13T15:13:50.266" v="45" actId="20577"/>
          <ac:spMkLst>
            <pc:docMk/>
            <pc:sldMk cId="1004786018" sldId="260"/>
            <ac:spMk id="251" creationId="{4204D376-3AD2-4703-85A0-7F235A060EAA}"/>
          </ac:spMkLst>
        </pc:spChg>
        <pc:spChg chg="mod">
          <ac:chgData name="GROSBOIS Cloé" userId="5f57a020-64f6-4ab3-8391-eb78b3388ff7" providerId="ADAL" clId="{04CEA349-5FBF-4870-AB25-B4AC333B31C8}" dt="2024-11-13T15:17:13.872" v="51" actId="20577"/>
          <ac:spMkLst>
            <pc:docMk/>
            <pc:sldMk cId="1004786018" sldId="260"/>
            <ac:spMk id="252" creationId="{32DBF0D4-CE71-4BE2-B095-2DC938AA39DE}"/>
          </ac:spMkLst>
        </pc:spChg>
        <pc:spChg chg="mod">
          <ac:chgData name="GROSBOIS Cloé" userId="5f57a020-64f6-4ab3-8391-eb78b3388ff7" providerId="ADAL" clId="{04CEA349-5FBF-4870-AB25-B4AC333B31C8}" dt="2024-11-13T15:17:19.378" v="53" actId="20577"/>
          <ac:spMkLst>
            <pc:docMk/>
            <pc:sldMk cId="1004786018" sldId="260"/>
            <ac:spMk id="253" creationId="{393BA158-12D7-4BD2-9F7C-F21B3420E63A}"/>
          </ac:spMkLst>
        </pc:spChg>
        <pc:spChg chg="mod">
          <ac:chgData name="GROSBOIS Cloé" userId="5f57a020-64f6-4ab3-8391-eb78b3388ff7" providerId="ADAL" clId="{04CEA349-5FBF-4870-AB25-B4AC333B31C8}" dt="2024-11-13T15:17:22.811" v="55" actId="20577"/>
          <ac:spMkLst>
            <pc:docMk/>
            <pc:sldMk cId="1004786018" sldId="260"/>
            <ac:spMk id="254" creationId="{E99DB743-9F04-4F4B-A4EE-D5B60D47C3B0}"/>
          </ac:spMkLst>
        </pc:spChg>
        <pc:spChg chg="mod">
          <ac:chgData name="GROSBOIS Cloé" userId="5f57a020-64f6-4ab3-8391-eb78b3388ff7" providerId="ADAL" clId="{04CEA349-5FBF-4870-AB25-B4AC333B31C8}" dt="2024-11-13T15:12:56.148" v="13" actId="20577"/>
          <ac:spMkLst>
            <pc:docMk/>
            <pc:sldMk cId="1004786018" sldId="260"/>
            <ac:spMk id="287" creationId="{24D704A6-1CC1-757E-8403-50452AEB580B}"/>
          </ac:spMkLst>
        </pc:spChg>
        <pc:spChg chg="mod">
          <ac:chgData name="GROSBOIS Cloé" userId="5f57a020-64f6-4ab3-8391-eb78b3388ff7" providerId="ADAL" clId="{04CEA349-5FBF-4870-AB25-B4AC333B31C8}" dt="2024-11-13T15:12:59.277" v="15" actId="20577"/>
          <ac:spMkLst>
            <pc:docMk/>
            <pc:sldMk cId="1004786018" sldId="260"/>
            <ac:spMk id="288" creationId="{4C490467-A978-508B-71E2-0A454A33AFC6}"/>
          </ac:spMkLst>
        </pc:spChg>
        <pc:spChg chg="mod">
          <ac:chgData name="GROSBOIS Cloé" userId="5f57a020-64f6-4ab3-8391-eb78b3388ff7" providerId="ADAL" clId="{04CEA349-5FBF-4870-AB25-B4AC333B31C8}" dt="2024-11-13T15:13:02.051" v="17" actId="20577"/>
          <ac:spMkLst>
            <pc:docMk/>
            <pc:sldMk cId="1004786018" sldId="260"/>
            <ac:spMk id="289" creationId="{882D6642-3DDC-EDF8-908E-0E40F2BDE73C}"/>
          </ac:spMkLst>
        </pc:spChg>
        <pc:spChg chg="mod">
          <ac:chgData name="GROSBOIS Cloé" userId="5f57a020-64f6-4ab3-8391-eb78b3388ff7" providerId="ADAL" clId="{04CEA349-5FBF-4870-AB25-B4AC333B31C8}" dt="2024-11-13T15:13:05.547" v="19" actId="20577"/>
          <ac:spMkLst>
            <pc:docMk/>
            <pc:sldMk cId="1004786018" sldId="260"/>
            <ac:spMk id="290" creationId="{2798D7EF-C132-98EB-D737-094AE9E55986}"/>
          </ac:spMkLst>
        </pc:spChg>
        <pc:spChg chg="mod">
          <ac:chgData name="GROSBOIS Cloé" userId="5f57a020-64f6-4ab3-8391-eb78b3388ff7" providerId="ADAL" clId="{04CEA349-5FBF-4870-AB25-B4AC333B31C8}" dt="2024-11-13T15:12:20.535" v="1" actId="20577"/>
          <ac:spMkLst>
            <pc:docMk/>
            <pc:sldMk cId="1004786018" sldId="260"/>
            <ac:spMk id="298" creationId="{28EC3705-D859-B54A-2085-9B927259FC95}"/>
          </ac:spMkLst>
        </pc:spChg>
        <pc:spChg chg="mod">
          <ac:chgData name="GROSBOIS Cloé" userId="5f57a020-64f6-4ab3-8391-eb78b3388ff7" providerId="ADAL" clId="{04CEA349-5FBF-4870-AB25-B4AC333B31C8}" dt="2024-11-13T15:12:23.724" v="3" actId="20577"/>
          <ac:spMkLst>
            <pc:docMk/>
            <pc:sldMk cId="1004786018" sldId="260"/>
            <ac:spMk id="299" creationId="{056B54E7-0204-3B27-D4C3-C7728FFB9F15}"/>
          </ac:spMkLst>
        </pc:spChg>
        <pc:spChg chg="mod">
          <ac:chgData name="GROSBOIS Cloé" userId="5f57a020-64f6-4ab3-8391-eb78b3388ff7" providerId="ADAL" clId="{04CEA349-5FBF-4870-AB25-B4AC333B31C8}" dt="2024-11-13T15:17:26.057" v="57" actId="20577"/>
          <ac:spMkLst>
            <pc:docMk/>
            <pc:sldMk cId="1004786018" sldId="260"/>
            <ac:spMk id="316" creationId="{6B979BD4-8235-43D7-AB26-0E4C3F416160}"/>
          </ac:spMkLst>
        </pc:spChg>
        <pc:spChg chg="mod">
          <ac:chgData name="GROSBOIS Cloé" userId="5f57a020-64f6-4ab3-8391-eb78b3388ff7" providerId="ADAL" clId="{04CEA349-5FBF-4870-AB25-B4AC333B31C8}" dt="2024-11-13T15:17:31.296" v="61" actId="20577"/>
          <ac:spMkLst>
            <pc:docMk/>
            <pc:sldMk cId="1004786018" sldId="260"/>
            <ac:spMk id="324" creationId="{9644DFEE-DE5F-4895-BC9E-96D5FCD91289}"/>
          </ac:spMkLst>
        </pc:spChg>
        <pc:spChg chg="mod">
          <ac:chgData name="GROSBOIS Cloé" userId="5f57a020-64f6-4ab3-8391-eb78b3388ff7" providerId="ADAL" clId="{04CEA349-5FBF-4870-AB25-B4AC333B31C8}" dt="2024-11-13T15:17:28.741" v="59" actId="20577"/>
          <ac:spMkLst>
            <pc:docMk/>
            <pc:sldMk cId="1004786018" sldId="260"/>
            <ac:spMk id="329" creationId="{9DBCD7B6-E096-4B5A-A8FA-083A5E2B96E0}"/>
          </ac:spMkLst>
        </pc:spChg>
        <pc:spChg chg="mod">
          <ac:chgData name="GROSBOIS Cloé" userId="5f57a020-64f6-4ab3-8391-eb78b3388ff7" providerId="ADAL" clId="{04CEA349-5FBF-4870-AB25-B4AC333B31C8}" dt="2024-11-13T15:17:33.984" v="63" actId="20577"/>
          <ac:spMkLst>
            <pc:docMk/>
            <pc:sldMk cId="1004786018" sldId="260"/>
            <ac:spMk id="332" creationId="{866245C5-7A27-4636-8E7F-254E74280D84}"/>
          </ac:spMkLst>
        </pc:spChg>
        <pc:spChg chg="mod">
          <ac:chgData name="GROSBOIS Cloé" userId="5f57a020-64f6-4ab3-8391-eb78b3388ff7" providerId="ADAL" clId="{04CEA349-5FBF-4870-AB25-B4AC333B31C8}" dt="2024-11-13T15:17:39.524" v="67" actId="20577"/>
          <ac:spMkLst>
            <pc:docMk/>
            <pc:sldMk cId="1004786018" sldId="260"/>
            <ac:spMk id="338" creationId="{B589C376-F291-4392-884F-7E72F6C53528}"/>
          </ac:spMkLst>
        </pc:spChg>
        <pc:spChg chg="mod">
          <ac:chgData name="GROSBOIS Cloé" userId="5f57a020-64f6-4ab3-8391-eb78b3388ff7" providerId="ADAL" clId="{04CEA349-5FBF-4870-AB25-B4AC333B31C8}" dt="2024-11-13T15:17:36.406" v="65" actId="20577"/>
          <ac:spMkLst>
            <pc:docMk/>
            <pc:sldMk cId="1004786018" sldId="260"/>
            <ac:spMk id="344" creationId="{6F973474-BC73-419B-97C7-74446F1B939D}"/>
          </ac:spMkLst>
        </pc:spChg>
        <pc:spChg chg="mod">
          <ac:chgData name="GROSBOIS Cloé" userId="5f57a020-64f6-4ab3-8391-eb78b3388ff7" providerId="ADAL" clId="{04CEA349-5FBF-4870-AB25-B4AC333B31C8}" dt="2024-11-13T15:17:42.344" v="69" actId="20577"/>
          <ac:spMkLst>
            <pc:docMk/>
            <pc:sldMk cId="1004786018" sldId="260"/>
            <ac:spMk id="350" creationId="{11B3844E-B807-4E1F-B2BA-624B1166E06D}"/>
          </ac:spMkLst>
        </pc:spChg>
        <pc:spChg chg="mod">
          <ac:chgData name="GROSBOIS Cloé" userId="5f57a020-64f6-4ab3-8391-eb78b3388ff7" providerId="ADAL" clId="{04CEA349-5FBF-4870-AB25-B4AC333B31C8}" dt="2024-11-13T15:17:47.760" v="73" actId="20577"/>
          <ac:spMkLst>
            <pc:docMk/>
            <pc:sldMk cId="1004786018" sldId="260"/>
            <ac:spMk id="356" creationId="{191FA970-3D52-42B5-B857-EDB5FAF4283F}"/>
          </ac:spMkLst>
        </pc:spChg>
        <pc:spChg chg="mod">
          <ac:chgData name="GROSBOIS Cloé" userId="5f57a020-64f6-4ab3-8391-eb78b3388ff7" providerId="ADAL" clId="{04CEA349-5FBF-4870-AB25-B4AC333B31C8}" dt="2024-11-13T15:17:45.089" v="71" actId="20577"/>
          <ac:spMkLst>
            <pc:docMk/>
            <pc:sldMk cId="1004786018" sldId="260"/>
            <ac:spMk id="362" creationId="{9876D56E-EBA6-456C-8379-FA80DE9E073F}"/>
          </ac:spMkLst>
        </pc:spChg>
        <pc:spChg chg="mod">
          <ac:chgData name="GROSBOIS Cloé" userId="5f57a020-64f6-4ab3-8391-eb78b3388ff7" providerId="ADAL" clId="{04CEA349-5FBF-4870-AB25-B4AC333B31C8}" dt="2024-11-13T15:17:50.697" v="75" actId="20577"/>
          <ac:spMkLst>
            <pc:docMk/>
            <pc:sldMk cId="1004786018" sldId="260"/>
            <ac:spMk id="368" creationId="{2124057A-8525-47C0-B195-B1A6D2408FD9}"/>
          </ac:spMkLst>
        </pc:spChg>
        <pc:spChg chg="mod">
          <ac:chgData name="GROSBOIS Cloé" userId="5f57a020-64f6-4ab3-8391-eb78b3388ff7" providerId="ADAL" clId="{04CEA349-5FBF-4870-AB25-B4AC333B31C8}" dt="2024-11-13T15:17:56.393" v="79" actId="20577"/>
          <ac:spMkLst>
            <pc:docMk/>
            <pc:sldMk cId="1004786018" sldId="260"/>
            <ac:spMk id="374" creationId="{A5A35CD8-16BF-40C8-91B0-07DE2C3AE53C}"/>
          </ac:spMkLst>
        </pc:spChg>
        <pc:spChg chg="mod">
          <ac:chgData name="GROSBOIS Cloé" userId="5f57a020-64f6-4ab3-8391-eb78b3388ff7" providerId="ADAL" clId="{04CEA349-5FBF-4870-AB25-B4AC333B31C8}" dt="2024-11-13T15:17:53.537" v="77" actId="20577"/>
          <ac:spMkLst>
            <pc:docMk/>
            <pc:sldMk cId="1004786018" sldId="260"/>
            <ac:spMk id="380" creationId="{E70562C4-C719-46D1-9D2F-31E0D0566FE3}"/>
          </ac:spMkLst>
        </pc:spChg>
        <pc:spChg chg="mod">
          <ac:chgData name="GROSBOIS Cloé" userId="5f57a020-64f6-4ab3-8391-eb78b3388ff7" providerId="ADAL" clId="{04CEA349-5FBF-4870-AB25-B4AC333B31C8}" dt="2024-11-13T15:17:59.649" v="81" actId="20577"/>
          <ac:spMkLst>
            <pc:docMk/>
            <pc:sldMk cId="1004786018" sldId="260"/>
            <ac:spMk id="386" creationId="{27D77ACE-BF8B-4611-8DD5-720F50120C69}"/>
          </ac:spMkLst>
        </pc:spChg>
        <pc:spChg chg="mod">
          <ac:chgData name="GROSBOIS Cloé" userId="5f57a020-64f6-4ab3-8391-eb78b3388ff7" providerId="ADAL" clId="{04CEA349-5FBF-4870-AB25-B4AC333B31C8}" dt="2024-11-13T15:18:05.993" v="87" actId="20577"/>
          <ac:spMkLst>
            <pc:docMk/>
            <pc:sldMk cId="1004786018" sldId="260"/>
            <ac:spMk id="392" creationId="{7DE5677D-0F34-4A46-A929-00EEFBB3172E}"/>
          </ac:spMkLst>
        </pc:spChg>
        <pc:spChg chg="mod">
          <ac:chgData name="GROSBOIS Cloé" userId="5f57a020-64f6-4ab3-8391-eb78b3388ff7" providerId="ADAL" clId="{04CEA349-5FBF-4870-AB25-B4AC333B31C8}" dt="2024-11-13T15:18:03.641" v="85" actId="20577"/>
          <ac:spMkLst>
            <pc:docMk/>
            <pc:sldMk cId="1004786018" sldId="260"/>
            <ac:spMk id="398" creationId="{6E6AFEA2-01AB-4AD4-9692-2A3BC752D830}"/>
          </ac:spMkLst>
        </pc:spChg>
      </pc:sldChg>
    </pc:docChg>
  </pc:docChgLst>
  <pc:docChgLst>
    <pc:chgData name="MOMMERT-TRIPON Marine" userId="957e260d-45d9-4bce-a44b-dc5e8c7cd978" providerId="ADAL" clId="{611BE448-6E63-4B2E-BE90-BBA1055C2605}"/>
    <pc:docChg chg="modSld">
      <pc:chgData name="MOMMERT-TRIPON Marine" userId="957e260d-45d9-4bce-a44b-dc5e8c7cd978" providerId="ADAL" clId="{611BE448-6E63-4B2E-BE90-BBA1055C2605}" dt="2024-10-24T14:41:23.043" v="15" actId="13926"/>
      <pc:docMkLst>
        <pc:docMk/>
      </pc:docMkLst>
      <pc:sldChg chg="modSp mod">
        <pc:chgData name="MOMMERT-TRIPON Marine" userId="957e260d-45d9-4bce-a44b-dc5e8c7cd978" providerId="ADAL" clId="{611BE448-6E63-4B2E-BE90-BBA1055C2605}" dt="2024-10-24T14:41:23.043" v="15" actId="13926"/>
        <pc:sldMkLst>
          <pc:docMk/>
          <pc:sldMk cId="1004786018" sldId="260"/>
        </pc:sldMkLst>
        <pc:spChg chg="mod">
          <ac:chgData name="MOMMERT-TRIPON Marine" userId="957e260d-45d9-4bce-a44b-dc5e8c7cd978" providerId="ADAL" clId="{611BE448-6E63-4B2E-BE90-BBA1055C2605}" dt="2024-10-24T14:40:13.462" v="0" actId="13926"/>
          <ac:spMkLst>
            <pc:docMk/>
            <pc:sldMk cId="1004786018" sldId="260"/>
            <ac:spMk id="5" creationId="{42474194-5220-D193-93F9-03C84AA2CF11}"/>
          </ac:spMkLst>
        </pc:spChg>
        <pc:spChg chg="mod">
          <ac:chgData name="MOMMERT-TRIPON Marine" userId="957e260d-45d9-4bce-a44b-dc5e8c7cd978" providerId="ADAL" clId="{611BE448-6E63-4B2E-BE90-BBA1055C2605}" dt="2024-10-24T14:40:22.737" v="1" actId="13926"/>
          <ac:spMkLst>
            <pc:docMk/>
            <pc:sldMk cId="1004786018" sldId="260"/>
            <ac:spMk id="316" creationId="{6B979BD4-8235-43D7-AB26-0E4C3F416160}"/>
          </ac:spMkLst>
        </pc:spChg>
        <pc:spChg chg="mod">
          <ac:chgData name="MOMMERT-TRIPON Marine" userId="957e260d-45d9-4bce-a44b-dc5e8c7cd978" providerId="ADAL" clId="{611BE448-6E63-4B2E-BE90-BBA1055C2605}" dt="2024-10-24T14:40:31.128" v="3" actId="13926"/>
          <ac:spMkLst>
            <pc:docMk/>
            <pc:sldMk cId="1004786018" sldId="260"/>
            <ac:spMk id="324" creationId="{9644DFEE-DE5F-4895-BC9E-96D5FCD91289}"/>
          </ac:spMkLst>
        </pc:spChg>
        <pc:spChg chg="mod">
          <ac:chgData name="MOMMERT-TRIPON Marine" userId="957e260d-45d9-4bce-a44b-dc5e8c7cd978" providerId="ADAL" clId="{611BE448-6E63-4B2E-BE90-BBA1055C2605}" dt="2024-10-24T14:40:26.753" v="2" actId="13926"/>
          <ac:spMkLst>
            <pc:docMk/>
            <pc:sldMk cId="1004786018" sldId="260"/>
            <ac:spMk id="329" creationId="{9DBCD7B6-E096-4B5A-A8FA-083A5E2B96E0}"/>
          </ac:spMkLst>
        </pc:spChg>
        <pc:spChg chg="mod">
          <ac:chgData name="MOMMERT-TRIPON Marine" userId="957e260d-45d9-4bce-a44b-dc5e8c7cd978" providerId="ADAL" clId="{611BE448-6E63-4B2E-BE90-BBA1055C2605}" dt="2024-10-24T14:40:34.688" v="4" actId="13926"/>
          <ac:spMkLst>
            <pc:docMk/>
            <pc:sldMk cId="1004786018" sldId="260"/>
            <ac:spMk id="332" creationId="{866245C5-7A27-4636-8E7F-254E74280D84}"/>
          </ac:spMkLst>
        </pc:spChg>
        <pc:spChg chg="mod">
          <ac:chgData name="MOMMERT-TRIPON Marine" userId="957e260d-45d9-4bce-a44b-dc5e8c7cd978" providerId="ADAL" clId="{611BE448-6E63-4B2E-BE90-BBA1055C2605}" dt="2024-10-24T14:40:43.094" v="6" actId="13926"/>
          <ac:spMkLst>
            <pc:docMk/>
            <pc:sldMk cId="1004786018" sldId="260"/>
            <ac:spMk id="338" creationId="{B589C376-F291-4392-884F-7E72F6C53528}"/>
          </ac:spMkLst>
        </pc:spChg>
        <pc:spChg chg="mod">
          <ac:chgData name="MOMMERT-TRIPON Marine" userId="957e260d-45d9-4bce-a44b-dc5e8c7cd978" providerId="ADAL" clId="{611BE448-6E63-4B2E-BE90-BBA1055C2605}" dt="2024-10-24T14:40:38.883" v="5" actId="13926"/>
          <ac:spMkLst>
            <pc:docMk/>
            <pc:sldMk cId="1004786018" sldId="260"/>
            <ac:spMk id="344" creationId="{6F973474-BC73-419B-97C7-74446F1B939D}"/>
          </ac:spMkLst>
        </pc:spChg>
        <pc:spChg chg="mod">
          <ac:chgData name="MOMMERT-TRIPON Marine" userId="957e260d-45d9-4bce-a44b-dc5e8c7cd978" providerId="ADAL" clId="{611BE448-6E63-4B2E-BE90-BBA1055C2605}" dt="2024-10-24T14:40:48.722" v="7" actId="13926"/>
          <ac:spMkLst>
            <pc:docMk/>
            <pc:sldMk cId="1004786018" sldId="260"/>
            <ac:spMk id="350" creationId="{11B3844E-B807-4E1F-B2BA-624B1166E06D}"/>
          </ac:spMkLst>
        </pc:spChg>
        <pc:spChg chg="mod">
          <ac:chgData name="MOMMERT-TRIPON Marine" userId="957e260d-45d9-4bce-a44b-dc5e8c7cd978" providerId="ADAL" clId="{611BE448-6E63-4B2E-BE90-BBA1055C2605}" dt="2024-10-24T14:40:57.346" v="9" actId="13926"/>
          <ac:spMkLst>
            <pc:docMk/>
            <pc:sldMk cId="1004786018" sldId="260"/>
            <ac:spMk id="356" creationId="{191FA970-3D52-42B5-B857-EDB5FAF4283F}"/>
          </ac:spMkLst>
        </pc:spChg>
        <pc:spChg chg="mod">
          <ac:chgData name="MOMMERT-TRIPON Marine" userId="957e260d-45d9-4bce-a44b-dc5e8c7cd978" providerId="ADAL" clId="{611BE448-6E63-4B2E-BE90-BBA1055C2605}" dt="2024-10-24T14:40:53.479" v="8" actId="13926"/>
          <ac:spMkLst>
            <pc:docMk/>
            <pc:sldMk cId="1004786018" sldId="260"/>
            <ac:spMk id="362" creationId="{9876D56E-EBA6-456C-8379-FA80DE9E073F}"/>
          </ac:spMkLst>
        </pc:spChg>
        <pc:spChg chg="mod">
          <ac:chgData name="MOMMERT-TRIPON Marine" userId="957e260d-45d9-4bce-a44b-dc5e8c7cd978" providerId="ADAL" clId="{611BE448-6E63-4B2E-BE90-BBA1055C2605}" dt="2024-10-24T14:41:01.977" v="10" actId="13926"/>
          <ac:spMkLst>
            <pc:docMk/>
            <pc:sldMk cId="1004786018" sldId="260"/>
            <ac:spMk id="368" creationId="{2124057A-8525-47C0-B195-B1A6D2408FD9}"/>
          </ac:spMkLst>
        </pc:spChg>
        <pc:spChg chg="mod">
          <ac:chgData name="MOMMERT-TRIPON Marine" userId="957e260d-45d9-4bce-a44b-dc5e8c7cd978" providerId="ADAL" clId="{611BE448-6E63-4B2E-BE90-BBA1055C2605}" dt="2024-10-24T14:41:09.807" v="12" actId="13926"/>
          <ac:spMkLst>
            <pc:docMk/>
            <pc:sldMk cId="1004786018" sldId="260"/>
            <ac:spMk id="374" creationId="{A5A35CD8-16BF-40C8-91B0-07DE2C3AE53C}"/>
          </ac:spMkLst>
        </pc:spChg>
        <pc:spChg chg="mod">
          <ac:chgData name="MOMMERT-TRIPON Marine" userId="957e260d-45d9-4bce-a44b-dc5e8c7cd978" providerId="ADAL" clId="{611BE448-6E63-4B2E-BE90-BBA1055C2605}" dt="2024-10-24T14:41:06.016" v="11" actId="13926"/>
          <ac:spMkLst>
            <pc:docMk/>
            <pc:sldMk cId="1004786018" sldId="260"/>
            <ac:spMk id="380" creationId="{E70562C4-C719-46D1-9D2F-31E0D0566FE3}"/>
          </ac:spMkLst>
        </pc:spChg>
        <pc:spChg chg="mod">
          <ac:chgData name="MOMMERT-TRIPON Marine" userId="957e260d-45d9-4bce-a44b-dc5e8c7cd978" providerId="ADAL" clId="{611BE448-6E63-4B2E-BE90-BBA1055C2605}" dt="2024-10-24T14:41:14.748" v="13" actId="13926"/>
          <ac:spMkLst>
            <pc:docMk/>
            <pc:sldMk cId="1004786018" sldId="260"/>
            <ac:spMk id="386" creationId="{27D77ACE-BF8B-4611-8DD5-720F50120C69}"/>
          </ac:spMkLst>
        </pc:spChg>
        <pc:spChg chg="mod">
          <ac:chgData name="MOMMERT-TRIPON Marine" userId="957e260d-45d9-4bce-a44b-dc5e8c7cd978" providerId="ADAL" clId="{611BE448-6E63-4B2E-BE90-BBA1055C2605}" dt="2024-10-24T14:41:23.043" v="15" actId="13926"/>
          <ac:spMkLst>
            <pc:docMk/>
            <pc:sldMk cId="1004786018" sldId="260"/>
            <ac:spMk id="392" creationId="{7DE5677D-0F34-4A46-A929-00EEFBB3172E}"/>
          </ac:spMkLst>
        </pc:spChg>
        <pc:spChg chg="mod">
          <ac:chgData name="MOMMERT-TRIPON Marine" userId="957e260d-45d9-4bce-a44b-dc5e8c7cd978" providerId="ADAL" clId="{611BE448-6E63-4B2E-BE90-BBA1055C2605}" dt="2024-10-24T14:41:19.442" v="14" actId="13926"/>
          <ac:spMkLst>
            <pc:docMk/>
            <pc:sldMk cId="1004786018" sldId="260"/>
            <ac:spMk id="398" creationId="{6E6AFEA2-01AB-4AD4-9692-2A3BC752D83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59F911-0869-4A14-9BF9-31EBA2B9EAEC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57263" y="1143000"/>
            <a:ext cx="4943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C62D90-E3C7-454A-A65D-B258D63EF3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5234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5089" y="1360865"/>
            <a:ext cx="9990535" cy="2894965"/>
          </a:xfrm>
        </p:spPr>
        <p:txBody>
          <a:bodyPr anchor="b"/>
          <a:lstStyle>
            <a:lvl1pPr algn="ctr">
              <a:defRPr sz="655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4367471"/>
            <a:ext cx="9990535" cy="2007611"/>
          </a:xfrm>
        </p:spPr>
        <p:txBody>
          <a:bodyPr/>
          <a:lstStyle>
            <a:lvl1pPr marL="0" indent="0" algn="ctr">
              <a:buNone/>
              <a:defRPr sz="2622"/>
            </a:lvl1pPr>
            <a:lvl2pPr marL="499537" indent="0" algn="ctr">
              <a:buNone/>
              <a:defRPr sz="2185"/>
            </a:lvl2pPr>
            <a:lvl3pPr marL="999073" indent="0" algn="ctr">
              <a:buNone/>
              <a:defRPr sz="1967"/>
            </a:lvl3pPr>
            <a:lvl4pPr marL="1498610" indent="0" algn="ctr">
              <a:buNone/>
              <a:defRPr sz="1748"/>
            </a:lvl4pPr>
            <a:lvl5pPr marL="1998147" indent="0" algn="ctr">
              <a:buNone/>
              <a:defRPr sz="1748"/>
            </a:lvl5pPr>
            <a:lvl6pPr marL="2497684" indent="0" algn="ctr">
              <a:buNone/>
              <a:defRPr sz="1748"/>
            </a:lvl6pPr>
            <a:lvl7pPr marL="2997220" indent="0" algn="ctr">
              <a:buNone/>
              <a:defRPr sz="1748"/>
            </a:lvl7pPr>
            <a:lvl8pPr marL="3496757" indent="0" algn="ctr">
              <a:buNone/>
              <a:defRPr sz="1748"/>
            </a:lvl8pPr>
            <a:lvl9pPr marL="3996294" indent="0" algn="ctr">
              <a:buNone/>
              <a:defRPr sz="1748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8794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7180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5" y="442714"/>
            <a:ext cx="2872279" cy="7046854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799" y="442714"/>
            <a:ext cx="8450327" cy="7046854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8373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348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1" y="2073058"/>
            <a:ext cx="11489115" cy="3458944"/>
          </a:xfrm>
        </p:spPr>
        <p:txBody>
          <a:bodyPr anchor="b"/>
          <a:lstStyle>
            <a:lvl1pPr>
              <a:defRPr sz="655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1" y="5564724"/>
            <a:ext cx="11489115" cy="1818977"/>
          </a:xfrm>
        </p:spPr>
        <p:txBody>
          <a:bodyPr/>
          <a:lstStyle>
            <a:lvl1pPr marL="0" indent="0">
              <a:buNone/>
              <a:defRPr sz="2622">
                <a:solidFill>
                  <a:schemeClr val="tx1">
                    <a:tint val="75000"/>
                  </a:schemeClr>
                </a:solidFill>
              </a:defRPr>
            </a:lvl1pPr>
            <a:lvl2pPr marL="499537" indent="0">
              <a:buNone/>
              <a:defRPr sz="2185">
                <a:solidFill>
                  <a:schemeClr val="tx1">
                    <a:tint val="75000"/>
                  </a:schemeClr>
                </a:solidFill>
              </a:defRPr>
            </a:lvl2pPr>
            <a:lvl3pPr marL="999073" indent="0">
              <a:buNone/>
              <a:defRPr sz="1967">
                <a:solidFill>
                  <a:schemeClr val="tx1">
                    <a:tint val="75000"/>
                  </a:schemeClr>
                </a:solidFill>
              </a:defRPr>
            </a:lvl3pPr>
            <a:lvl4pPr marL="1498610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4pPr>
            <a:lvl5pPr marL="1998147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5pPr>
            <a:lvl6pPr marL="2497684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6pPr>
            <a:lvl7pPr marL="2997220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7pPr>
            <a:lvl8pPr marL="3496757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8pPr>
            <a:lvl9pPr marL="3996294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5635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213570"/>
            <a:ext cx="5661303" cy="527599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213570"/>
            <a:ext cx="5661303" cy="527599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7429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442715"/>
            <a:ext cx="11489115" cy="160724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5" y="2038410"/>
            <a:ext cx="5635285" cy="998993"/>
          </a:xfrm>
        </p:spPr>
        <p:txBody>
          <a:bodyPr anchor="b"/>
          <a:lstStyle>
            <a:lvl1pPr marL="0" indent="0">
              <a:buNone/>
              <a:defRPr sz="2622" b="1"/>
            </a:lvl1pPr>
            <a:lvl2pPr marL="499537" indent="0">
              <a:buNone/>
              <a:defRPr sz="2185" b="1"/>
            </a:lvl2pPr>
            <a:lvl3pPr marL="999073" indent="0">
              <a:buNone/>
              <a:defRPr sz="1967" b="1"/>
            </a:lvl3pPr>
            <a:lvl4pPr marL="1498610" indent="0">
              <a:buNone/>
              <a:defRPr sz="1748" b="1"/>
            </a:lvl4pPr>
            <a:lvl5pPr marL="1998147" indent="0">
              <a:buNone/>
              <a:defRPr sz="1748" b="1"/>
            </a:lvl5pPr>
            <a:lvl6pPr marL="2497684" indent="0">
              <a:buNone/>
              <a:defRPr sz="1748" b="1"/>
            </a:lvl6pPr>
            <a:lvl7pPr marL="2997220" indent="0">
              <a:buNone/>
              <a:defRPr sz="1748" b="1"/>
            </a:lvl7pPr>
            <a:lvl8pPr marL="3496757" indent="0">
              <a:buNone/>
              <a:defRPr sz="1748" b="1"/>
            </a:lvl8pPr>
            <a:lvl9pPr marL="3996294" indent="0">
              <a:buNone/>
              <a:defRPr sz="1748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5" y="3037403"/>
            <a:ext cx="5635285" cy="446756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1" y="2038410"/>
            <a:ext cx="5663038" cy="998993"/>
          </a:xfrm>
        </p:spPr>
        <p:txBody>
          <a:bodyPr anchor="b"/>
          <a:lstStyle>
            <a:lvl1pPr marL="0" indent="0">
              <a:buNone/>
              <a:defRPr sz="2622" b="1"/>
            </a:lvl1pPr>
            <a:lvl2pPr marL="499537" indent="0">
              <a:buNone/>
              <a:defRPr sz="2185" b="1"/>
            </a:lvl2pPr>
            <a:lvl3pPr marL="999073" indent="0">
              <a:buNone/>
              <a:defRPr sz="1967" b="1"/>
            </a:lvl3pPr>
            <a:lvl4pPr marL="1498610" indent="0">
              <a:buNone/>
              <a:defRPr sz="1748" b="1"/>
            </a:lvl4pPr>
            <a:lvl5pPr marL="1998147" indent="0">
              <a:buNone/>
              <a:defRPr sz="1748" b="1"/>
            </a:lvl5pPr>
            <a:lvl6pPr marL="2497684" indent="0">
              <a:buNone/>
              <a:defRPr sz="1748" b="1"/>
            </a:lvl6pPr>
            <a:lvl7pPr marL="2997220" indent="0">
              <a:buNone/>
              <a:defRPr sz="1748" b="1"/>
            </a:lvl7pPr>
            <a:lvl8pPr marL="3496757" indent="0">
              <a:buNone/>
              <a:defRPr sz="1748" b="1"/>
            </a:lvl8pPr>
            <a:lvl9pPr marL="3996294" indent="0">
              <a:buNone/>
              <a:defRPr sz="1748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1" y="3037403"/>
            <a:ext cx="5663038" cy="446756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171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0022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4177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554355"/>
            <a:ext cx="4296276" cy="1940243"/>
          </a:xfrm>
        </p:spPr>
        <p:txBody>
          <a:bodyPr anchor="b"/>
          <a:lstStyle>
            <a:lvl1pPr>
              <a:defRPr sz="349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197254"/>
            <a:ext cx="6743611" cy="5909270"/>
          </a:xfrm>
        </p:spPr>
        <p:txBody>
          <a:bodyPr/>
          <a:lstStyle>
            <a:lvl1pPr>
              <a:defRPr sz="3496"/>
            </a:lvl1pPr>
            <a:lvl2pPr>
              <a:defRPr sz="3059"/>
            </a:lvl2pPr>
            <a:lvl3pPr>
              <a:defRPr sz="2622"/>
            </a:lvl3pPr>
            <a:lvl4pPr>
              <a:defRPr sz="2185"/>
            </a:lvl4pPr>
            <a:lvl5pPr>
              <a:defRPr sz="2185"/>
            </a:lvl5pPr>
            <a:lvl6pPr>
              <a:defRPr sz="2185"/>
            </a:lvl6pPr>
            <a:lvl7pPr>
              <a:defRPr sz="2185"/>
            </a:lvl7pPr>
            <a:lvl8pPr>
              <a:defRPr sz="2185"/>
            </a:lvl8pPr>
            <a:lvl9pPr>
              <a:defRPr sz="2185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494598"/>
            <a:ext cx="4296276" cy="4621550"/>
          </a:xfrm>
        </p:spPr>
        <p:txBody>
          <a:bodyPr/>
          <a:lstStyle>
            <a:lvl1pPr marL="0" indent="0">
              <a:buNone/>
              <a:defRPr sz="1748"/>
            </a:lvl1pPr>
            <a:lvl2pPr marL="499537" indent="0">
              <a:buNone/>
              <a:defRPr sz="1530"/>
            </a:lvl2pPr>
            <a:lvl3pPr marL="999073" indent="0">
              <a:buNone/>
              <a:defRPr sz="1311"/>
            </a:lvl3pPr>
            <a:lvl4pPr marL="1498610" indent="0">
              <a:buNone/>
              <a:defRPr sz="1093"/>
            </a:lvl4pPr>
            <a:lvl5pPr marL="1998147" indent="0">
              <a:buNone/>
              <a:defRPr sz="1093"/>
            </a:lvl5pPr>
            <a:lvl6pPr marL="2497684" indent="0">
              <a:buNone/>
              <a:defRPr sz="1093"/>
            </a:lvl6pPr>
            <a:lvl7pPr marL="2997220" indent="0">
              <a:buNone/>
              <a:defRPr sz="1093"/>
            </a:lvl7pPr>
            <a:lvl8pPr marL="3496757" indent="0">
              <a:buNone/>
              <a:defRPr sz="1093"/>
            </a:lvl8pPr>
            <a:lvl9pPr marL="3996294" indent="0">
              <a:buNone/>
              <a:defRPr sz="109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5953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554355"/>
            <a:ext cx="4296276" cy="1940243"/>
          </a:xfrm>
        </p:spPr>
        <p:txBody>
          <a:bodyPr anchor="b"/>
          <a:lstStyle>
            <a:lvl1pPr>
              <a:defRPr sz="349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197254"/>
            <a:ext cx="6743611" cy="5909270"/>
          </a:xfrm>
        </p:spPr>
        <p:txBody>
          <a:bodyPr anchor="t"/>
          <a:lstStyle>
            <a:lvl1pPr marL="0" indent="0">
              <a:buNone/>
              <a:defRPr sz="3496"/>
            </a:lvl1pPr>
            <a:lvl2pPr marL="499537" indent="0">
              <a:buNone/>
              <a:defRPr sz="3059"/>
            </a:lvl2pPr>
            <a:lvl3pPr marL="999073" indent="0">
              <a:buNone/>
              <a:defRPr sz="2622"/>
            </a:lvl3pPr>
            <a:lvl4pPr marL="1498610" indent="0">
              <a:buNone/>
              <a:defRPr sz="2185"/>
            </a:lvl4pPr>
            <a:lvl5pPr marL="1998147" indent="0">
              <a:buNone/>
              <a:defRPr sz="2185"/>
            </a:lvl5pPr>
            <a:lvl6pPr marL="2497684" indent="0">
              <a:buNone/>
              <a:defRPr sz="2185"/>
            </a:lvl6pPr>
            <a:lvl7pPr marL="2997220" indent="0">
              <a:buNone/>
              <a:defRPr sz="2185"/>
            </a:lvl7pPr>
            <a:lvl8pPr marL="3496757" indent="0">
              <a:buNone/>
              <a:defRPr sz="2185"/>
            </a:lvl8pPr>
            <a:lvl9pPr marL="3996294" indent="0">
              <a:buNone/>
              <a:defRPr sz="2185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494598"/>
            <a:ext cx="4296276" cy="4621550"/>
          </a:xfrm>
        </p:spPr>
        <p:txBody>
          <a:bodyPr/>
          <a:lstStyle>
            <a:lvl1pPr marL="0" indent="0">
              <a:buNone/>
              <a:defRPr sz="1748"/>
            </a:lvl1pPr>
            <a:lvl2pPr marL="499537" indent="0">
              <a:buNone/>
              <a:defRPr sz="1530"/>
            </a:lvl2pPr>
            <a:lvl3pPr marL="999073" indent="0">
              <a:buNone/>
              <a:defRPr sz="1311"/>
            </a:lvl3pPr>
            <a:lvl4pPr marL="1498610" indent="0">
              <a:buNone/>
              <a:defRPr sz="1093"/>
            </a:lvl4pPr>
            <a:lvl5pPr marL="1998147" indent="0">
              <a:buNone/>
              <a:defRPr sz="1093"/>
            </a:lvl5pPr>
            <a:lvl6pPr marL="2497684" indent="0">
              <a:buNone/>
              <a:defRPr sz="1093"/>
            </a:lvl6pPr>
            <a:lvl7pPr marL="2997220" indent="0">
              <a:buNone/>
              <a:defRPr sz="1093"/>
            </a:lvl7pPr>
            <a:lvl8pPr marL="3496757" indent="0">
              <a:buNone/>
              <a:defRPr sz="1093"/>
            </a:lvl8pPr>
            <a:lvl9pPr marL="3996294" indent="0">
              <a:buNone/>
              <a:defRPr sz="109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0796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442715"/>
            <a:ext cx="11489115" cy="1607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213570"/>
            <a:ext cx="11489115" cy="5275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7707075"/>
            <a:ext cx="2997160" cy="4427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7707075"/>
            <a:ext cx="4495741" cy="4427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7707075"/>
            <a:ext cx="2997160" cy="4427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332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99073" rtl="0" eaLnBrk="1" latinLnBrk="0" hangingPunct="1">
        <a:lnSpc>
          <a:spcPct val="90000"/>
        </a:lnSpc>
        <a:spcBef>
          <a:spcPct val="0"/>
        </a:spcBef>
        <a:buNone/>
        <a:defRPr sz="48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9768" indent="-249768" algn="l" defTabSz="999073" rtl="0" eaLnBrk="1" latinLnBrk="0" hangingPunct="1">
        <a:lnSpc>
          <a:spcPct val="90000"/>
        </a:lnSpc>
        <a:spcBef>
          <a:spcPts val="1093"/>
        </a:spcBef>
        <a:buFont typeface="Arial" panose="020B0604020202020204" pitchFamily="34" charset="0"/>
        <a:buChar char="•"/>
        <a:defRPr sz="3059" kern="1200">
          <a:solidFill>
            <a:schemeClr val="tx1"/>
          </a:solidFill>
          <a:latin typeface="+mn-lt"/>
          <a:ea typeface="+mn-ea"/>
          <a:cs typeface="+mn-cs"/>
        </a:defRPr>
      </a:lvl1pPr>
      <a:lvl2pPr marL="74930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2pPr>
      <a:lvl3pPr marL="124884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2185" kern="1200">
          <a:solidFill>
            <a:schemeClr val="tx1"/>
          </a:solidFill>
          <a:latin typeface="+mn-lt"/>
          <a:ea typeface="+mn-ea"/>
          <a:cs typeface="+mn-cs"/>
        </a:defRPr>
      </a:lvl3pPr>
      <a:lvl4pPr marL="1748379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4pPr>
      <a:lvl5pPr marL="224791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5pPr>
      <a:lvl6pPr marL="274745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6pPr>
      <a:lvl7pPr marL="3246989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7pPr>
      <a:lvl8pPr marL="374652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8pPr>
      <a:lvl9pPr marL="424606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1pPr>
      <a:lvl2pPr marL="49953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2pPr>
      <a:lvl3pPr marL="999073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3pPr>
      <a:lvl4pPr marL="149861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4pPr>
      <a:lvl5pPr marL="199814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5pPr>
      <a:lvl6pPr marL="2497684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6pPr>
      <a:lvl7pPr marL="299722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7pPr>
      <a:lvl8pPr marL="349675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8pPr>
      <a:lvl9pPr marL="3996294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Forme libre : forme 49">
            <a:extLst>
              <a:ext uri="{FF2B5EF4-FFF2-40B4-BE49-F238E27FC236}">
                <a16:creationId xmlns:a16="http://schemas.microsoft.com/office/drawing/2014/main" id="{2B080D64-7947-042B-F237-A1205EEA0DD8}"/>
              </a:ext>
            </a:extLst>
          </p:cNvPr>
          <p:cNvSpPr/>
          <p:nvPr/>
        </p:nvSpPr>
        <p:spPr>
          <a:xfrm>
            <a:off x="983742" y="735754"/>
            <a:ext cx="8038" cy="2571386"/>
          </a:xfrm>
          <a:custGeom>
            <a:avLst/>
            <a:gdLst>
              <a:gd name="connsiteX0" fmla="*/ 0 w 12700"/>
              <a:gd name="connsiteY0" fmla="*/ 4344042 h 4344041"/>
              <a:gd name="connsiteX1" fmla="*/ 0 w 12700"/>
              <a:gd name="connsiteY1" fmla="*/ 0 h 43440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700" h="4344041">
                <a:moveTo>
                  <a:pt x="0" y="4344042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 dirty="0"/>
          </a:p>
        </p:txBody>
      </p:sp>
      <p:sp>
        <p:nvSpPr>
          <p:cNvPr id="211" name="Forme libre : forme 210">
            <a:extLst>
              <a:ext uri="{FF2B5EF4-FFF2-40B4-BE49-F238E27FC236}">
                <a16:creationId xmlns:a16="http://schemas.microsoft.com/office/drawing/2014/main" id="{62ABE717-3C7C-A13B-FA67-43A96673608D}"/>
              </a:ext>
            </a:extLst>
          </p:cNvPr>
          <p:cNvSpPr/>
          <p:nvPr/>
        </p:nvSpPr>
        <p:spPr>
          <a:xfrm>
            <a:off x="983745" y="3307141"/>
            <a:ext cx="3577993" cy="7518"/>
          </a:xfrm>
          <a:custGeom>
            <a:avLst/>
            <a:gdLst>
              <a:gd name="connsiteX0" fmla="*/ 0 w 5653443"/>
              <a:gd name="connsiteY0" fmla="*/ 0 h 12700"/>
              <a:gd name="connsiteX1" fmla="*/ 5653444 w 565344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653443" h="12700">
                <a:moveTo>
                  <a:pt x="0" y="0"/>
                </a:moveTo>
                <a:lnTo>
                  <a:pt x="5653444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12" name="Forme libre : forme 211">
            <a:extLst>
              <a:ext uri="{FF2B5EF4-FFF2-40B4-BE49-F238E27FC236}">
                <a16:creationId xmlns:a16="http://schemas.microsoft.com/office/drawing/2014/main" id="{A607AFF8-D364-5124-06BD-8548B7571D89}"/>
              </a:ext>
            </a:extLst>
          </p:cNvPr>
          <p:cNvSpPr/>
          <p:nvPr/>
        </p:nvSpPr>
        <p:spPr>
          <a:xfrm>
            <a:off x="1327288" y="3307140"/>
            <a:ext cx="8038" cy="54000"/>
          </a:xfrm>
          <a:custGeom>
            <a:avLst/>
            <a:gdLst>
              <a:gd name="connsiteX0" fmla="*/ 0 w 12700"/>
              <a:gd name="connsiteY0" fmla="*/ 34823 h 34823"/>
              <a:gd name="connsiteX1" fmla="*/ 0 w 12700"/>
              <a:gd name="connsiteY1" fmla="*/ 0 h 348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700" h="34823">
                <a:moveTo>
                  <a:pt x="0" y="3482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13" name="Forme libre : forme 212">
            <a:extLst>
              <a:ext uri="{FF2B5EF4-FFF2-40B4-BE49-F238E27FC236}">
                <a16:creationId xmlns:a16="http://schemas.microsoft.com/office/drawing/2014/main" id="{E8AFCF76-3141-EBF8-2476-CDDB08F0F410}"/>
              </a:ext>
            </a:extLst>
          </p:cNvPr>
          <p:cNvSpPr/>
          <p:nvPr/>
        </p:nvSpPr>
        <p:spPr>
          <a:xfrm>
            <a:off x="2180576" y="3307140"/>
            <a:ext cx="8038" cy="54000"/>
          </a:xfrm>
          <a:custGeom>
            <a:avLst/>
            <a:gdLst>
              <a:gd name="connsiteX0" fmla="*/ 0 w 12700"/>
              <a:gd name="connsiteY0" fmla="*/ 34823 h 34823"/>
              <a:gd name="connsiteX1" fmla="*/ 0 w 12700"/>
              <a:gd name="connsiteY1" fmla="*/ 0 h 348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700" h="34823">
                <a:moveTo>
                  <a:pt x="0" y="3482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14" name="Forme libre : forme 213">
            <a:extLst>
              <a:ext uri="{FF2B5EF4-FFF2-40B4-BE49-F238E27FC236}">
                <a16:creationId xmlns:a16="http://schemas.microsoft.com/office/drawing/2014/main" id="{DF566E1C-37CA-A158-8A73-5FCEBC0E1BD4}"/>
              </a:ext>
            </a:extLst>
          </p:cNvPr>
          <p:cNvSpPr/>
          <p:nvPr/>
        </p:nvSpPr>
        <p:spPr>
          <a:xfrm>
            <a:off x="3033854" y="3307140"/>
            <a:ext cx="8038" cy="54000"/>
          </a:xfrm>
          <a:custGeom>
            <a:avLst/>
            <a:gdLst>
              <a:gd name="connsiteX0" fmla="*/ 0 w 12700"/>
              <a:gd name="connsiteY0" fmla="*/ 34823 h 34823"/>
              <a:gd name="connsiteX1" fmla="*/ 0 w 12700"/>
              <a:gd name="connsiteY1" fmla="*/ 0 h 348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700" h="34823">
                <a:moveTo>
                  <a:pt x="0" y="3482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15" name="Forme libre : forme 214">
            <a:extLst>
              <a:ext uri="{FF2B5EF4-FFF2-40B4-BE49-F238E27FC236}">
                <a16:creationId xmlns:a16="http://schemas.microsoft.com/office/drawing/2014/main" id="{E97354D9-EC03-F2DF-0CFB-763590423887}"/>
              </a:ext>
            </a:extLst>
          </p:cNvPr>
          <p:cNvSpPr/>
          <p:nvPr/>
        </p:nvSpPr>
        <p:spPr>
          <a:xfrm>
            <a:off x="3887133" y="3307140"/>
            <a:ext cx="8038" cy="54000"/>
          </a:xfrm>
          <a:custGeom>
            <a:avLst/>
            <a:gdLst>
              <a:gd name="connsiteX0" fmla="*/ 0 w 12700"/>
              <a:gd name="connsiteY0" fmla="*/ 34823 h 34823"/>
              <a:gd name="connsiteX1" fmla="*/ 0 w 12700"/>
              <a:gd name="connsiteY1" fmla="*/ 0 h 348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700" h="34823">
                <a:moveTo>
                  <a:pt x="0" y="3482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87" name="ZoneTexte 286">
            <a:extLst>
              <a:ext uri="{FF2B5EF4-FFF2-40B4-BE49-F238E27FC236}">
                <a16:creationId xmlns:a16="http://schemas.microsoft.com/office/drawing/2014/main" id="{24D704A6-1CC1-757E-8403-50452AEB580B}"/>
              </a:ext>
            </a:extLst>
          </p:cNvPr>
          <p:cNvSpPr txBox="1"/>
          <p:nvPr/>
        </p:nvSpPr>
        <p:spPr>
          <a:xfrm>
            <a:off x="1130524" y="331467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0</a:t>
            </a:r>
          </a:p>
        </p:txBody>
      </p:sp>
      <p:sp>
        <p:nvSpPr>
          <p:cNvPr id="288" name="ZoneTexte 287">
            <a:extLst>
              <a:ext uri="{FF2B5EF4-FFF2-40B4-BE49-F238E27FC236}">
                <a16:creationId xmlns:a16="http://schemas.microsoft.com/office/drawing/2014/main" id="{4C490467-A978-508B-71E2-0A454A33AFC6}"/>
              </a:ext>
            </a:extLst>
          </p:cNvPr>
          <p:cNvSpPr txBox="1"/>
          <p:nvPr/>
        </p:nvSpPr>
        <p:spPr>
          <a:xfrm>
            <a:off x="1992314" y="331467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2</a:t>
            </a:r>
            <a:r>
              <a:rPr lang="en-GB" sz="1200" dirty="0"/>
              <a:t>.</a:t>
            </a:r>
            <a:r>
              <a:rPr lang="fr-FR" sz="1200" dirty="0"/>
              <a:t>5</a:t>
            </a:r>
          </a:p>
        </p:txBody>
      </p:sp>
      <p:sp>
        <p:nvSpPr>
          <p:cNvPr id="289" name="ZoneTexte 288">
            <a:extLst>
              <a:ext uri="{FF2B5EF4-FFF2-40B4-BE49-F238E27FC236}">
                <a16:creationId xmlns:a16="http://schemas.microsoft.com/office/drawing/2014/main" id="{882D6642-3DDC-EDF8-908E-0E40F2BDE73C}"/>
              </a:ext>
            </a:extLst>
          </p:cNvPr>
          <p:cNvSpPr txBox="1"/>
          <p:nvPr/>
        </p:nvSpPr>
        <p:spPr>
          <a:xfrm>
            <a:off x="2841122" y="331467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5</a:t>
            </a:r>
            <a:r>
              <a:rPr lang="en-GB" sz="1200" dirty="0"/>
              <a:t>.</a:t>
            </a:r>
            <a:r>
              <a:rPr lang="fr-FR" sz="1200" dirty="0"/>
              <a:t>0</a:t>
            </a:r>
          </a:p>
        </p:txBody>
      </p:sp>
      <p:sp>
        <p:nvSpPr>
          <p:cNvPr id="290" name="ZoneTexte 289">
            <a:extLst>
              <a:ext uri="{FF2B5EF4-FFF2-40B4-BE49-F238E27FC236}">
                <a16:creationId xmlns:a16="http://schemas.microsoft.com/office/drawing/2014/main" id="{2798D7EF-C132-98EB-D737-094AE9E55986}"/>
              </a:ext>
            </a:extLst>
          </p:cNvPr>
          <p:cNvSpPr txBox="1"/>
          <p:nvPr/>
        </p:nvSpPr>
        <p:spPr>
          <a:xfrm>
            <a:off x="3694427" y="331467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7</a:t>
            </a:r>
            <a:r>
              <a:rPr lang="en-GB" sz="1200" dirty="0"/>
              <a:t>.</a:t>
            </a:r>
            <a:r>
              <a:rPr lang="fr-FR" sz="1200" dirty="0"/>
              <a:t>5</a:t>
            </a:r>
          </a:p>
        </p:txBody>
      </p:sp>
      <p:sp>
        <p:nvSpPr>
          <p:cNvPr id="291" name="ZoneTexte 290">
            <a:extLst>
              <a:ext uri="{FF2B5EF4-FFF2-40B4-BE49-F238E27FC236}">
                <a16:creationId xmlns:a16="http://schemas.microsoft.com/office/drawing/2014/main" id="{ECFABCCE-E52C-860B-7B46-E0DF63134923}"/>
              </a:ext>
            </a:extLst>
          </p:cNvPr>
          <p:cNvSpPr txBox="1"/>
          <p:nvPr/>
        </p:nvSpPr>
        <p:spPr>
          <a:xfrm>
            <a:off x="1668159" y="3536806"/>
            <a:ext cx="2164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Nasal viral </a:t>
            </a:r>
            <a:r>
              <a:rPr lang="fr-FR" sz="1200" dirty="0" err="1"/>
              <a:t>load</a:t>
            </a:r>
            <a:r>
              <a:rPr lang="fr-FR" sz="1200" dirty="0"/>
              <a:t> (log</a:t>
            </a:r>
            <a:r>
              <a:rPr lang="fr-FR" sz="1200" baseline="-25000" dirty="0"/>
              <a:t>10</a:t>
            </a:r>
            <a:r>
              <a:rPr lang="fr-FR" sz="1200" dirty="0"/>
              <a:t>/10</a:t>
            </a:r>
            <a:r>
              <a:rPr lang="fr-FR" sz="1200" baseline="30000" dirty="0"/>
              <a:t>6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) </a:t>
            </a:r>
          </a:p>
        </p:txBody>
      </p: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27B29B56-13DD-4D7E-8A31-7FE730B30707}"/>
              </a:ext>
            </a:extLst>
          </p:cNvPr>
          <p:cNvGrpSpPr/>
          <p:nvPr/>
        </p:nvGrpSpPr>
        <p:grpSpPr>
          <a:xfrm>
            <a:off x="37845" y="767137"/>
            <a:ext cx="5172359" cy="400547"/>
            <a:chOff x="37845" y="767137"/>
            <a:chExt cx="5172359" cy="400547"/>
          </a:xfrm>
        </p:grpSpPr>
        <p:grpSp>
          <p:nvGrpSpPr>
            <p:cNvPr id="6" name="Groupe 5">
              <a:extLst>
                <a:ext uri="{FF2B5EF4-FFF2-40B4-BE49-F238E27FC236}">
                  <a16:creationId xmlns:a16="http://schemas.microsoft.com/office/drawing/2014/main" id="{0C71759E-0F7F-404A-8DDA-051FEE32B0D1}"/>
                </a:ext>
              </a:extLst>
            </p:cNvPr>
            <p:cNvGrpSpPr/>
            <p:nvPr/>
          </p:nvGrpSpPr>
          <p:grpSpPr>
            <a:xfrm>
              <a:off x="1510241" y="845906"/>
              <a:ext cx="2619215" cy="243008"/>
              <a:chOff x="1510241" y="814026"/>
              <a:chExt cx="2619215" cy="243008"/>
            </a:xfrm>
          </p:grpSpPr>
          <p:sp>
            <p:nvSpPr>
              <p:cNvPr id="14" name="Forme libre : forme 13">
                <a:extLst>
                  <a:ext uri="{FF2B5EF4-FFF2-40B4-BE49-F238E27FC236}">
                    <a16:creationId xmlns:a16="http://schemas.microsoft.com/office/drawing/2014/main" id="{1F9A4973-1BC3-3096-1BA9-E9CE6A6BB55D}"/>
                  </a:ext>
                </a:extLst>
              </p:cNvPr>
              <p:cNvSpPr/>
              <p:nvPr/>
            </p:nvSpPr>
            <p:spPr>
              <a:xfrm flipV="1">
                <a:off x="1510241" y="855044"/>
                <a:ext cx="1539310" cy="7518"/>
              </a:xfrm>
              <a:custGeom>
                <a:avLst/>
                <a:gdLst>
                  <a:gd name="connsiteX0" fmla="*/ 0 w 2432202"/>
                  <a:gd name="connsiteY0" fmla="*/ 0 h 12700"/>
                  <a:gd name="connsiteX1" fmla="*/ 2432202 w 243220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432202" h="12700">
                    <a:moveTo>
                      <a:pt x="0" y="0"/>
                    </a:moveTo>
                    <a:lnTo>
                      <a:pt x="2432202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5" name="Forme libre : forme 14">
                <a:extLst>
                  <a:ext uri="{FF2B5EF4-FFF2-40B4-BE49-F238E27FC236}">
                    <a16:creationId xmlns:a16="http://schemas.microsoft.com/office/drawing/2014/main" id="{9FB0F258-2F71-AC5F-40C0-6CBC004AE081}"/>
                  </a:ext>
                </a:extLst>
              </p:cNvPr>
              <p:cNvSpPr/>
              <p:nvPr/>
            </p:nvSpPr>
            <p:spPr>
              <a:xfrm flipV="1">
                <a:off x="3112345" y="990034"/>
                <a:ext cx="1017111" cy="7518"/>
              </a:xfrm>
              <a:custGeom>
                <a:avLst/>
                <a:gdLst>
                  <a:gd name="connsiteX0" fmla="*/ 0 w 1607096"/>
                  <a:gd name="connsiteY0" fmla="*/ 0 h 12700"/>
                  <a:gd name="connsiteX1" fmla="*/ 1607096 w 16070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07096" h="12700">
                    <a:moveTo>
                      <a:pt x="0" y="0"/>
                    </a:moveTo>
                    <a:lnTo>
                      <a:pt x="1607096" y="0"/>
                    </a:lnTo>
                  </a:path>
                </a:pathLst>
              </a:cu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2" name="Forme libre : forme 21">
                <a:extLst>
                  <a:ext uri="{FF2B5EF4-FFF2-40B4-BE49-F238E27FC236}">
                    <a16:creationId xmlns:a16="http://schemas.microsoft.com/office/drawing/2014/main" id="{DD981B0D-D4C9-09C7-4DB5-F310887AAAAE}"/>
                  </a:ext>
                </a:extLst>
              </p:cNvPr>
              <p:cNvSpPr/>
              <p:nvPr/>
            </p:nvSpPr>
            <p:spPr>
              <a:xfrm flipV="1">
                <a:off x="2225896" y="814026"/>
                <a:ext cx="108000" cy="108000"/>
              </a:xfrm>
              <a:custGeom>
                <a:avLst/>
                <a:gdLst>
                  <a:gd name="connsiteX0" fmla="*/ 72187 w 72186"/>
                  <a:gd name="connsiteY0" fmla="*/ 36091 h 72181"/>
                  <a:gd name="connsiteX1" fmla="*/ 0 w 72186"/>
                  <a:gd name="connsiteY1" fmla="*/ 36091 h 72181"/>
                  <a:gd name="connsiteX2" fmla="*/ 72187 w 72186"/>
                  <a:gd name="connsiteY2" fmla="*/ 36091 h 721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186" h="72181">
                    <a:moveTo>
                      <a:pt x="72187" y="36091"/>
                    </a:moveTo>
                    <a:cubicBezTo>
                      <a:pt x="72187" y="84212"/>
                      <a:pt x="0" y="84212"/>
                      <a:pt x="0" y="36091"/>
                    </a:cubicBezTo>
                    <a:cubicBezTo>
                      <a:pt x="0" y="-12030"/>
                      <a:pt x="72187" y="-12030"/>
                      <a:pt x="72187" y="36091"/>
                    </a:cubicBezTo>
                  </a:path>
                </a:pathLst>
              </a:custGeom>
              <a:solidFill>
                <a:schemeClr val="bg1"/>
              </a:solidFill>
              <a:ln w="3175" cap="rnd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 dirty="0"/>
              </a:p>
            </p:txBody>
          </p:sp>
          <p:sp>
            <p:nvSpPr>
              <p:cNvPr id="23" name="Forme libre : forme 22">
                <a:extLst>
                  <a:ext uri="{FF2B5EF4-FFF2-40B4-BE49-F238E27FC236}">
                    <a16:creationId xmlns:a16="http://schemas.microsoft.com/office/drawing/2014/main" id="{B0E70FB7-9326-04D0-C441-854193FDC194}"/>
                  </a:ext>
                </a:extLst>
              </p:cNvPr>
              <p:cNvSpPr/>
              <p:nvPr/>
            </p:nvSpPr>
            <p:spPr>
              <a:xfrm flipV="1">
                <a:off x="3566900" y="949034"/>
                <a:ext cx="108000" cy="108000"/>
              </a:xfrm>
              <a:custGeom>
                <a:avLst/>
                <a:gdLst>
                  <a:gd name="connsiteX0" fmla="*/ 72225 w 72225"/>
                  <a:gd name="connsiteY0" fmla="*/ 36128 h 72219"/>
                  <a:gd name="connsiteX1" fmla="*/ 0 w 72225"/>
                  <a:gd name="connsiteY1" fmla="*/ 36128 h 72219"/>
                  <a:gd name="connsiteX2" fmla="*/ 72225 w 72225"/>
                  <a:gd name="connsiteY2" fmla="*/ 36128 h 722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225" h="72219">
                    <a:moveTo>
                      <a:pt x="72225" y="36128"/>
                    </a:moveTo>
                    <a:cubicBezTo>
                      <a:pt x="72225" y="84250"/>
                      <a:pt x="0" y="84250"/>
                      <a:pt x="0" y="36128"/>
                    </a:cubicBezTo>
                    <a:cubicBezTo>
                      <a:pt x="0" y="-12043"/>
                      <a:pt x="72225" y="-12043"/>
                      <a:pt x="72225" y="36128"/>
                    </a:cubicBezTo>
                  </a:path>
                </a:pathLst>
              </a:custGeom>
              <a:solidFill>
                <a:schemeClr val="tx1">
                  <a:lumMod val="75000"/>
                  <a:lumOff val="25000"/>
                </a:schemeClr>
              </a:solidFill>
              <a:ln w="3175" cap="rnd">
                <a:solidFill>
                  <a:schemeClr val="tx1">
                    <a:lumMod val="75000"/>
                    <a:lumOff val="25000"/>
                  </a:schemeClr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grpSp>
          <p:nvGrpSpPr>
            <p:cNvPr id="26" name="Groupe 25">
              <a:extLst>
                <a:ext uri="{FF2B5EF4-FFF2-40B4-BE49-F238E27FC236}">
                  <a16:creationId xmlns:a16="http://schemas.microsoft.com/office/drawing/2014/main" id="{803FC5D8-18CE-4E34-906D-840B1126A6D9}"/>
                </a:ext>
              </a:extLst>
            </p:cNvPr>
            <p:cNvGrpSpPr/>
            <p:nvPr/>
          </p:nvGrpSpPr>
          <p:grpSpPr>
            <a:xfrm>
              <a:off x="37845" y="826282"/>
              <a:ext cx="947585" cy="282257"/>
              <a:chOff x="44195" y="834625"/>
              <a:chExt cx="947585" cy="282257"/>
            </a:xfrm>
          </p:grpSpPr>
          <p:sp>
            <p:nvSpPr>
              <p:cNvPr id="210" name="Forme libre : forme 209">
                <a:extLst>
                  <a:ext uri="{FF2B5EF4-FFF2-40B4-BE49-F238E27FC236}">
                    <a16:creationId xmlns:a16="http://schemas.microsoft.com/office/drawing/2014/main" id="{1603BEFB-843F-8ABB-5EA1-E584736AC8BF}"/>
                  </a:ext>
                </a:extLst>
              </p:cNvPr>
              <p:cNvSpPr/>
              <p:nvPr/>
            </p:nvSpPr>
            <p:spPr>
              <a:xfrm>
                <a:off x="937780" y="971994"/>
                <a:ext cx="54000" cy="7518"/>
              </a:xfrm>
              <a:custGeom>
                <a:avLst/>
                <a:gdLst>
                  <a:gd name="connsiteX0" fmla="*/ 0 w 34772"/>
                  <a:gd name="connsiteY0" fmla="*/ 0 h 12700"/>
                  <a:gd name="connsiteX1" fmla="*/ 34773 w 3477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772" h="12700">
                    <a:moveTo>
                      <a:pt x="0" y="0"/>
                    </a:moveTo>
                    <a:lnTo>
                      <a:pt x="34773" y="0"/>
                    </a:lnTo>
                  </a:path>
                </a:pathLst>
              </a:custGeom>
              <a:noFill/>
              <a:ln w="3175" cap="flat">
                <a:solidFill>
                  <a:srgbClr val="333333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79" name="ZoneTexte 278">
                <a:extLst>
                  <a:ext uri="{FF2B5EF4-FFF2-40B4-BE49-F238E27FC236}">
                    <a16:creationId xmlns:a16="http://schemas.microsoft.com/office/drawing/2014/main" id="{C81B6BE4-2708-B6AF-F4A1-B1B4345675BF}"/>
                  </a:ext>
                </a:extLst>
              </p:cNvPr>
              <p:cNvSpPr txBox="1"/>
              <p:nvPr/>
            </p:nvSpPr>
            <p:spPr>
              <a:xfrm>
                <a:off x="44195" y="834625"/>
                <a:ext cx="938014" cy="2822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200" dirty="0"/>
                  <a:t>SARS-CoV-2</a:t>
                </a:r>
              </a:p>
            </p:txBody>
          </p:sp>
        </p:grpSp>
        <p:grpSp>
          <p:nvGrpSpPr>
            <p:cNvPr id="37" name="Groupe 36">
              <a:extLst>
                <a:ext uri="{FF2B5EF4-FFF2-40B4-BE49-F238E27FC236}">
                  <a16:creationId xmlns:a16="http://schemas.microsoft.com/office/drawing/2014/main" id="{7A9C0632-CC8C-429D-897B-85A5CA279897}"/>
                </a:ext>
              </a:extLst>
            </p:cNvPr>
            <p:cNvGrpSpPr/>
            <p:nvPr/>
          </p:nvGrpSpPr>
          <p:grpSpPr>
            <a:xfrm>
              <a:off x="4526318" y="767137"/>
              <a:ext cx="683886" cy="400547"/>
              <a:chOff x="4606541" y="1180807"/>
              <a:chExt cx="683886" cy="400547"/>
            </a:xfrm>
          </p:grpSpPr>
          <p:grpSp>
            <p:nvGrpSpPr>
              <p:cNvPr id="30" name="Groupe 29">
                <a:extLst>
                  <a:ext uri="{FF2B5EF4-FFF2-40B4-BE49-F238E27FC236}">
                    <a16:creationId xmlns:a16="http://schemas.microsoft.com/office/drawing/2014/main" id="{B5554709-C60A-4721-A5E9-D88E95C99BB2}"/>
                  </a:ext>
                </a:extLst>
              </p:cNvPr>
              <p:cNvGrpSpPr/>
              <p:nvPr/>
            </p:nvGrpSpPr>
            <p:grpSpPr>
              <a:xfrm>
                <a:off x="4606541" y="1180807"/>
                <a:ext cx="64097" cy="400547"/>
                <a:chOff x="4601778" y="1180807"/>
                <a:chExt cx="64097" cy="400547"/>
              </a:xfrm>
            </p:grpSpPr>
            <p:sp>
              <p:nvSpPr>
                <p:cNvPr id="47" name="Forme libre : forme 46">
                  <a:extLst>
                    <a:ext uri="{FF2B5EF4-FFF2-40B4-BE49-F238E27FC236}">
                      <a16:creationId xmlns:a16="http://schemas.microsoft.com/office/drawing/2014/main" id="{3B1614DA-11C0-D119-9BB8-D998A682ADCF}"/>
                    </a:ext>
                  </a:extLst>
                </p:cNvPr>
                <p:cNvSpPr/>
                <p:nvPr/>
              </p:nvSpPr>
              <p:spPr>
                <a:xfrm>
                  <a:off x="4601778" y="1568654"/>
                  <a:ext cx="51396" cy="12700"/>
                </a:xfrm>
                <a:custGeom>
                  <a:avLst/>
                  <a:gdLst>
                    <a:gd name="connsiteX0" fmla="*/ 0 w 51396"/>
                    <a:gd name="connsiteY0" fmla="*/ 0 h 12700"/>
                    <a:gd name="connsiteX1" fmla="*/ 51397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0" y="0"/>
                      </a:moveTo>
                      <a:lnTo>
                        <a:pt x="51397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48" name="Forme libre : forme 47">
                  <a:extLst>
                    <a:ext uri="{FF2B5EF4-FFF2-40B4-BE49-F238E27FC236}">
                      <a16:creationId xmlns:a16="http://schemas.microsoft.com/office/drawing/2014/main" id="{1B9C2DBC-0857-D54E-9E65-F50C3233AE5F}"/>
                    </a:ext>
                  </a:extLst>
                </p:cNvPr>
                <p:cNvSpPr/>
                <p:nvPr/>
              </p:nvSpPr>
              <p:spPr>
                <a:xfrm>
                  <a:off x="4653175" y="1180807"/>
                  <a:ext cx="12700" cy="387846"/>
                </a:xfrm>
                <a:custGeom>
                  <a:avLst/>
                  <a:gdLst>
                    <a:gd name="connsiteX0" fmla="*/ 0 w 12700"/>
                    <a:gd name="connsiteY0" fmla="*/ 387847 h 387846"/>
                    <a:gd name="connsiteX1" fmla="*/ 0 w 12700"/>
                    <a:gd name="connsiteY1" fmla="*/ 0 h 3878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00" h="387846">
                      <a:moveTo>
                        <a:pt x="0" y="387847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49" name="Forme libre : forme 48">
                  <a:extLst>
                    <a:ext uri="{FF2B5EF4-FFF2-40B4-BE49-F238E27FC236}">
                      <a16:creationId xmlns:a16="http://schemas.microsoft.com/office/drawing/2014/main" id="{DAF56565-2388-4291-0448-C9A9F686A23F}"/>
                    </a:ext>
                  </a:extLst>
                </p:cNvPr>
                <p:cNvSpPr/>
                <p:nvPr/>
              </p:nvSpPr>
              <p:spPr>
                <a:xfrm>
                  <a:off x="4601778" y="1180807"/>
                  <a:ext cx="51396" cy="12700"/>
                </a:xfrm>
                <a:custGeom>
                  <a:avLst/>
                  <a:gdLst>
                    <a:gd name="connsiteX0" fmla="*/ 51397 w 51396"/>
                    <a:gd name="connsiteY0" fmla="*/ 0 h 12700"/>
                    <a:gd name="connsiteX1" fmla="*/ 0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51397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sp>
            <p:nvSpPr>
              <p:cNvPr id="2" name="ZoneTexte 1">
                <a:extLst>
                  <a:ext uri="{FF2B5EF4-FFF2-40B4-BE49-F238E27FC236}">
                    <a16:creationId xmlns:a16="http://schemas.microsoft.com/office/drawing/2014/main" id="{68C2C617-BB3B-50C5-0FB6-7A7A18CBA56A}"/>
                  </a:ext>
                </a:extLst>
              </p:cNvPr>
              <p:cNvSpPr txBox="1"/>
              <p:nvPr/>
            </p:nvSpPr>
            <p:spPr>
              <a:xfrm>
                <a:off x="4660126" y="1255080"/>
                <a:ext cx="63030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i="1" dirty="0">
                    <a:cs typeface="Times New Roman" panose="02020603050405020304" pitchFamily="18" charset="0"/>
                  </a:rPr>
                  <a:t>&lt;0</a:t>
                </a:r>
                <a:r>
                  <a:rPr lang="en-GB" sz="1050" i="1" dirty="0">
                    <a:cs typeface="Times New Roman" panose="02020603050405020304" pitchFamily="18" charset="0"/>
                  </a:rPr>
                  <a:t>.</a:t>
                </a:r>
                <a:r>
                  <a:rPr lang="en-GB" sz="1050" i="1" dirty="0">
                    <a:ea typeface="Times New Roman" panose="02020603050405020304" pitchFamily="18" charset="0"/>
                  </a:rPr>
                  <a:t>0001</a:t>
                </a:r>
                <a:endParaRPr lang="fr-FR" sz="1050" i="1" dirty="0"/>
              </a:p>
            </p:txBody>
          </p:sp>
        </p:grpSp>
      </p:grpSp>
      <p:grpSp>
        <p:nvGrpSpPr>
          <p:cNvPr id="61" name="Groupe 60">
            <a:extLst>
              <a:ext uri="{FF2B5EF4-FFF2-40B4-BE49-F238E27FC236}">
                <a16:creationId xmlns:a16="http://schemas.microsoft.com/office/drawing/2014/main" id="{2EC0072C-54BE-478A-AFE7-EC1D9BB52CE6}"/>
              </a:ext>
            </a:extLst>
          </p:cNvPr>
          <p:cNvGrpSpPr/>
          <p:nvPr/>
        </p:nvGrpSpPr>
        <p:grpSpPr>
          <a:xfrm>
            <a:off x="553820" y="1462862"/>
            <a:ext cx="4656384" cy="400545"/>
            <a:chOff x="553820" y="1473079"/>
            <a:chExt cx="4656384" cy="400545"/>
          </a:xfrm>
        </p:grpSpPr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CBB149FF-3A64-45FF-B965-F2C843D0E251}"/>
                </a:ext>
              </a:extLst>
            </p:cNvPr>
            <p:cNvGrpSpPr/>
            <p:nvPr/>
          </p:nvGrpSpPr>
          <p:grpSpPr>
            <a:xfrm>
              <a:off x="2274263" y="1555020"/>
              <a:ext cx="1588130" cy="236662"/>
              <a:chOff x="2274263" y="1509142"/>
              <a:chExt cx="1588130" cy="236662"/>
            </a:xfrm>
          </p:grpSpPr>
          <p:sp>
            <p:nvSpPr>
              <p:cNvPr id="12" name="Forme libre : forme 11">
                <a:extLst>
                  <a:ext uri="{FF2B5EF4-FFF2-40B4-BE49-F238E27FC236}">
                    <a16:creationId xmlns:a16="http://schemas.microsoft.com/office/drawing/2014/main" id="{6F167629-450D-5BC3-7427-555E9F4A71E3}"/>
                  </a:ext>
                </a:extLst>
              </p:cNvPr>
              <p:cNvSpPr/>
              <p:nvPr/>
            </p:nvSpPr>
            <p:spPr>
              <a:xfrm flipV="1">
                <a:off x="2274263" y="1550162"/>
                <a:ext cx="682286" cy="7518"/>
              </a:xfrm>
              <a:custGeom>
                <a:avLst/>
                <a:gdLst>
                  <a:gd name="connsiteX0" fmla="*/ 0 w 1078052"/>
                  <a:gd name="connsiteY0" fmla="*/ 0 h 12700"/>
                  <a:gd name="connsiteX1" fmla="*/ 1078052 w 107805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78052" h="12700">
                    <a:moveTo>
                      <a:pt x="0" y="0"/>
                    </a:moveTo>
                    <a:lnTo>
                      <a:pt x="1078052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 dirty="0"/>
              </a:p>
            </p:txBody>
          </p:sp>
          <p:sp>
            <p:nvSpPr>
              <p:cNvPr id="13" name="Forme libre : forme 12">
                <a:extLst>
                  <a:ext uri="{FF2B5EF4-FFF2-40B4-BE49-F238E27FC236}">
                    <a16:creationId xmlns:a16="http://schemas.microsoft.com/office/drawing/2014/main" id="{4A8E8965-FC17-5087-CFCE-B083BF12A6A5}"/>
                  </a:ext>
                </a:extLst>
              </p:cNvPr>
              <p:cNvSpPr/>
              <p:nvPr/>
            </p:nvSpPr>
            <p:spPr>
              <a:xfrm flipV="1">
                <a:off x="3134357" y="1685151"/>
                <a:ext cx="728036" cy="7518"/>
              </a:xfrm>
              <a:custGeom>
                <a:avLst/>
                <a:gdLst>
                  <a:gd name="connsiteX0" fmla="*/ 0 w 1150340"/>
                  <a:gd name="connsiteY0" fmla="*/ 0 h 12700"/>
                  <a:gd name="connsiteX1" fmla="*/ 1150341 w 1150340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50340" h="12700">
                    <a:moveTo>
                      <a:pt x="0" y="0"/>
                    </a:moveTo>
                    <a:lnTo>
                      <a:pt x="1150341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0" name="Forme libre : forme 19">
                <a:extLst>
                  <a:ext uri="{FF2B5EF4-FFF2-40B4-BE49-F238E27FC236}">
                    <a16:creationId xmlns:a16="http://schemas.microsoft.com/office/drawing/2014/main" id="{92822D92-FE31-7B18-2C6E-723DE774A131}"/>
                  </a:ext>
                </a:extLst>
              </p:cNvPr>
              <p:cNvSpPr/>
              <p:nvPr/>
            </p:nvSpPr>
            <p:spPr>
              <a:xfrm flipV="1">
                <a:off x="2561406" y="1509142"/>
                <a:ext cx="108000" cy="108000"/>
              </a:xfrm>
              <a:custGeom>
                <a:avLst/>
                <a:gdLst>
                  <a:gd name="connsiteX0" fmla="*/ 72187 w 72186"/>
                  <a:gd name="connsiteY0" fmla="*/ 36090 h 72180"/>
                  <a:gd name="connsiteX1" fmla="*/ 0 w 72186"/>
                  <a:gd name="connsiteY1" fmla="*/ 36090 h 72180"/>
                  <a:gd name="connsiteX2" fmla="*/ 72187 w 72186"/>
                  <a:gd name="connsiteY2" fmla="*/ 36090 h 72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186" h="72180">
                    <a:moveTo>
                      <a:pt x="72187" y="36090"/>
                    </a:moveTo>
                    <a:cubicBezTo>
                      <a:pt x="72187" y="84211"/>
                      <a:pt x="0" y="84211"/>
                      <a:pt x="0" y="36090"/>
                    </a:cubicBezTo>
                    <a:cubicBezTo>
                      <a:pt x="0" y="-12030"/>
                      <a:pt x="72187" y="-12030"/>
                      <a:pt x="72187" y="36090"/>
                    </a:cubicBezTo>
                  </a:path>
                </a:pathLst>
              </a:custGeom>
              <a:solidFill>
                <a:schemeClr val="bg1"/>
              </a:solidFill>
              <a:ln w="3175" cap="rnd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1" name="Forme libre : forme 20">
                <a:extLst>
                  <a:ext uri="{FF2B5EF4-FFF2-40B4-BE49-F238E27FC236}">
                    <a16:creationId xmlns:a16="http://schemas.microsoft.com/office/drawing/2014/main" id="{F1E2FC3D-0796-915A-47A8-8BCC79DD9D75}"/>
                  </a:ext>
                </a:extLst>
              </p:cNvPr>
              <p:cNvSpPr/>
              <p:nvPr/>
            </p:nvSpPr>
            <p:spPr>
              <a:xfrm flipV="1">
                <a:off x="3444375" y="1637804"/>
                <a:ext cx="108000" cy="108000"/>
              </a:xfrm>
              <a:custGeom>
                <a:avLst/>
                <a:gdLst>
                  <a:gd name="connsiteX0" fmla="*/ 72225 w 72225"/>
                  <a:gd name="connsiteY0" fmla="*/ 36128 h 72218"/>
                  <a:gd name="connsiteX1" fmla="*/ 0 w 72225"/>
                  <a:gd name="connsiteY1" fmla="*/ 36128 h 72218"/>
                  <a:gd name="connsiteX2" fmla="*/ 72225 w 72225"/>
                  <a:gd name="connsiteY2" fmla="*/ 36128 h 72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225" h="72218">
                    <a:moveTo>
                      <a:pt x="72225" y="36128"/>
                    </a:moveTo>
                    <a:cubicBezTo>
                      <a:pt x="72225" y="84249"/>
                      <a:pt x="0" y="84249"/>
                      <a:pt x="0" y="36128"/>
                    </a:cubicBezTo>
                    <a:cubicBezTo>
                      <a:pt x="0" y="-12043"/>
                      <a:pt x="72225" y="-12043"/>
                      <a:pt x="72225" y="36128"/>
                    </a:cubicBezTo>
                  </a:path>
                </a:pathLst>
              </a:custGeom>
              <a:solidFill>
                <a:schemeClr val="tx1">
                  <a:lumMod val="75000"/>
                  <a:lumOff val="25000"/>
                </a:schemeClr>
              </a:solidFill>
              <a:ln w="3175" cap="rnd">
                <a:solidFill>
                  <a:schemeClr val="tx1">
                    <a:lumMod val="75000"/>
                    <a:lumOff val="25000"/>
                  </a:schemeClr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grpSp>
          <p:nvGrpSpPr>
            <p:cNvPr id="46" name="Groupe 45">
              <a:extLst>
                <a:ext uri="{FF2B5EF4-FFF2-40B4-BE49-F238E27FC236}">
                  <a16:creationId xmlns:a16="http://schemas.microsoft.com/office/drawing/2014/main" id="{B04BE426-3B6C-420A-AB66-2DA8C75FF60E}"/>
                </a:ext>
              </a:extLst>
            </p:cNvPr>
            <p:cNvGrpSpPr/>
            <p:nvPr/>
          </p:nvGrpSpPr>
          <p:grpSpPr>
            <a:xfrm>
              <a:off x="553820" y="1534852"/>
              <a:ext cx="431610" cy="276999"/>
              <a:chOff x="560170" y="1550092"/>
              <a:chExt cx="431610" cy="276999"/>
            </a:xfrm>
          </p:grpSpPr>
          <p:sp>
            <p:nvSpPr>
              <p:cNvPr id="208" name="Forme libre : forme 207">
                <a:extLst>
                  <a:ext uri="{FF2B5EF4-FFF2-40B4-BE49-F238E27FC236}">
                    <a16:creationId xmlns:a16="http://schemas.microsoft.com/office/drawing/2014/main" id="{D40AB641-9D8C-3E7B-A555-9E42FC8794F6}"/>
                  </a:ext>
                </a:extLst>
              </p:cNvPr>
              <p:cNvSpPr/>
              <p:nvPr/>
            </p:nvSpPr>
            <p:spPr>
              <a:xfrm>
                <a:off x="937780" y="1684832"/>
                <a:ext cx="54000" cy="7518"/>
              </a:xfrm>
              <a:custGeom>
                <a:avLst/>
                <a:gdLst>
                  <a:gd name="connsiteX0" fmla="*/ 0 w 34772"/>
                  <a:gd name="connsiteY0" fmla="*/ 0 h 12700"/>
                  <a:gd name="connsiteX1" fmla="*/ 34773 w 3477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772" h="12700">
                    <a:moveTo>
                      <a:pt x="0" y="0"/>
                    </a:moveTo>
                    <a:lnTo>
                      <a:pt x="34773" y="0"/>
                    </a:lnTo>
                  </a:path>
                </a:pathLst>
              </a:custGeom>
              <a:noFill/>
              <a:ln w="3175" cap="flat">
                <a:solidFill>
                  <a:srgbClr val="333333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80" name="ZoneTexte 279">
                <a:extLst>
                  <a:ext uri="{FF2B5EF4-FFF2-40B4-BE49-F238E27FC236}">
                    <a16:creationId xmlns:a16="http://schemas.microsoft.com/office/drawing/2014/main" id="{462143B1-4F2C-889C-6E3C-F9AF4CCA88C3}"/>
                  </a:ext>
                </a:extLst>
              </p:cNvPr>
              <p:cNvSpPr txBox="1"/>
              <p:nvPr/>
            </p:nvSpPr>
            <p:spPr>
              <a:xfrm>
                <a:off x="560170" y="1550092"/>
                <a:ext cx="4220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200" dirty="0"/>
                  <a:t>RSV</a:t>
                </a:r>
              </a:p>
            </p:txBody>
          </p:sp>
        </p:grpSp>
        <p:grpSp>
          <p:nvGrpSpPr>
            <p:cNvPr id="38" name="Groupe 37">
              <a:extLst>
                <a:ext uri="{FF2B5EF4-FFF2-40B4-BE49-F238E27FC236}">
                  <a16:creationId xmlns:a16="http://schemas.microsoft.com/office/drawing/2014/main" id="{3093740E-0D8E-4D60-8253-AD9E7B57C550}"/>
                </a:ext>
              </a:extLst>
            </p:cNvPr>
            <p:cNvGrpSpPr/>
            <p:nvPr/>
          </p:nvGrpSpPr>
          <p:grpSpPr>
            <a:xfrm>
              <a:off x="4526318" y="1473079"/>
              <a:ext cx="683886" cy="400545"/>
              <a:chOff x="4606541" y="2344398"/>
              <a:chExt cx="683886" cy="400545"/>
            </a:xfrm>
          </p:grpSpPr>
          <p:grpSp>
            <p:nvGrpSpPr>
              <p:cNvPr id="34" name="Groupe 33">
                <a:extLst>
                  <a:ext uri="{FF2B5EF4-FFF2-40B4-BE49-F238E27FC236}">
                    <a16:creationId xmlns:a16="http://schemas.microsoft.com/office/drawing/2014/main" id="{6AF92E46-B8B5-4F88-A650-10739F17E8DD}"/>
                  </a:ext>
                </a:extLst>
              </p:cNvPr>
              <p:cNvGrpSpPr/>
              <p:nvPr/>
            </p:nvGrpSpPr>
            <p:grpSpPr>
              <a:xfrm>
                <a:off x="4606541" y="2344398"/>
                <a:ext cx="64097" cy="400545"/>
                <a:chOff x="4601778" y="2344398"/>
                <a:chExt cx="64097" cy="400545"/>
              </a:xfrm>
            </p:grpSpPr>
            <p:sp>
              <p:nvSpPr>
                <p:cNvPr id="39" name="Forme libre : forme 38">
                  <a:extLst>
                    <a:ext uri="{FF2B5EF4-FFF2-40B4-BE49-F238E27FC236}">
                      <a16:creationId xmlns:a16="http://schemas.microsoft.com/office/drawing/2014/main" id="{DFB9D7D2-4AF9-1CA3-7D13-30D4A609EDA7}"/>
                    </a:ext>
                  </a:extLst>
                </p:cNvPr>
                <p:cNvSpPr/>
                <p:nvPr/>
              </p:nvSpPr>
              <p:spPr>
                <a:xfrm>
                  <a:off x="4601778" y="2732243"/>
                  <a:ext cx="51396" cy="12700"/>
                </a:xfrm>
                <a:custGeom>
                  <a:avLst/>
                  <a:gdLst>
                    <a:gd name="connsiteX0" fmla="*/ 0 w 51396"/>
                    <a:gd name="connsiteY0" fmla="*/ 0 h 12700"/>
                    <a:gd name="connsiteX1" fmla="*/ 51397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0" y="0"/>
                      </a:moveTo>
                      <a:lnTo>
                        <a:pt x="51397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40" name="Forme libre : forme 39">
                  <a:extLst>
                    <a:ext uri="{FF2B5EF4-FFF2-40B4-BE49-F238E27FC236}">
                      <a16:creationId xmlns:a16="http://schemas.microsoft.com/office/drawing/2014/main" id="{2A27F25E-CFDF-D455-56BC-879B7FDFC3CA}"/>
                    </a:ext>
                  </a:extLst>
                </p:cNvPr>
                <p:cNvSpPr/>
                <p:nvPr/>
              </p:nvSpPr>
              <p:spPr>
                <a:xfrm>
                  <a:off x="4653175" y="2344398"/>
                  <a:ext cx="12700" cy="387845"/>
                </a:xfrm>
                <a:custGeom>
                  <a:avLst/>
                  <a:gdLst>
                    <a:gd name="connsiteX0" fmla="*/ 0 w 12700"/>
                    <a:gd name="connsiteY0" fmla="*/ 387845 h 387845"/>
                    <a:gd name="connsiteX1" fmla="*/ 0 w 12700"/>
                    <a:gd name="connsiteY1" fmla="*/ 0 h 3878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00" h="387845">
                      <a:moveTo>
                        <a:pt x="0" y="3878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41" name="Forme libre : forme 40">
                  <a:extLst>
                    <a:ext uri="{FF2B5EF4-FFF2-40B4-BE49-F238E27FC236}">
                      <a16:creationId xmlns:a16="http://schemas.microsoft.com/office/drawing/2014/main" id="{C45C5420-9BA2-CBF7-59A7-7A979D1027AE}"/>
                    </a:ext>
                  </a:extLst>
                </p:cNvPr>
                <p:cNvSpPr/>
                <p:nvPr/>
              </p:nvSpPr>
              <p:spPr>
                <a:xfrm>
                  <a:off x="4601778" y="2344398"/>
                  <a:ext cx="51396" cy="12700"/>
                </a:xfrm>
                <a:custGeom>
                  <a:avLst/>
                  <a:gdLst>
                    <a:gd name="connsiteX0" fmla="*/ 51397 w 51396"/>
                    <a:gd name="connsiteY0" fmla="*/ 0 h 12700"/>
                    <a:gd name="connsiteX1" fmla="*/ 0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51397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sp>
            <p:nvSpPr>
              <p:cNvPr id="3" name="ZoneTexte 2">
                <a:extLst>
                  <a:ext uri="{FF2B5EF4-FFF2-40B4-BE49-F238E27FC236}">
                    <a16:creationId xmlns:a16="http://schemas.microsoft.com/office/drawing/2014/main" id="{5C90947D-B2C4-7AEB-2523-731F4D319E29}"/>
                  </a:ext>
                </a:extLst>
              </p:cNvPr>
              <p:cNvSpPr txBox="1"/>
              <p:nvPr/>
            </p:nvSpPr>
            <p:spPr>
              <a:xfrm>
                <a:off x="4660126" y="2418670"/>
                <a:ext cx="63030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i="1" dirty="0">
                    <a:cs typeface="Times New Roman" panose="02020603050405020304" pitchFamily="18" charset="0"/>
                  </a:rPr>
                  <a:t>&lt;0</a:t>
                </a:r>
                <a:r>
                  <a:rPr lang="en-GB" sz="1050" i="1" dirty="0">
                    <a:cs typeface="Times New Roman" panose="02020603050405020304" pitchFamily="18" charset="0"/>
                  </a:rPr>
                  <a:t>.</a:t>
                </a:r>
                <a:r>
                  <a:rPr lang="en-GB" sz="1050" i="1" dirty="0">
                    <a:ea typeface="Times New Roman" panose="02020603050405020304" pitchFamily="18" charset="0"/>
                  </a:rPr>
                  <a:t>0001</a:t>
                </a:r>
                <a:endParaRPr lang="fr-FR" sz="1050" i="1" dirty="0"/>
              </a:p>
            </p:txBody>
          </p:sp>
        </p:grpSp>
      </p:grpSp>
      <p:grpSp>
        <p:nvGrpSpPr>
          <p:cNvPr id="60" name="Groupe 59">
            <a:extLst>
              <a:ext uri="{FF2B5EF4-FFF2-40B4-BE49-F238E27FC236}">
                <a16:creationId xmlns:a16="http://schemas.microsoft.com/office/drawing/2014/main" id="{08C208A4-28F1-4445-85C5-2542356D8FE0}"/>
              </a:ext>
            </a:extLst>
          </p:cNvPr>
          <p:cNvGrpSpPr/>
          <p:nvPr/>
        </p:nvGrpSpPr>
        <p:grpSpPr>
          <a:xfrm>
            <a:off x="584665" y="2158585"/>
            <a:ext cx="4489287" cy="400546"/>
            <a:chOff x="584665" y="2151183"/>
            <a:chExt cx="4489287" cy="400546"/>
          </a:xfrm>
        </p:grpSpPr>
        <p:grpSp>
          <p:nvGrpSpPr>
            <p:cNvPr id="24" name="Groupe 23">
              <a:extLst>
                <a:ext uri="{FF2B5EF4-FFF2-40B4-BE49-F238E27FC236}">
                  <a16:creationId xmlns:a16="http://schemas.microsoft.com/office/drawing/2014/main" id="{F632FAB4-CCC5-416A-BAF3-5411A4BDBB6B}"/>
                </a:ext>
              </a:extLst>
            </p:cNvPr>
            <p:cNvGrpSpPr/>
            <p:nvPr/>
          </p:nvGrpSpPr>
          <p:grpSpPr>
            <a:xfrm>
              <a:off x="2097816" y="2229962"/>
              <a:ext cx="1667466" cy="242988"/>
              <a:chOff x="2097816" y="2197931"/>
              <a:chExt cx="1667466" cy="242988"/>
            </a:xfrm>
          </p:grpSpPr>
          <p:sp>
            <p:nvSpPr>
              <p:cNvPr id="10" name="Forme libre : forme 9">
                <a:extLst>
                  <a:ext uri="{FF2B5EF4-FFF2-40B4-BE49-F238E27FC236}">
                    <a16:creationId xmlns:a16="http://schemas.microsoft.com/office/drawing/2014/main" id="{8B42285A-4903-4BBD-500B-8854DA5DD223}"/>
                  </a:ext>
                </a:extLst>
              </p:cNvPr>
              <p:cNvSpPr/>
              <p:nvPr/>
            </p:nvSpPr>
            <p:spPr>
              <a:xfrm flipV="1">
                <a:off x="2097816" y="2248172"/>
                <a:ext cx="472711" cy="7518"/>
              </a:xfrm>
              <a:custGeom>
                <a:avLst/>
                <a:gdLst>
                  <a:gd name="connsiteX0" fmla="*/ 0 w 746912"/>
                  <a:gd name="connsiteY0" fmla="*/ 0 h 12700"/>
                  <a:gd name="connsiteX1" fmla="*/ 746912 w 74691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46912" h="12700">
                    <a:moveTo>
                      <a:pt x="0" y="0"/>
                    </a:moveTo>
                    <a:lnTo>
                      <a:pt x="746912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1" name="Forme libre : forme 10">
                <a:extLst>
                  <a:ext uri="{FF2B5EF4-FFF2-40B4-BE49-F238E27FC236}">
                    <a16:creationId xmlns:a16="http://schemas.microsoft.com/office/drawing/2014/main" id="{AC1769C0-A30A-1E9B-7EA9-955BCFC6EE8A}"/>
                  </a:ext>
                </a:extLst>
              </p:cNvPr>
              <p:cNvSpPr/>
              <p:nvPr/>
            </p:nvSpPr>
            <p:spPr>
              <a:xfrm flipV="1">
                <a:off x="3368672" y="2383160"/>
                <a:ext cx="396610" cy="7518"/>
              </a:xfrm>
              <a:custGeom>
                <a:avLst/>
                <a:gdLst>
                  <a:gd name="connsiteX0" fmla="*/ 0 w 626668"/>
                  <a:gd name="connsiteY0" fmla="*/ 0 h 12700"/>
                  <a:gd name="connsiteX1" fmla="*/ 626669 w 626668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26668" h="12700">
                    <a:moveTo>
                      <a:pt x="0" y="0"/>
                    </a:moveTo>
                    <a:lnTo>
                      <a:pt x="626669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8" name="Forme libre : forme 17">
                <a:extLst>
                  <a:ext uri="{FF2B5EF4-FFF2-40B4-BE49-F238E27FC236}">
                    <a16:creationId xmlns:a16="http://schemas.microsoft.com/office/drawing/2014/main" id="{B39AE98E-34D4-C6DB-F45E-DFA3E7E09781}"/>
                  </a:ext>
                </a:extLst>
              </p:cNvPr>
              <p:cNvSpPr/>
              <p:nvPr/>
            </p:nvSpPr>
            <p:spPr>
              <a:xfrm flipV="1">
                <a:off x="2280171" y="2197931"/>
                <a:ext cx="108000" cy="108000"/>
              </a:xfrm>
              <a:custGeom>
                <a:avLst/>
                <a:gdLst>
                  <a:gd name="connsiteX0" fmla="*/ 72187 w 72186"/>
                  <a:gd name="connsiteY0" fmla="*/ 36090 h 72180"/>
                  <a:gd name="connsiteX1" fmla="*/ 0 w 72186"/>
                  <a:gd name="connsiteY1" fmla="*/ 36090 h 72180"/>
                  <a:gd name="connsiteX2" fmla="*/ 72187 w 72186"/>
                  <a:gd name="connsiteY2" fmla="*/ 36090 h 72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186" h="72180">
                    <a:moveTo>
                      <a:pt x="72187" y="36090"/>
                    </a:moveTo>
                    <a:cubicBezTo>
                      <a:pt x="72187" y="84211"/>
                      <a:pt x="0" y="84211"/>
                      <a:pt x="0" y="36090"/>
                    </a:cubicBezTo>
                    <a:cubicBezTo>
                      <a:pt x="0" y="-12030"/>
                      <a:pt x="72187" y="-12030"/>
                      <a:pt x="72187" y="36090"/>
                    </a:cubicBezTo>
                  </a:path>
                </a:pathLst>
              </a:custGeom>
              <a:solidFill>
                <a:schemeClr val="bg1"/>
              </a:solidFill>
              <a:ln w="3175" cap="rnd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9" name="Forme libre : forme 18">
                <a:extLst>
                  <a:ext uri="{FF2B5EF4-FFF2-40B4-BE49-F238E27FC236}">
                    <a16:creationId xmlns:a16="http://schemas.microsoft.com/office/drawing/2014/main" id="{316557E9-49B0-1568-ABA2-1C6A55BDD7DE}"/>
                  </a:ext>
                </a:extLst>
              </p:cNvPr>
              <p:cNvSpPr/>
              <p:nvPr/>
            </p:nvSpPr>
            <p:spPr>
              <a:xfrm flipV="1">
                <a:off x="3512977" y="2332919"/>
                <a:ext cx="108000" cy="108000"/>
              </a:xfrm>
              <a:custGeom>
                <a:avLst/>
                <a:gdLst>
                  <a:gd name="connsiteX0" fmla="*/ 72187 w 72186"/>
                  <a:gd name="connsiteY0" fmla="*/ 36090 h 72180"/>
                  <a:gd name="connsiteX1" fmla="*/ 0 w 72186"/>
                  <a:gd name="connsiteY1" fmla="*/ 36090 h 72180"/>
                  <a:gd name="connsiteX2" fmla="*/ 72187 w 72186"/>
                  <a:gd name="connsiteY2" fmla="*/ 36090 h 72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186" h="72180">
                    <a:moveTo>
                      <a:pt x="72187" y="36090"/>
                    </a:moveTo>
                    <a:cubicBezTo>
                      <a:pt x="72187" y="84211"/>
                      <a:pt x="0" y="84211"/>
                      <a:pt x="0" y="36090"/>
                    </a:cubicBezTo>
                    <a:cubicBezTo>
                      <a:pt x="0" y="-12030"/>
                      <a:pt x="72187" y="-12030"/>
                      <a:pt x="72187" y="36090"/>
                    </a:cubicBezTo>
                  </a:path>
                </a:pathLst>
              </a:custGeom>
              <a:solidFill>
                <a:schemeClr val="tx1">
                  <a:lumMod val="75000"/>
                  <a:lumOff val="25000"/>
                </a:schemeClr>
              </a:solidFill>
              <a:ln w="3175" cap="rnd">
                <a:solidFill>
                  <a:schemeClr val="tx1">
                    <a:lumMod val="75000"/>
                    <a:lumOff val="25000"/>
                  </a:schemeClr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grpSp>
          <p:nvGrpSpPr>
            <p:cNvPr id="56" name="Groupe 55">
              <a:extLst>
                <a:ext uri="{FF2B5EF4-FFF2-40B4-BE49-F238E27FC236}">
                  <a16:creationId xmlns:a16="http://schemas.microsoft.com/office/drawing/2014/main" id="{7C3AC630-BDD2-4409-87F9-44693E2E2F43}"/>
                </a:ext>
              </a:extLst>
            </p:cNvPr>
            <p:cNvGrpSpPr/>
            <p:nvPr/>
          </p:nvGrpSpPr>
          <p:grpSpPr>
            <a:xfrm>
              <a:off x="584665" y="2212957"/>
              <a:ext cx="400765" cy="276999"/>
              <a:chOff x="591015" y="2237725"/>
              <a:chExt cx="400765" cy="276999"/>
            </a:xfrm>
          </p:grpSpPr>
          <p:sp>
            <p:nvSpPr>
              <p:cNvPr id="206" name="Forme libre : forme 205">
                <a:extLst>
                  <a:ext uri="{FF2B5EF4-FFF2-40B4-BE49-F238E27FC236}">
                    <a16:creationId xmlns:a16="http://schemas.microsoft.com/office/drawing/2014/main" id="{7DD2F22E-6E11-0C57-1669-A1B79B36857B}"/>
                  </a:ext>
                </a:extLst>
              </p:cNvPr>
              <p:cNvSpPr/>
              <p:nvPr/>
            </p:nvSpPr>
            <p:spPr>
              <a:xfrm>
                <a:off x="937780" y="2372465"/>
                <a:ext cx="54000" cy="7518"/>
              </a:xfrm>
              <a:custGeom>
                <a:avLst/>
                <a:gdLst>
                  <a:gd name="connsiteX0" fmla="*/ 0 w 34772"/>
                  <a:gd name="connsiteY0" fmla="*/ 0 h 12700"/>
                  <a:gd name="connsiteX1" fmla="*/ 34773 w 3477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772" h="12700">
                    <a:moveTo>
                      <a:pt x="0" y="0"/>
                    </a:moveTo>
                    <a:lnTo>
                      <a:pt x="34773" y="0"/>
                    </a:lnTo>
                  </a:path>
                </a:pathLst>
              </a:custGeom>
              <a:noFill/>
              <a:ln w="3175" cap="flat">
                <a:solidFill>
                  <a:srgbClr val="333333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81" name="ZoneTexte 280">
                <a:extLst>
                  <a:ext uri="{FF2B5EF4-FFF2-40B4-BE49-F238E27FC236}">
                    <a16:creationId xmlns:a16="http://schemas.microsoft.com/office/drawing/2014/main" id="{1575A931-ABC8-E534-3886-DEEF2F57131F}"/>
                  </a:ext>
                </a:extLst>
              </p:cNvPr>
              <p:cNvSpPr txBox="1"/>
              <p:nvPr/>
            </p:nvSpPr>
            <p:spPr>
              <a:xfrm>
                <a:off x="591015" y="2237725"/>
                <a:ext cx="3911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200" dirty="0"/>
                  <a:t>IBV</a:t>
                </a:r>
              </a:p>
            </p:txBody>
          </p:sp>
        </p:grpSp>
        <p:grpSp>
          <p:nvGrpSpPr>
            <p:cNvPr id="42" name="Groupe 41">
              <a:extLst>
                <a:ext uri="{FF2B5EF4-FFF2-40B4-BE49-F238E27FC236}">
                  <a16:creationId xmlns:a16="http://schemas.microsoft.com/office/drawing/2014/main" id="{F09BAEEF-1095-4136-B051-38E72FD53B6D}"/>
                </a:ext>
              </a:extLst>
            </p:cNvPr>
            <p:cNvGrpSpPr/>
            <p:nvPr/>
          </p:nvGrpSpPr>
          <p:grpSpPr>
            <a:xfrm>
              <a:off x="4526321" y="2151183"/>
              <a:ext cx="547631" cy="400546"/>
              <a:chOff x="4606541" y="3507984"/>
              <a:chExt cx="547630" cy="400546"/>
            </a:xfrm>
          </p:grpSpPr>
          <p:grpSp>
            <p:nvGrpSpPr>
              <p:cNvPr id="35" name="Groupe 34">
                <a:extLst>
                  <a:ext uri="{FF2B5EF4-FFF2-40B4-BE49-F238E27FC236}">
                    <a16:creationId xmlns:a16="http://schemas.microsoft.com/office/drawing/2014/main" id="{067798A8-A77D-4BAE-B1F5-A46CDCBA4CB3}"/>
                  </a:ext>
                </a:extLst>
              </p:cNvPr>
              <p:cNvGrpSpPr/>
              <p:nvPr/>
            </p:nvGrpSpPr>
            <p:grpSpPr>
              <a:xfrm>
                <a:off x="4606541" y="3507984"/>
                <a:ext cx="64097" cy="400546"/>
                <a:chOff x="4601778" y="3507984"/>
                <a:chExt cx="64097" cy="400546"/>
              </a:xfrm>
            </p:grpSpPr>
            <p:sp>
              <p:nvSpPr>
                <p:cNvPr id="31" name="Forme libre : forme 30">
                  <a:extLst>
                    <a:ext uri="{FF2B5EF4-FFF2-40B4-BE49-F238E27FC236}">
                      <a16:creationId xmlns:a16="http://schemas.microsoft.com/office/drawing/2014/main" id="{50B34CE5-6823-6BC9-B02D-9BD690929260}"/>
                    </a:ext>
                  </a:extLst>
                </p:cNvPr>
                <p:cNvSpPr/>
                <p:nvPr/>
              </p:nvSpPr>
              <p:spPr>
                <a:xfrm>
                  <a:off x="4601778" y="3895830"/>
                  <a:ext cx="51396" cy="12700"/>
                </a:xfrm>
                <a:custGeom>
                  <a:avLst/>
                  <a:gdLst>
                    <a:gd name="connsiteX0" fmla="*/ 0 w 51396"/>
                    <a:gd name="connsiteY0" fmla="*/ 0 h 12700"/>
                    <a:gd name="connsiteX1" fmla="*/ 51397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0" y="0"/>
                      </a:moveTo>
                      <a:lnTo>
                        <a:pt x="51397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32" name="Forme libre : forme 31">
                  <a:extLst>
                    <a:ext uri="{FF2B5EF4-FFF2-40B4-BE49-F238E27FC236}">
                      <a16:creationId xmlns:a16="http://schemas.microsoft.com/office/drawing/2014/main" id="{C447CB8A-F7FD-1273-B5DD-14A45A74B9D6}"/>
                    </a:ext>
                  </a:extLst>
                </p:cNvPr>
                <p:cNvSpPr/>
                <p:nvPr/>
              </p:nvSpPr>
              <p:spPr>
                <a:xfrm>
                  <a:off x="4653175" y="3507984"/>
                  <a:ext cx="12700" cy="387845"/>
                </a:xfrm>
                <a:custGeom>
                  <a:avLst/>
                  <a:gdLst>
                    <a:gd name="connsiteX0" fmla="*/ 0 w 12700"/>
                    <a:gd name="connsiteY0" fmla="*/ 387845 h 387845"/>
                    <a:gd name="connsiteX1" fmla="*/ 0 w 12700"/>
                    <a:gd name="connsiteY1" fmla="*/ 0 h 3878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00" h="387845">
                      <a:moveTo>
                        <a:pt x="0" y="3878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33" name="Forme libre : forme 32">
                  <a:extLst>
                    <a:ext uri="{FF2B5EF4-FFF2-40B4-BE49-F238E27FC236}">
                      <a16:creationId xmlns:a16="http://schemas.microsoft.com/office/drawing/2014/main" id="{956D1F2D-3F2E-1163-7E63-5D0ACB898E0D}"/>
                    </a:ext>
                  </a:extLst>
                </p:cNvPr>
                <p:cNvSpPr/>
                <p:nvPr/>
              </p:nvSpPr>
              <p:spPr>
                <a:xfrm>
                  <a:off x="4601778" y="3507984"/>
                  <a:ext cx="51396" cy="12700"/>
                </a:xfrm>
                <a:custGeom>
                  <a:avLst/>
                  <a:gdLst>
                    <a:gd name="connsiteX0" fmla="*/ 51397 w 51396"/>
                    <a:gd name="connsiteY0" fmla="*/ 0 h 12700"/>
                    <a:gd name="connsiteX1" fmla="*/ 0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51397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sp>
            <p:nvSpPr>
              <p:cNvPr id="4" name="ZoneTexte 3">
                <a:extLst>
                  <a:ext uri="{FF2B5EF4-FFF2-40B4-BE49-F238E27FC236}">
                    <a16:creationId xmlns:a16="http://schemas.microsoft.com/office/drawing/2014/main" id="{75CC009F-9892-7A7E-E131-2B69B5A9EC14}"/>
                  </a:ext>
                </a:extLst>
              </p:cNvPr>
              <p:cNvSpPr txBox="1"/>
              <p:nvPr/>
            </p:nvSpPr>
            <p:spPr>
              <a:xfrm>
                <a:off x="4660126" y="3582257"/>
                <a:ext cx="4940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i="1" dirty="0"/>
                  <a:t>0.033</a:t>
                </a:r>
              </a:p>
            </p:txBody>
          </p:sp>
        </p:grpSp>
      </p:grpSp>
      <p:grpSp>
        <p:nvGrpSpPr>
          <p:cNvPr id="59" name="Groupe 58">
            <a:extLst>
              <a:ext uri="{FF2B5EF4-FFF2-40B4-BE49-F238E27FC236}">
                <a16:creationId xmlns:a16="http://schemas.microsoft.com/office/drawing/2014/main" id="{BEC4767A-26AF-4EBA-8590-056DF2CEB900}"/>
              </a:ext>
            </a:extLst>
          </p:cNvPr>
          <p:cNvGrpSpPr/>
          <p:nvPr/>
        </p:nvGrpSpPr>
        <p:grpSpPr>
          <a:xfrm>
            <a:off x="583059" y="2854308"/>
            <a:ext cx="4559821" cy="400545"/>
            <a:chOff x="583059" y="2854308"/>
            <a:chExt cx="4559821" cy="400545"/>
          </a:xfrm>
        </p:grpSpPr>
        <p:grpSp>
          <p:nvGrpSpPr>
            <p:cNvPr id="25" name="Groupe 24">
              <a:extLst>
                <a:ext uri="{FF2B5EF4-FFF2-40B4-BE49-F238E27FC236}">
                  <a16:creationId xmlns:a16="http://schemas.microsoft.com/office/drawing/2014/main" id="{1A8CFA13-276A-420F-986A-12D56EF55D20}"/>
                </a:ext>
              </a:extLst>
            </p:cNvPr>
            <p:cNvGrpSpPr/>
            <p:nvPr/>
          </p:nvGrpSpPr>
          <p:grpSpPr>
            <a:xfrm>
              <a:off x="1146388" y="2929911"/>
              <a:ext cx="2458297" cy="249339"/>
              <a:chOff x="1146388" y="2886698"/>
              <a:chExt cx="2458297" cy="249339"/>
            </a:xfrm>
          </p:grpSpPr>
          <p:sp>
            <p:nvSpPr>
              <p:cNvPr id="8" name="Forme libre : forme 7">
                <a:extLst>
                  <a:ext uri="{FF2B5EF4-FFF2-40B4-BE49-F238E27FC236}">
                    <a16:creationId xmlns:a16="http://schemas.microsoft.com/office/drawing/2014/main" id="{20E73449-B91F-77B4-046C-74DC0C00E02B}"/>
                  </a:ext>
                </a:extLst>
              </p:cNvPr>
              <p:cNvSpPr/>
              <p:nvPr/>
            </p:nvSpPr>
            <p:spPr>
              <a:xfrm flipV="1">
                <a:off x="1146388" y="2936939"/>
                <a:ext cx="863511" cy="7518"/>
              </a:xfrm>
              <a:custGeom>
                <a:avLst/>
                <a:gdLst>
                  <a:gd name="connsiteX0" fmla="*/ 0 w 1364399"/>
                  <a:gd name="connsiteY0" fmla="*/ 0 h 12700"/>
                  <a:gd name="connsiteX1" fmla="*/ 1364399 w 1364399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64399" h="12700">
                    <a:moveTo>
                      <a:pt x="0" y="0"/>
                    </a:moveTo>
                    <a:lnTo>
                      <a:pt x="1364399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9" name="Forme libre : forme 8">
                <a:extLst>
                  <a:ext uri="{FF2B5EF4-FFF2-40B4-BE49-F238E27FC236}">
                    <a16:creationId xmlns:a16="http://schemas.microsoft.com/office/drawing/2014/main" id="{F5558BD6-7C87-55A1-6E4B-57575E813C61}"/>
                  </a:ext>
                </a:extLst>
              </p:cNvPr>
              <p:cNvSpPr/>
              <p:nvPr/>
            </p:nvSpPr>
            <p:spPr>
              <a:xfrm flipV="1">
                <a:off x="2584528" y="3078278"/>
                <a:ext cx="1020157" cy="7518"/>
              </a:xfrm>
              <a:custGeom>
                <a:avLst/>
                <a:gdLst>
                  <a:gd name="connsiteX0" fmla="*/ 0 w 1611909"/>
                  <a:gd name="connsiteY0" fmla="*/ 0 h 12700"/>
                  <a:gd name="connsiteX1" fmla="*/ 1611909 w 1611909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11909" h="12700">
                    <a:moveTo>
                      <a:pt x="0" y="0"/>
                    </a:moveTo>
                    <a:lnTo>
                      <a:pt x="1611909" y="0"/>
                    </a:lnTo>
                  </a:path>
                </a:pathLst>
              </a:custGeom>
              <a:noFill/>
              <a:ln w="3175" cap="flat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6" name="Forme libre : forme 15">
                <a:extLst>
                  <a:ext uri="{FF2B5EF4-FFF2-40B4-BE49-F238E27FC236}">
                    <a16:creationId xmlns:a16="http://schemas.microsoft.com/office/drawing/2014/main" id="{FCFE2A78-8BEE-99BE-1664-CA53A09B4CF6}"/>
                  </a:ext>
                </a:extLst>
              </p:cNvPr>
              <p:cNvSpPr/>
              <p:nvPr/>
            </p:nvSpPr>
            <p:spPr>
              <a:xfrm flipV="1">
                <a:off x="1524143" y="2886698"/>
                <a:ext cx="108000" cy="108000"/>
              </a:xfrm>
              <a:custGeom>
                <a:avLst/>
                <a:gdLst>
                  <a:gd name="connsiteX0" fmla="*/ 72225 w 72224"/>
                  <a:gd name="connsiteY0" fmla="*/ 36090 h 72180"/>
                  <a:gd name="connsiteX1" fmla="*/ 0 w 72224"/>
                  <a:gd name="connsiteY1" fmla="*/ 36090 h 72180"/>
                  <a:gd name="connsiteX2" fmla="*/ 72225 w 72224"/>
                  <a:gd name="connsiteY2" fmla="*/ 36090 h 72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224" h="72180">
                    <a:moveTo>
                      <a:pt x="72225" y="36090"/>
                    </a:moveTo>
                    <a:cubicBezTo>
                      <a:pt x="72225" y="84211"/>
                      <a:pt x="0" y="84211"/>
                      <a:pt x="0" y="36090"/>
                    </a:cubicBezTo>
                    <a:cubicBezTo>
                      <a:pt x="0" y="-12030"/>
                      <a:pt x="72225" y="-12030"/>
                      <a:pt x="72225" y="36090"/>
                    </a:cubicBezTo>
                  </a:path>
                </a:pathLst>
              </a:custGeom>
              <a:solidFill>
                <a:schemeClr val="bg1"/>
              </a:solidFill>
              <a:ln w="3175" cap="rnd">
                <a:solidFill>
                  <a:schemeClr val="tx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7" name="Forme libre : forme 16">
                <a:extLst>
                  <a:ext uri="{FF2B5EF4-FFF2-40B4-BE49-F238E27FC236}">
                    <a16:creationId xmlns:a16="http://schemas.microsoft.com/office/drawing/2014/main" id="{7DD92CCE-B7EB-0171-9BB7-F9D35B82C6E7}"/>
                  </a:ext>
                </a:extLst>
              </p:cNvPr>
              <p:cNvSpPr/>
              <p:nvPr/>
            </p:nvSpPr>
            <p:spPr>
              <a:xfrm flipV="1">
                <a:off x="3040606" y="3028037"/>
                <a:ext cx="108000" cy="108000"/>
              </a:xfrm>
              <a:custGeom>
                <a:avLst/>
                <a:gdLst>
                  <a:gd name="connsiteX0" fmla="*/ 72225 w 72225"/>
                  <a:gd name="connsiteY0" fmla="*/ 36090 h 72180"/>
                  <a:gd name="connsiteX1" fmla="*/ 0 w 72225"/>
                  <a:gd name="connsiteY1" fmla="*/ 36090 h 72180"/>
                  <a:gd name="connsiteX2" fmla="*/ 72225 w 72225"/>
                  <a:gd name="connsiteY2" fmla="*/ 36090 h 72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2225" h="72180">
                    <a:moveTo>
                      <a:pt x="72225" y="36090"/>
                    </a:moveTo>
                    <a:cubicBezTo>
                      <a:pt x="72225" y="84211"/>
                      <a:pt x="0" y="84211"/>
                      <a:pt x="0" y="36090"/>
                    </a:cubicBezTo>
                    <a:cubicBezTo>
                      <a:pt x="0" y="-12030"/>
                      <a:pt x="72225" y="-12030"/>
                      <a:pt x="72225" y="36090"/>
                    </a:cubicBezTo>
                  </a:path>
                </a:pathLst>
              </a:custGeom>
              <a:solidFill>
                <a:schemeClr val="tx1">
                  <a:lumMod val="75000"/>
                  <a:lumOff val="25000"/>
                </a:schemeClr>
              </a:solidFill>
              <a:ln w="3175" cap="rnd">
                <a:solidFill>
                  <a:schemeClr val="tx1">
                    <a:lumMod val="75000"/>
                    <a:lumOff val="25000"/>
                  </a:schemeClr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AE3815E0-54E2-42FA-AC45-C3F428AB7428}"/>
                </a:ext>
              </a:extLst>
            </p:cNvPr>
            <p:cNvGrpSpPr/>
            <p:nvPr/>
          </p:nvGrpSpPr>
          <p:grpSpPr>
            <a:xfrm>
              <a:off x="583059" y="2916081"/>
              <a:ext cx="402371" cy="276999"/>
              <a:chOff x="589409" y="2921796"/>
              <a:chExt cx="402371" cy="276999"/>
            </a:xfrm>
          </p:grpSpPr>
          <p:sp>
            <p:nvSpPr>
              <p:cNvPr id="203" name="Forme libre : forme 202">
                <a:extLst>
                  <a:ext uri="{FF2B5EF4-FFF2-40B4-BE49-F238E27FC236}">
                    <a16:creationId xmlns:a16="http://schemas.microsoft.com/office/drawing/2014/main" id="{A52292EC-6253-A29E-B623-12724F643232}"/>
                  </a:ext>
                </a:extLst>
              </p:cNvPr>
              <p:cNvSpPr/>
              <p:nvPr/>
            </p:nvSpPr>
            <p:spPr>
              <a:xfrm>
                <a:off x="937780" y="3056536"/>
                <a:ext cx="54000" cy="7518"/>
              </a:xfrm>
              <a:custGeom>
                <a:avLst/>
                <a:gdLst>
                  <a:gd name="connsiteX0" fmla="*/ 0 w 34772"/>
                  <a:gd name="connsiteY0" fmla="*/ 0 h 12700"/>
                  <a:gd name="connsiteX1" fmla="*/ 34773 w 34772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772" h="12700">
                    <a:moveTo>
                      <a:pt x="0" y="0"/>
                    </a:moveTo>
                    <a:lnTo>
                      <a:pt x="34773" y="0"/>
                    </a:lnTo>
                  </a:path>
                </a:pathLst>
              </a:custGeom>
              <a:noFill/>
              <a:ln w="3175" cap="flat">
                <a:solidFill>
                  <a:srgbClr val="333333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82" name="ZoneTexte 281">
                <a:extLst>
                  <a:ext uri="{FF2B5EF4-FFF2-40B4-BE49-F238E27FC236}">
                    <a16:creationId xmlns:a16="http://schemas.microsoft.com/office/drawing/2014/main" id="{42870783-0F40-9BDA-289A-665326D113C6}"/>
                  </a:ext>
                </a:extLst>
              </p:cNvPr>
              <p:cNvSpPr txBox="1"/>
              <p:nvPr/>
            </p:nvSpPr>
            <p:spPr>
              <a:xfrm>
                <a:off x="589409" y="2921796"/>
                <a:ext cx="3928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IAV</a:t>
                </a:r>
              </a:p>
            </p:txBody>
          </p:sp>
        </p:grpSp>
        <p:grpSp>
          <p:nvGrpSpPr>
            <p:cNvPr id="43" name="Groupe 42">
              <a:extLst>
                <a:ext uri="{FF2B5EF4-FFF2-40B4-BE49-F238E27FC236}">
                  <a16:creationId xmlns:a16="http://schemas.microsoft.com/office/drawing/2014/main" id="{E643CF50-C07F-4D4B-8CEE-278162B0B658}"/>
                </a:ext>
              </a:extLst>
            </p:cNvPr>
            <p:cNvGrpSpPr/>
            <p:nvPr/>
          </p:nvGrpSpPr>
          <p:grpSpPr>
            <a:xfrm>
              <a:off x="4526320" y="2854308"/>
              <a:ext cx="616560" cy="400545"/>
              <a:chOff x="4606541" y="4671571"/>
              <a:chExt cx="616559" cy="400545"/>
            </a:xfrm>
          </p:grpSpPr>
          <p:grpSp>
            <p:nvGrpSpPr>
              <p:cNvPr id="36" name="Groupe 35">
                <a:extLst>
                  <a:ext uri="{FF2B5EF4-FFF2-40B4-BE49-F238E27FC236}">
                    <a16:creationId xmlns:a16="http://schemas.microsoft.com/office/drawing/2014/main" id="{F6DFDA24-2686-40AF-8C27-AE942817FE09}"/>
                  </a:ext>
                </a:extLst>
              </p:cNvPr>
              <p:cNvGrpSpPr/>
              <p:nvPr/>
            </p:nvGrpSpPr>
            <p:grpSpPr>
              <a:xfrm>
                <a:off x="4606541" y="4671571"/>
                <a:ext cx="64097" cy="400545"/>
                <a:chOff x="4601778" y="4671571"/>
                <a:chExt cx="64097" cy="400545"/>
              </a:xfrm>
            </p:grpSpPr>
            <p:sp>
              <p:nvSpPr>
                <p:cNvPr id="27" name="Forme libre : forme 26">
                  <a:extLst>
                    <a:ext uri="{FF2B5EF4-FFF2-40B4-BE49-F238E27FC236}">
                      <a16:creationId xmlns:a16="http://schemas.microsoft.com/office/drawing/2014/main" id="{20D94114-0537-F5A0-8444-3B53E085A5CF}"/>
                    </a:ext>
                  </a:extLst>
                </p:cNvPr>
                <p:cNvSpPr/>
                <p:nvPr/>
              </p:nvSpPr>
              <p:spPr>
                <a:xfrm>
                  <a:off x="4601778" y="5059416"/>
                  <a:ext cx="51396" cy="12700"/>
                </a:xfrm>
                <a:custGeom>
                  <a:avLst/>
                  <a:gdLst>
                    <a:gd name="connsiteX0" fmla="*/ 0 w 51396"/>
                    <a:gd name="connsiteY0" fmla="*/ 0 h 12700"/>
                    <a:gd name="connsiteX1" fmla="*/ 51397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0" y="0"/>
                      </a:moveTo>
                      <a:lnTo>
                        <a:pt x="51397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28" name="Forme libre : forme 27">
                  <a:extLst>
                    <a:ext uri="{FF2B5EF4-FFF2-40B4-BE49-F238E27FC236}">
                      <a16:creationId xmlns:a16="http://schemas.microsoft.com/office/drawing/2014/main" id="{630CAB50-6E4D-E657-370E-26464914F754}"/>
                    </a:ext>
                  </a:extLst>
                </p:cNvPr>
                <p:cNvSpPr/>
                <p:nvPr/>
              </p:nvSpPr>
              <p:spPr>
                <a:xfrm>
                  <a:off x="4653175" y="4671571"/>
                  <a:ext cx="12700" cy="387845"/>
                </a:xfrm>
                <a:custGeom>
                  <a:avLst/>
                  <a:gdLst>
                    <a:gd name="connsiteX0" fmla="*/ 0 w 12700"/>
                    <a:gd name="connsiteY0" fmla="*/ 387845 h 387845"/>
                    <a:gd name="connsiteX1" fmla="*/ 0 w 12700"/>
                    <a:gd name="connsiteY1" fmla="*/ 0 h 3878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00" h="387845">
                      <a:moveTo>
                        <a:pt x="0" y="3878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29" name="Forme libre : forme 28">
                  <a:extLst>
                    <a:ext uri="{FF2B5EF4-FFF2-40B4-BE49-F238E27FC236}">
                      <a16:creationId xmlns:a16="http://schemas.microsoft.com/office/drawing/2014/main" id="{7CD3F369-2E6A-B475-2DD6-1C474416ECC3}"/>
                    </a:ext>
                  </a:extLst>
                </p:cNvPr>
                <p:cNvSpPr/>
                <p:nvPr/>
              </p:nvSpPr>
              <p:spPr>
                <a:xfrm>
                  <a:off x="4601778" y="4671571"/>
                  <a:ext cx="51396" cy="12700"/>
                </a:xfrm>
                <a:custGeom>
                  <a:avLst/>
                  <a:gdLst>
                    <a:gd name="connsiteX0" fmla="*/ 51397 w 51396"/>
                    <a:gd name="connsiteY0" fmla="*/ 0 h 12700"/>
                    <a:gd name="connsiteX1" fmla="*/ 0 w 51396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1396" h="12700">
                      <a:moveTo>
                        <a:pt x="51397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8130" cap="rnd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42474194-5220-D193-93F9-03C84AA2CF11}"/>
                  </a:ext>
                </a:extLst>
              </p:cNvPr>
              <p:cNvSpPr txBox="1"/>
              <p:nvPr/>
            </p:nvSpPr>
            <p:spPr>
              <a:xfrm>
                <a:off x="4660126" y="4734688"/>
                <a:ext cx="56297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i="1" dirty="0"/>
                  <a:t>0.0018</a:t>
                </a:r>
              </a:p>
            </p:txBody>
          </p:sp>
        </p:grpSp>
      </p:grpSp>
      <p:sp>
        <p:nvSpPr>
          <p:cNvPr id="73" name="ZoneTexte 72">
            <a:extLst>
              <a:ext uri="{FF2B5EF4-FFF2-40B4-BE49-F238E27FC236}">
                <a16:creationId xmlns:a16="http://schemas.microsoft.com/office/drawing/2014/main" id="{807822E5-E75A-40A3-A832-097173AA200E}"/>
              </a:ext>
            </a:extLst>
          </p:cNvPr>
          <p:cNvSpPr txBox="1"/>
          <p:nvPr/>
        </p:nvSpPr>
        <p:spPr>
          <a:xfrm>
            <a:off x="265353" y="428681"/>
            <a:ext cx="320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.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32207915-681B-469D-A6B7-C723D7FB821D}"/>
              </a:ext>
            </a:extLst>
          </p:cNvPr>
          <p:cNvSpPr txBox="1"/>
          <p:nvPr/>
        </p:nvSpPr>
        <p:spPr>
          <a:xfrm>
            <a:off x="6761402" y="428683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b.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542FCA42-ED73-4A3A-99B7-D2763638434B}"/>
              </a:ext>
            </a:extLst>
          </p:cNvPr>
          <p:cNvSpPr txBox="1"/>
          <p:nvPr/>
        </p:nvSpPr>
        <p:spPr>
          <a:xfrm>
            <a:off x="8190567" y="3536806"/>
            <a:ext cx="2164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Nasal viral </a:t>
            </a:r>
            <a:r>
              <a:rPr lang="fr-FR" sz="1200" dirty="0" err="1"/>
              <a:t>load</a:t>
            </a:r>
            <a:r>
              <a:rPr lang="fr-FR" sz="1200" dirty="0"/>
              <a:t> (log</a:t>
            </a:r>
            <a:r>
              <a:rPr lang="fr-FR" sz="1200" baseline="-25000" dirty="0"/>
              <a:t>10</a:t>
            </a:r>
            <a:r>
              <a:rPr lang="fr-FR" sz="1200" dirty="0"/>
              <a:t>/10</a:t>
            </a:r>
            <a:r>
              <a:rPr lang="fr-FR" sz="1200" baseline="30000" dirty="0"/>
              <a:t>6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r>
              <a:rPr lang="fr-FR" sz="1200" dirty="0"/>
              <a:t>) 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D9EF69C3-DBD0-4FC6-AAC2-1BF1378CB38D}"/>
              </a:ext>
            </a:extLst>
          </p:cNvPr>
          <p:cNvSpPr txBox="1"/>
          <p:nvPr/>
        </p:nvSpPr>
        <p:spPr>
          <a:xfrm>
            <a:off x="6550292" y="899192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SARS-CoV-2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FA4A3D6E-ADDC-4C4B-B62F-3A2A6A488203}"/>
              </a:ext>
            </a:extLst>
          </p:cNvPr>
          <p:cNvSpPr txBox="1"/>
          <p:nvPr/>
        </p:nvSpPr>
        <p:spPr>
          <a:xfrm>
            <a:off x="7045491" y="1569696"/>
            <a:ext cx="4220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RSV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14BDD3A8-0246-4CD6-B10E-BD65C796A5BA}"/>
              </a:ext>
            </a:extLst>
          </p:cNvPr>
          <p:cNvSpPr txBox="1"/>
          <p:nvPr/>
        </p:nvSpPr>
        <p:spPr>
          <a:xfrm>
            <a:off x="7076335" y="2246647"/>
            <a:ext cx="39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IBV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89A02F7E-40EC-469C-964F-E59E53D0C6AF}"/>
              </a:ext>
            </a:extLst>
          </p:cNvPr>
          <p:cNvSpPr txBox="1"/>
          <p:nvPr/>
        </p:nvSpPr>
        <p:spPr>
          <a:xfrm>
            <a:off x="7074731" y="2923758"/>
            <a:ext cx="392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IAV</a:t>
            </a:r>
          </a:p>
        </p:txBody>
      </p:sp>
      <p:graphicFrame>
        <p:nvGraphicFramePr>
          <p:cNvPr id="76" name="Objet 75">
            <a:extLst>
              <a:ext uri="{FF2B5EF4-FFF2-40B4-BE49-F238E27FC236}">
                <a16:creationId xmlns:a16="http://schemas.microsoft.com/office/drawing/2014/main" id="{F994F897-7CB4-4142-BA4A-DE08FEE2D1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4101358"/>
              </p:ext>
            </p:extLst>
          </p:nvPr>
        </p:nvGraphicFramePr>
        <p:xfrm>
          <a:off x="7375525" y="622300"/>
          <a:ext cx="3771900" cy="2860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785386" imgH="2547730" progId="Prism8.Document">
                  <p:embed/>
                </p:oleObj>
              </mc:Choice>
              <mc:Fallback>
                <p:oleObj name="Prism 8" r:id="rId2" imgW="3785386" imgH="2547730" progId="Prism8.Document">
                  <p:embed/>
                  <p:pic>
                    <p:nvPicPr>
                      <p:cNvPr id="76" name="Objet 75">
                        <a:extLst>
                          <a:ext uri="{FF2B5EF4-FFF2-40B4-BE49-F238E27FC236}">
                            <a16:creationId xmlns:a16="http://schemas.microsoft.com/office/drawing/2014/main" id="{F994F897-7CB4-4142-BA4A-DE08FEE2D1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375525" y="622300"/>
                        <a:ext cx="3771900" cy="2860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12B61700-E02D-4A58-8001-4B3A302817FA}"/>
              </a:ext>
            </a:extLst>
          </p:cNvPr>
          <p:cNvCxnSpPr/>
          <p:nvPr/>
        </p:nvCxnSpPr>
        <p:spPr>
          <a:xfrm>
            <a:off x="7422992" y="1034713"/>
            <a:ext cx="45105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Connecteur droit 108">
            <a:extLst>
              <a:ext uri="{FF2B5EF4-FFF2-40B4-BE49-F238E27FC236}">
                <a16:creationId xmlns:a16="http://schemas.microsoft.com/office/drawing/2014/main" id="{562F3E3C-0E9C-4D82-B864-DA8C0056417D}"/>
              </a:ext>
            </a:extLst>
          </p:cNvPr>
          <p:cNvCxnSpPr/>
          <p:nvPr/>
        </p:nvCxnSpPr>
        <p:spPr>
          <a:xfrm>
            <a:off x="7422992" y="1708191"/>
            <a:ext cx="45105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Connecteur droit 109">
            <a:extLst>
              <a:ext uri="{FF2B5EF4-FFF2-40B4-BE49-F238E27FC236}">
                <a16:creationId xmlns:a16="http://schemas.microsoft.com/office/drawing/2014/main" id="{C26F71D9-4C31-48E1-9729-2C48A2DF95D3}"/>
              </a:ext>
            </a:extLst>
          </p:cNvPr>
          <p:cNvCxnSpPr/>
          <p:nvPr/>
        </p:nvCxnSpPr>
        <p:spPr>
          <a:xfrm>
            <a:off x="7422992" y="2377406"/>
            <a:ext cx="45105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BEDFC21F-A313-49C9-ACE9-74F20055279D}"/>
              </a:ext>
            </a:extLst>
          </p:cNvPr>
          <p:cNvCxnSpPr/>
          <p:nvPr/>
        </p:nvCxnSpPr>
        <p:spPr>
          <a:xfrm>
            <a:off x="7422992" y="3062253"/>
            <a:ext cx="45105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13" name="Groupe 112">
            <a:extLst>
              <a:ext uri="{FF2B5EF4-FFF2-40B4-BE49-F238E27FC236}">
                <a16:creationId xmlns:a16="http://schemas.microsoft.com/office/drawing/2014/main" id="{4E43AA34-6D3A-4D74-A8FB-EACCE56F4598}"/>
              </a:ext>
            </a:extLst>
          </p:cNvPr>
          <p:cNvGrpSpPr/>
          <p:nvPr/>
        </p:nvGrpSpPr>
        <p:grpSpPr>
          <a:xfrm>
            <a:off x="11123595" y="834444"/>
            <a:ext cx="683886" cy="400547"/>
            <a:chOff x="4606541" y="1180807"/>
            <a:chExt cx="683886" cy="400547"/>
          </a:xfrm>
        </p:grpSpPr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253FCEFE-9C02-4B44-8065-0DE6846BB879}"/>
                </a:ext>
              </a:extLst>
            </p:cNvPr>
            <p:cNvGrpSpPr/>
            <p:nvPr/>
          </p:nvGrpSpPr>
          <p:grpSpPr>
            <a:xfrm>
              <a:off x="4606541" y="1180807"/>
              <a:ext cx="64097" cy="400547"/>
              <a:chOff x="4601778" y="1180807"/>
              <a:chExt cx="64097" cy="400547"/>
            </a:xfrm>
          </p:grpSpPr>
          <p:sp>
            <p:nvSpPr>
              <p:cNvPr id="116" name="Forme libre : forme 115">
                <a:extLst>
                  <a:ext uri="{FF2B5EF4-FFF2-40B4-BE49-F238E27FC236}">
                    <a16:creationId xmlns:a16="http://schemas.microsoft.com/office/drawing/2014/main" id="{B919F1E5-E194-4824-AD7A-8BDD9556B632}"/>
                  </a:ext>
                </a:extLst>
              </p:cNvPr>
              <p:cNvSpPr/>
              <p:nvPr/>
            </p:nvSpPr>
            <p:spPr>
              <a:xfrm>
                <a:off x="4601778" y="1568654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17" name="Forme libre : forme 116">
                <a:extLst>
                  <a:ext uri="{FF2B5EF4-FFF2-40B4-BE49-F238E27FC236}">
                    <a16:creationId xmlns:a16="http://schemas.microsoft.com/office/drawing/2014/main" id="{2DCB22FC-C696-49AB-AB2C-25C956F19D19}"/>
                  </a:ext>
                </a:extLst>
              </p:cNvPr>
              <p:cNvSpPr/>
              <p:nvPr/>
            </p:nvSpPr>
            <p:spPr>
              <a:xfrm>
                <a:off x="4653175" y="1180807"/>
                <a:ext cx="12700" cy="387846"/>
              </a:xfrm>
              <a:custGeom>
                <a:avLst/>
                <a:gdLst>
                  <a:gd name="connsiteX0" fmla="*/ 0 w 12700"/>
                  <a:gd name="connsiteY0" fmla="*/ 387847 h 387846"/>
                  <a:gd name="connsiteX1" fmla="*/ 0 w 12700"/>
                  <a:gd name="connsiteY1" fmla="*/ 0 h 387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6">
                    <a:moveTo>
                      <a:pt x="0" y="387847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18" name="Forme libre : forme 117">
                <a:extLst>
                  <a:ext uri="{FF2B5EF4-FFF2-40B4-BE49-F238E27FC236}">
                    <a16:creationId xmlns:a16="http://schemas.microsoft.com/office/drawing/2014/main" id="{0A14722A-9FF1-491D-8D60-58B12AA907AF}"/>
                  </a:ext>
                </a:extLst>
              </p:cNvPr>
              <p:cNvSpPr/>
              <p:nvPr/>
            </p:nvSpPr>
            <p:spPr>
              <a:xfrm>
                <a:off x="4601778" y="1180807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35B7D5CD-65FE-41B0-AE17-C70CDB1F0679}"/>
                </a:ext>
              </a:extLst>
            </p:cNvPr>
            <p:cNvSpPr txBox="1"/>
            <p:nvPr/>
          </p:nvSpPr>
          <p:spPr>
            <a:xfrm>
              <a:off x="4660126" y="125508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119" name="Groupe 118">
            <a:extLst>
              <a:ext uri="{FF2B5EF4-FFF2-40B4-BE49-F238E27FC236}">
                <a16:creationId xmlns:a16="http://schemas.microsoft.com/office/drawing/2014/main" id="{4CC02175-4996-4B2F-8F57-827B74B976C1}"/>
              </a:ext>
            </a:extLst>
          </p:cNvPr>
          <p:cNvGrpSpPr/>
          <p:nvPr/>
        </p:nvGrpSpPr>
        <p:grpSpPr>
          <a:xfrm>
            <a:off x="11122962" y="1507921"/>
            <a:ext cx="683886" cy="400547"/>
            <a:chOff x="4606541" y="1180807"/>
            <a:chExt cx="683886" cy="400547"/>
          </a:xfrm>
        </p:grpSpPr>
        <p:grpSp>
          <p:nvGrpSpPr>
            <p:cNvPr id="120" name="Groupe 119">
              <a:extLst>
                <a:ext uri="{FF2B5EF4-FFF2-40B4-BE49-F238E27FC236}">
                  <a16:creationId xmlns:a16="http://schemas.microsoft.com/office/drawing/2014/main" id="{1848FE06-C78E-4341-A3FE-7434DEC78F68}"/>
                </a:ext>
              </a:extLst>
            </p:cNvPr>
            <p:cNvGrpSpPr/>
            <p:nvPr/>
          </p:nvGrpSpPr>
          <p:grpSpPr>
            <a:xfrm>
              <a:off x="4606541" y="1180807"/>
              <a:ext cx="64097" cy="400547"/>
              <a:chOff x="4601778" y="1180807"/>
              <a:chExt cx="64097" cy="400547"/>
            </a:xfrm>
          </p:grpSpPr>
          <p:sp>
            <p:nvSpPr>
              <p:cNvPr id="122" name="Forme libre : forme 121">
                <a:extLst>
                  <a:ext uri="{FF2B5EF4-FFF2-40B4-BE49-F238E27FC236}">
                    <a16:creationId xmlns:a16="http://schemas.microsoft.com/office/drawing/2014/main" id="{D3F0C04E-0C4A-42BD-8972-B8E4053FFF58}"/>
                  </a:ext>
                </a:extLst>
              </p:cNvPr>
              <p:cNvSpPr/>
              <p:nvPr/>
            </p:nvSpPr>
            <p:spPr>
              <a:xfrm>
                <a:off x="4601778" y="1568654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23" name="Forme libre : forme 122">
                <a:extLst>
                  <a:ext uri="{FF2B5EF4-FFF2-40B4-BE49-F238E27FC236}">
                    <a16:creationId xmlns:a16="http://schemas.microsoft.com/office/drawing/2014/main" id="{48B7375C-FB79-491A-B7FC-3EBDA7FE0874}"/>
                  </a:ext>
                </a:extLst>
              </p:cNvPr>
              <p:cNvSpPr/>
              <p:nvPr/>
            </p:nvSpPr>
            <p:spPr>
              <a:xfrm>
                <a:off x="4653175" y="1180807"/>
                <a:ext cx="12700" cy="387846"/>
              </a:xfrm>
              <a:custGeom>
                <a:avLst/>
                <a:gdLst>
                  <a:gd name="connsiteX0" fmla="*/ 0 w 12700"/>
                  <a:gd name="connsiteY0" fmla="*/ 387847 h 387846"/>
                  <a:gd name="connsiteX1" fmla="*/ 0 w 12700"/>
                  <a:gd name="connsiteY1" fmla="*/ 0 h 387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6">
                    <a:moveTo>
                      <a:pt x="0" y="387847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24" name="Forme libre : forme 123">
                <a:extLst>
                  <a:ext uri="{FF2B5EF4-FFF2-40B4-BE49-F238E27FC236}">
                    <a16:creationId xmlns:a16="http://schemas.microsoft.com/office/drawing/2014/main" id="{9A9F9442-7C9D-4573-83A6-E086D7DC655C}"/>
                  </a:ext>
                </a:extLst>
              </p:cNvPr>
              <p:cNvSpPr/>
              <p:nvPr/>
            </p:nvSpPr>
            <p:spPr>
              <a:xfrm>
                <a:off x="4601778" y="1180807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70BDEEEC-9366-4F7E-8DF6-A7B6D723E573}"/>
                </a:ext>
              </a:extLst>
            </p:cNvPr>
            <p:cNvSpPr txBox="1"/>
            <p:nvPr/>
          </p:nvSpPr>
          <p:spPr>
            <a:xfrm>
              <a:off x="4660126" y="125508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125" name="Groupe 124">
            <a:extLst>
              <a:ext uri="{FF2B5EF4-FFF2-40B4-BE49-F238E27FC236}">
                <a16:creationId xmlns:a16="http://schemas.microsoft.com/office/drawing/2014/main" id="{7BCA20D2-E3D7-4E7B-9B74-B30AC0868976}"/>
              </a:ext>
            </a:extLst>
          </p:cNvPr>
          <p:cNvGrpSpPr/>
          <p:nvPr/>
        </p:nvGrpSpPr>
        <p:grpSpPr>
          <a:xfrm>
            <a:off x="11122962" y="2177136"/>
            <a:ext cx="683886" cy="400547"/>
            <a:chOff x="4606541" y="1180807"/>
            <a:chExt cx="683886" cy="400547"/>
          </a:xfrm>
        </p:grpSpPr>
        <p:grpSp>
          <p:nvGrpSpPr>
            <p:cNvPr id="126" name="Groupe 125">
              <a:extLst>
                <a:ext uri="{FF2B5EF4-FFF2-40B4-BE49-F238E27FC236}">
                  <a16:creationId xmlns:a16="http://schemas.microsoft.com/office/drawing/2014/main" id="{1D55B396-2EE3-4C25-8F80-131ABAF8A520}"/>
                </a:ext>
              </a:extLst>
            </p:cNvPr>
            <p:cNvGrpSpPr/>
            <p:nvPr/>
          </p:nvGrpSpPr>
          <p:grpSpPr>
            <a:xfrm>
              <a:off x="4606541" y="1180807"/>
              <a:ext cx="64097" cy="400547"/>
              <a:chOff x="4601778" y="1180807"/>
              <a:chExt cx="64097" cy="400547"/>
            </a:xfrm>
          </p:grpSpPr>
          <p:sp>
            <p:nvSpPr>
              <p:cNvPr id="128" name="Forme libre : forme 127">
                <a:extLst>
                  <a:ext uri="{FF2B5EF4-FFF2-40B4-BE49-F238E27FC236}">
                    <a16:creationId xmlns:a16="http://schemas.microsoft.com/office/drawing/2014/main" id="{ADDD8C2F-91ED-4530-9E3A-DB550B1D1A1B}"/>
                  </a:ext>
                </a:extLst>
              </p:cNvPr>
              <p:cNvSpPr/>
              <p:nvPr/>
            </p:nvSpPr>
            <p:spPr>
              <a:xfrm>
                <a:off x="4601778" y="1568654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29" name="Forme libre : forme 128">
                <a:extLst>
                  <a:ext uri="{FF2B5EF4-FFF2-40B4-BE49-F238E27FC236}">
                    <a16:creationId xmlns:a16="http://schemas.microsoft.com/office/drawing/2014/main" id="{B5C4D290-72AA-4092-8643-19F8D48C9802}"/>
                  </a:ext>
                </a:extLst>
              </p:cNvPr>
              <p:cNvSpPr/>
              <p:nvPr/>
            </p:nvSpPr>
            <p:spPr>
              <a:xfrm>
                <a:off x="4653175" y="1180807"/>
                <a:ext cx="12700" cy="387846"/>
              </a:xfrm>
              <a:custGeom>
                <a:avLst/>
                <a:gdLst>
                  <a:gd name="connsiteX0" fmla="*/ 0 w 12700"/>
                  <a:gd name="connsiteY0" fmla="*/ 387847 h 387846"/>
                  <a:gd name="connsiteX1" fmla="*/ 0 w 12700"/>
                  <a:gd name="connsiteY1" fmla="*/ 0 h 387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6">
                    <a:moveTo>
                      <a:pt x="0" y="387847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30" name="Forme libre : forme 129">
                <a:extLst>
                  <a:ext uri="{FF2B5EF4-FFF2-40B4-BE49-F238E27FC236}">
                    <a16:creationId xmlns:a16="http://schemas.microsoft.com/office/drawing/2014/main" id="{1A0DD283-46BE-4AE7-8E3D-E56609172D49}"/>
                  </a:ext>
                </a:extLst>
              </p:cNvPr>
              <p:cNvSpPr/>
              <p:nvPr/>
            </p:nvSpPr>
            <p:spPr>
              <a:xfrm>
                <a:off x="4601778" y="1180807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27" name="ZoneTexte 126">
              <a:extLst>
                <a:ext uri="{FF2B5EF4-FFF2-40B4-BE49-F238E27FC236}">
                  <a16:creationId xmlns:a16="http://schemas.microsoft.com/office/drawing/2014/main" id="{ABC9DFF2-F778-4006-89D0-88AE23970467}"/>
                </a:ext>
              </a:extLst>
            </p:cNvPr>
            <p:cNvSpPr txBox="1"/>
            <p:nvPr/>
          </p:nvSpPr>
          <p:spPr>
            <a:xfrm>
              <a:off x="4660126" y="125508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131" name="Groupe 130">
            <a:extLst>
              <a:ext uri="{FF2B5EF4-FFF2-40B4-BE49-F238E27FC236}">
                <a16:creationId xmlns:a16="http://schemas.microsoft.com/office/drawing/2014/main" id="{5E486DD7-C7F4-4FD6-B6FA-CAD7CDED4CD1}"/>
              </a:ext>
            </a:extLst>
          </p:cNvPr>
          <p:cNvGrpSpPr/>
          <p:nvPr/>
        </p:nvGrpSpPr>
        <p:grpSpPr>
          <a:xfrm>
            <a:off x="11122962" y="2861983"/>
            <a:ext cx="683886" cy="400547"/>
            <a:chOff x="4606541" y="1180807"/>
            <a:chExt cx="683886" cy="400547"/>
          </a:xfrm>
        </p:grpSpPr>
        <p:grpSp>
          <p:nvGrpSpPr>
            <p:cNvPr id="132" name="Groupe 131">
              <a:extLst>
                <a:ext uri="{FF2B5EF4-FFF2-40B4-BE49-F238E27FC236}">
                  <a16:creationId xmlns:a16="http://schemas.microsoft.com/office/drawing/2014/main" id="{474A0F45-41A4-4C61-ABEF-72EFA90C3A4C}"/>
                </a:ext>
              </a:extLst>
            </p:cNvPr>
            <p:cNvGrpSpPr/>
            <p:nvPr/>
          </p:nvGrpSpPr>
          <p:grpSpPr>
            <a:xfrm>
              <a:off x="4606541" y="1180807"/>
              <a:ext cx="64097" cy="400547"/>
              <a:chOff x="4601778" y="1180807"/>
              <a:chExt cx="64097" cy="400547"/>
            </a:xfrm>
          </p:grpSpPr>
          <p:sp>
            <p:nvSpPr>
              <p:cNvPr id="134" name="Forme libre : forme 133">
                <a:extLst>
                  <a:ext uri="{FF2B5EF4-FFF2-40B4-BE49-F238E27FC236}">
                    <a16:creationId xmlns:a16="http://schemas.microsoft.com/office/drawing/2014/main" id="{33E56BB8-D690-4697-B1F9-170A2FE15CEE}"/>
                  </a:ext>
                </a:extLst>
              </p:cNvPr>
              <p:cNvSpPr/>
              <p:nvPr/>
            </p:nvSpPr>
            <p:spPr>
              <a:xfrm>
                <a:off x="4601778" y="1568654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35" name="Forme libre : forme 134">
                <a:extLst>
                  <a:ext uri="{FF2B5EF4-FFF2-40B4-BE49-F238E27FC236}">
                    <a16:creationId xmlns:a16="http://schemas.microsoft.com/office/drawing/2014/main" id="{DEE3341D-D2B3-4E96-A22C-D385950D956A}"/>
                  </a:ext>
                </a:extLst>
              </p:cNvPr>
              <p:cNvSpPr/>
              <p:nvPr/>
            </p:nvSpPr>
            <p:spPr>
              <a:xfrm>
                <a:off x="4653175" y="1180807"/>
                <a:ext cx="12700" cy="387846"/>
              </a:xfrm>
              <a:custGeom>
                <a:avLst/>
                <a:gdLst>
                  <a:gd name="connsiteX0" fmla="*/ 0 w 12700"/>
                  <a:gd name="connsiteY0" fmla="*/ 387847 h 387846"/>
                  <a:gd name="connsiteX1" fmla="*/ 0 w 12700"/>
                  <a:gd name="connsiteY1" fmla="*/ 0 h 387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6">
                    <a:moveTo>
                      <a:pt x="0" y="387847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36" name="Forme libre : forme 135">
                <a:extLst>
                  <a:ext uri="{FF2B5EF4-FFF2-40B4-BE49-F238E27FC236}">
                    <a16:creationId xmlns:a16="http://schemas.microsoft.com/office/drawing/2014/main" id="{1D923AF3-3850-4401-BFD6-4E332AA9D999}"/>
                  </a:ext>
                </a:extLst>
              </p:cNvPr>
              <p:cNvSpPr/>
              <p:nvPr/>
            </p:nvSpPr>
            <p:spPr>
              <a:xfrm>
                <a:off x="4601778" y="1180807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33" name="ZoneTexte 132">
              <a:extLst>
                <a:ext uri="{FF2B5EF4-FFF2-40B4-BE49-F238E27FC236}">
                  <a16:creationId xmlns:a16="http://schemas.microsoft.com/office/drawing/2014/main" id="{9A841BDB-C4E0-4A24-8217-7028AC8DB693}"/>
                </a:ext>
              </a:extLst>
            </p:cNvPr>
            <p:cNvSpPr txBox="1"/>
            <p:nvPr/>
          </p:nvSpPr>
          <p:spPr>
            <a:xfrm>
              <a:off x="4660126" y="125508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sp>
        <p:nvSpPr>
          <p:cNvPr id="137" name="ZoneTexte 136">
            <a:extLst>
              <a:ext uri="{FF2B5EF4-FFF2-40B4-BE49-F238E27FC236}">
                <a16:creationId xmlns:a16="http://schemas.microsoft.com/office/drawing/2014/main" id="{CD5AD4CB-CB06-43BA-ADFD-C6F44D551FAB}"/>
              </a:ext>
            </a:extLst>
          </p:cNvPr>
          <p:cNvSpPr txBox="1"/>
          <p:nvPr/>
        </p:nvSpPr>
        <p:spPr>
          <a:xfrm>
            <a:off x="7271272" y="331548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0</a:t>
            </a:r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3A1C1F08-7C23-46A5-B358-7CCE0E016B85}"/>
              </a:ext>
            </a:extLst>
          </p:cNvPr>
          <p:cNvSpPr txBox="1"/>
          <p:nvPr/>
        </p:nvSpPr>
        <p:spPr>
          <a:xfrm>
            <a:off x="8384522" y="331548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2</a:t>
            </a:r>
            <a:r>
              <a:rPr lang="en-GB" sz="1200" dirty="0"/>
              <a:t>.</a:t>
            </a:r>
            <a:r>
              <a:rPr lang="fr-FR" sz="1200" dirty="0"/>
              <a:t>5</a:t>
            </a:r>
          </a:p>
        </p:txBody>
      </p:sp>
      <p:sp>
        <p:nvSpPr>
          <p:cNvPr id="139" name="ZoneTexte 138">
            <a:extLst>
              <a:ext uri="{FF2B5EF4-FFF2-40B4-BE49-F238E27FC236}">
                <a16:creationId xmlns:a16="http://schemas.microsoft.com/office/drawing/2014/main" id="{F48834C8-9224-4D85-91F5-C587C628B385}"/>
              </a:ext>
            </a:extLst>
          </p:cNvPr>
          <p:cNvSpPr txBox="1"/>
          <p:nvPr/>
        </p:nvSpPr>
        <p:spPr>
          <a:xfrm>
            <a:off x="9507650" y="331548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5</a:t>
            </a:r>
            <a:r>
              <a:rPr lang="en-GB" sz="1200" dirty="0"/>
              <a:t>.</a:t>
            </a:r>
            <a:r>
              <a:rPr lang="fr-FR" sz="1200" dirty="0"/>
              <a:t>0</a:t>
            </a:r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01AC262C-8AA8-4179-B25F-0F5BBBB30F61}"/>
              </a:ext>
            </a:extLst>
          </p:cNvPr>
          <p:cNvSpPr txBox="1"/>
          <p:nvPr/>
        </p:nvSpPr>
        <p:spPr>
          <a:xfrm>
            <a:off x="10627656" y="331548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7</a:t>
            </a:r>
            <a:r>
              <a:rPr lang="en-GB" sz="1200" dirty="0"/>
              <a:t>.</a:t>
            </a:r>
            <a:r>
              <a:rPr lang="fr-FR" sz="1200" dirty="0"/>
              <a:t>5</a:t>
            </a: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12EC5BEA-8D40-4C2C-B69D-B52B79D98BDD}"/>
              </a:ext>
            </a:extLst>
          </p:cNvPr>
          <p:cNvSpPr txBox="1"/>
          <p:nvPr/>
        </p:nvSpPr>
        <p:spPr>
          <a:xfrm>
            <a:off x="772227" y="735160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0</a:t>
            </a:r>
            <a:r>
              <a:rPr lang="fr-FR" sz="1200" baseline="30000" dirty="0"/>
              <a:t>-1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CB2D0F59-C885-4C48-BED2-BA28B6ECA06F}"/>
              </a:ext>
            </a:extLst>
          </p:cNvPr>
          <p:cNvSpPr txBox="1"/>
          <p:nvPr/>
        </p:nvSpPr>
        <p:spPr>
          <a:xfrm>
            <a:off x="1696859" y="7351604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0</a:t>
            </a:r>
            <a:r>
              <a:rPr lang="fr-FR" sz="1200" baseline="30000" dirty="0"/>
              <a:t>0</a:t>
            </a:r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EF917BC8-7188-473B-9302-1B4CA95544D5}"/>
              </a:ext>
            </a:extLst>
          </p:cNvPr>
          <p:cNvSpPr txBox="1"/>
          <p:nvPr/>
        </p:nvSpPr>
        <p:spPr>
          <a:xfrm>
            <a:off x="2592914" y="7351604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0</a:t>
            </a:r>
            <a:r>
              <a:rPr lang="fr-FR" sz="1200" baseline="30000" dirty="0"/>
              <a:t>1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D4C4C27D-3178-4138-A538-F56DDF8E4E29}"/>
              </a:ext>
            </a:extLst>
          </p:cNvPr>
          <p:cNvSpPr txBox="1"/>
          <p:nvPr/>
        </p:nvSpPr>
        <p:spPr>
          <a:xfrm>
            <a:off x="3498496" y="7351604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0</a:t>
            </a:r>
            <a:r>
              <a:rPr lang="fr-FR" sz="1200" baseline="30000" dirty="0"/>
              <a:t>2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C90D57E1-B799-4950-B9BF-88FA23515454}"/>
              </a:ext>
            </a:extLst>
          </p:cNvPr>
          <p:cNvSpPr txBox="1"/>
          <p:nvPr/>
        </p:nvSpPr>
        <p:spPr>
          <a:xfrm>
            <a:off x="4398432" y="7345254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0</a:t>
            </a:r>
            <a:r>
              <a:rPr lang="fr-FR" sz="1200" baseline="30000" dirty="0"/>
              <a:t>3</a:t>
            </a:r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5EFF5325-A0D7-40CF-826E-F47444246400}"/>
              </a:ext>
            </a:extLst>
          </p:cNvPr>
          <p:cNvSpPr txBox="1"/>
          <p:nvPr/>
        </p:nvSpPr>
        <p:spPr>
          <a:xfrm>
            <a:off x="1862230" y="7633235"/>
            <a:ext cx="1911101" cy="2822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IFN-I score </a:t>
            </a:r>
            <a:r>
              <a:rPr lang="fr-FR" sz="1200" dirty="0" err="1"/>
              <a:t>FilmArray</a:t>
            </a:r>
            <a:r>
              <a:rPr lang="fr-FR" sz="1200" dirty="0"/>
              <a:t>® (NP)</a:t>
            </a:r>
          </a:p>
        </p:txBody>
      </p:sp>
      <p:sp>
        <p:nvSpPr>
          <p:cNvPr id="172" name="ZoneTexte 171">
            <a:extLst>
              <a:ext uri="{FF2B5EF4-FFF2-40B4-BE49-F238E27FC236}">
                <a16:creationId xmlns:a16="http://schemas.microsoft.com/office/drawing/2014/main" id="{F3080156-A7BF-4712-B189-1B71D3AAB40C}"/>
              </a:ext>
            </a:extLst>
          </p:cNvPr>
          <p:cNvSpPr txBox="1"/>
          <p:nvPr/>
        </p:nvSpPr>
        <p:spPr>
          <a:xfrm>
            <a:off x="278052" y="4480225"/>
            <a:ext cx="3080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c.</a:t>
            </a:r>
          </a:p>
        </p:txBody>
      </p:sp>
      <p:sp>
        <p:nvSpPr>
          <p:cNvPr id="173" name="ZoneTexte 172">
            <a:extLst>
              <a:ext uri="{FF2B5EF4-FFF2-40B4-BE49-F238E27FC236}">
                <a16:creationId xmlns:a16="http://schemas.microsoft.com/office/drawing/2014/main" id="{FD208588-339F-4F2D-8D99-760EE21FD02F}"/>
              </a:ext>
            </a:extLst>
          </p:cNvPr>
          <p:cNvSpPr txBox="1"/>
          <p:nvPr/>
        </p:nvSpPr>
        <p:spPr>
          <a:xfrm>
            <a:off x="6763593" y="4480227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d.</a:t>
            </a:r>
          </a:p>
        </p:txBody>
      </p:sp>
      <p:grpSp>
        <p:nvGrpSpPr>
          <p:cNvPr id="51" name="Groupe 50">
            <a:extLst>
              <a:ext uri="{FF2B5EF4-FFF2-40B4-BE49-F238E27FC236}">
                <a16:creationId xmlns:a16="http://schemas.microsoft.com/office/drawing/2014/main" id="{E669491E-B2D8-4254-8592-ADBA46486D90}"/>
              </a:ext>
            </a:extLst>
          </p:cNvPr>
          <p:cNvGrpSpPr/>
          <p:nvPr/>
        </p:nvGrpSpPr>
        <p:grpSpPr>
          <a:xfrm>
            <a:off x="895927" y="4649076"/>
            <a:ext cx="3801051" cy="2882900"/>
            <a:chOff x="949697" y="4689475"/>
            <a:chExt cx="4286250" cy="2882900"/>
          </a:xfrm>
        </p:grpSpPr>
        <p:graphicFrame>
          <p:nvGraphicFramePr>
            <p:cNvPr id="142" name="Objet 141">
              <a:extLst>
                <a:ext uri="{FF2B5EF4-FFF2-40B4-BE49-F238E27FC236}">
                  <a16:creationId xmlns:a16="http://schemas.microsoft.com/office/drawing/2014/main" id="{1EE62EA3-A6D1-4E32-A353-6B6DC9D9518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0805575"/>
                </p:ext>
              </p:extLst>
            </p:nvPr>
          </p:nvGraphicFramePr>
          <p:xfrm>
            <a:off x="949697" y="4689475"/>
            <a:ext cx="4286250" cy="2882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783946" imgH="2546289" progId="Prism8.Document">
                    <p:embed/>
                  </p:oleObj>
                </mc:Choice>
                <mc:Fallback>
                  <p:oleObj name="Prism 8" r:id="rId4" imgW="3783946" imgH="2546289" progId="Prism8.Document">
                    <p:embed/>
                    <p:pic>
                      <p:nvPicPr>
                        <p:cNvPr id="142" name="Objet 141">
                          <a:extLst>
                            <a:ext uri="{FF2B5EF4-FFF2-40B4-BE49-F238E27FC236}">
                              <a16:creationId xmlns:a16="http://schemas.microsoft.com/office/drawing/2014/main" id="{1EE62EA3-A6D1-4E32-A353-6B6DC9D9518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949697" y="4689475"/>
                          <a:ext cx="4286250" cy="2882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5" name="Forme libre : forme 174">
              <a:extLst>
                <a:ext uri="{FF2B5EF4-FFF2-40B4-BE49-F238E27FC236}">
                  <a16:creationId xmlns:a16="http://schemas.microsoft.com/office/drawing/2014/main" id="{CF60B07F-139C-47FD-9CB0-A9CAFE6FE804}"/>
                </a:ext>
              </a:extLst>
            </p:cNvPr>
            <p:cNvSpPr/>
            <p:nvPr/>
          </p:nvSpPr>
          <p:spPr>
            <a:xfrm>
              <a:off x="982544" y="7122851"/>
              <a:ext cx="72000" cy="7518"/>
            </a:xfrm>
            <a:custGeom>
              <a:avLst/>
              <a:gdLst>
                <a:gd name="connsiteX0" fmla="*/ 0 w 34772"/>
                <a:gd name="connsiteY0" fmla="*/ 0 h 12700"/>
                <a:gd name="connsiteX1" fmla="*/ 34773 w 34772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772" h="12700">
                  <a:moveTo>
                    <a:pt x="0" y="0"/>
                  </a:moveTo>
                  <a:lnTo>
                    <a:pt x="34773" y="0"/>
                  </a:lnTo>
                </a:path>
              </a:pathLst>
            </a:custGeom>
            <a:noFill/>
            <a:ln w="3175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176" name="Forme libre : forme 175">
              <a:extLst>
                <a:ext uri="{FF2B5EF4-FFF2-40B4-BE49-F238E27FC236}">
                  <a16:creationId xmlns:a16="http://schemas.microsoft.com/office/drawing/2014/main" id="{3F1058EB-56FB-4E6E-AE9A-FD0E53F32A4B}"/>
                </a:ext>
              </a:extLst>
            </p:cNvPr>
            <p:cNvSpPr/>
            <p:nvPr/>
          </p:nvSpPr>
          <p:spPr>
            <a:xfrm>
              <a:off x="982544" y="6440840"/>
              <a:ext cx="72000" cy="7518"/>
            </a:xfrm>
            <a:custGeom>
              <a:avLst/>
              <a:gdLst>
                <a:gd name="connsiteX0" fmla="*/ 0 w 34772"/>
                <a:gd name="connsiteY0" fmla="*/ 0 h 12700"/>
                <a:gd name="connsiteX1" fmla="*/ 34773 w 34772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772" h="12700">
                  <a:moveTo>
                    <a:pt x="0" y="0"/>
                  </a:moveTo>
                  <a:lnTo>
                    <a:pt x="34773" y="0"/>
                  </a:lnTo>
                </a:path>
              </a:pathLst>
            </a:custGeom>
            <a:noFill/>
            <a:ln w="3175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177" name="Forme libre : forme 176">
              <a:extLst>
                <a:ext uri="{FF2B5EF4-FFF2-40B4-BE49-F238E27FC236}">
                  <a16:creationId xmlns:a16="http://schemas.microsoft.com/office/drawing/2014/main" id="{7A258DEA-C4C6-4FFF-9C86-D57000721B5D}"/>
                </a:ext>
              </a:extLst>
            </p:cNvPr>
            <p:cNvSpPr/>
            <p:nvPr/>
          </p:nvSpPr>
          <p:spPr>
            <a:xfrm>
              <a:off x="982544" y="5745516"/>
              <a:ext cx="72000" cy="7518"/>
            </a:xfrm>
            <a:custGeom>
              <a:avLst/>
              <a:gdLst>
                <a:gd name="connsiteX0" fmla="*/ 0 w 34772"/>
                <a:gd name="connsiteY0" fmla="*/ 0 h 12700"/>
                <a:gd name="connsiteX1" fmla="*/ 34773 w 34772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772" h="12700">
                  <a:moveTo>
                    <a:pt x="0" y="0"/>
                  </a:moveTo>
                  <a:lnTo>
                    <a:pt x="34773" y="0"/>
                  </a:lnTo>
                </a:path>
              </a:pathLst>
            </a:custGeom>
            <a:noFill/>
            <a:ln w="3175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178" name="Forme libre : forme 177">
              <a:extLst>
                <a:ext uri="{FF2B5EF4-FFF2-40B4-BE49-F238E27FC236}">
                  <a16:creationId xmlns:a16="http://schemas.microsoft.com/office/drawing/2014/main" id="{E3F89FC6-227A-4938-A939-CA7190276291}"/>
                </a:ext>
              </a:extLst>
            </p:cNvPr>
            <p:cNvSpPr/>
            <p:nvPr/>
          </p:nvSpPr>
          <p:spPr>
            <a:xfrm>
              <a:off x="982544" y="5073831"/>
              <a:ext cx="72000" cy="7518"/>
            </a:xfrm>
            <a:custGeom>
              <a:avLst/>
              <a:gdLst>
                <a:gd name="connsiteX0" fmla="*/ 0 w 34772"/>
                <a:gd name="connsiteY0" fmla="*/ 0 h 12700"/>
                <a:gd name="connsiteX1" fmla="*/ 34773 w 34772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772" h="12700">
                  <a:moveTo>
                    <a:pt x="0" y="0"/>
                  </a:moveTo>
                  <a:lnTo>
                    <a:pt x="34773" y="0"/>
                  </a:lnTo>
                </a:path>
              </a:pathLst>
            </a:custGeom>
            <a:noFill/>
            <a:ln w="3175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180" name="ZoneTexte 179">
            <a:extLst>
              <a:ext uri="{FF2B5EF4-FFF2-40B4-BE49-F238E27FC236}">
                <a16:creationId xmlns:a16="http://schemas.microsoft.com/office/drawing/2014/main" id="{3CAA799B-465B-40C4-B545-1CD541CAC722}"/>
              </a:ext>
            </a:extLst>
          </p:cNvPr>
          <p:cNvSpPr txBox="1"/>
          <p:nvPr/>
        </p:nvSpPr>
        <p:spPr>
          <a:xfrm>
            <a:off x="48958" y="4891667"/>
            <a:ext cx="938014" cy="2822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SARS-CoV-2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BA2546AD-3165-4C7D-8A4D-DEE65BC8FD8C}"/>
              </a:ext>
            </a:extLst>
          </p:cNvPr>
          <p:cNvSpPr txBox="1"/>
          <p:nvPr/>
        </p:nvSpPr>
        <p:spPr>
          <a:xfrm>
            <a:off x="564933" y="5569034"/>
            <a:ext cx="4220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RSV</a:t>
            </a:r>
          </a:p>
        </p:txBody>
      </p:sp>
      <p:sp>
        <p:nvSpPr>
          <p:cNvPr id="182" name="ZoneTexte 181">
            <a:extLst>
              <a:ext uri="{FF2B5EF4-FFF2-40B4-BE49-F238E27FC236}">
                <a16:creationId xmlns:a16="http://schemas.microsoft.com/office/drawing/2014/main" id="{C63FC04F-FA23-49E6-9C18-13CBD16EAFE0}"/>
              </a:ext>
            </a:extLst>
          </p:cNvPr>
          <p:cNvSpPr txBox="1"/>
          <p:nvPr/>
        </p:nvSpPr>
        <p:spPr>
          <a:xfrm>
            <a:off x="595778" y="6266192"/>
            <a:ext cx="39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IBV</a:t>
            </a:r>
          </a:p>
        </p:txBody>
      </p:sp>
      <p:sp>
        <p:nvSpPr>
          <p:cNvPr id="183" name="ZoneTexte 182">
            <a:extLst>
              <a:ext uri="{FF2B5EF4-FFF2-40B4-BE49-F238E27FC236}">
                <a16:creationId xmlns:a16="http://schemas.microsoft.com/office/drawing/2014/main" id="{C80A2C4B-AF1F-467C-9DDD-A415D329D580}"/>
              </a:ext>
            </a:extLst>
          </p:cNvPr>
          <p:cNvSpPr txBox="1"/>
          <p:nvPr/>
        </p:nvSpPr>
        <p:spPr>
          <a:xfrm>
            <a:off x="594172" y="6950263"/>
            <a:ext cx="392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IAV</a:t>
            </a:r>
          </a:p>
        </p:txBody>
      </p:sp>
      <p:grpSp>
        <p:nvGrpSpPr>
          <p:cNvPr id="184" name="Groupe 183">
            <a:extLst>
              <a:ext uri="{FF2B5EF4-FFF2-40B4-BE49-F238E27FC236}">
                <a16:creationId xmlns:a16="http://schemas.microsoft.com/office/drawing/2014/main" id="{7B8667DE-A4CC-4340-A80A-2F19D4483EEC}"/>
              </a:ext>
            </a:extLst>
          </p:cNvPr>
          <p:cNvGrpSpPr/>
          <p:nvPr/>
        </p:nvGrpSpPr>
        <p:grpSpPr>
          <a:xfrm>
            <a:off x="4531220" y="4838111"/>
            <a:ext cx="683886" cy="400547"/>
            <a:chOff x="4606541" y="1180807"/>
            <a:chExt cx="683886" cy="400547"/>
          </a:xfrm>
        </p:grpSpPr>
        <p:grpSp>
          <p:nvGrpSpPr>
            <p:cNvPr id="185" name="Groupe 184">
              <a:extLst>
                <a:ext uri="{FF2B5EF4-FFF2-40B4-BE49-F238E27FC236}">
                  <a16:creationId xmlns:a16="http://schemas.microsoft.com/office/drawing/2014/main" id="{C9F0264E-9630-404D-94CF-FA7858E8DEB8}"/>
                </a:ext>
              </a:extLst>
            </p:cNvPr>
            <p:cNvGrpSpPr/>
            <p:nvPr/>
          </p:nvGrpSpPr>
          <p:grpSpPr>
            <a:xfrm>
              <a:off x="4606541" y="1180807"/>
              <a:ext cx="64097" cy="400547"/>
              <a:chOff x="4601778" y="1180807"/>
              <a:chExt cx="64097" cy="400547"/>
            </a:xfrm>
          </p:grpSpPr>
          <p:sp>
            <p:nvSpPr>
              <p:cNvPr id="187" name="Forme libre : forme 186">
                <a:extLst>
                  <a:ext uri="{FF2B5EF4-FFF2-40B4-BE49-F238E27FC236}">
                    <a16:creationId xmlns:a16="http://schemas.microsoft.com/office/drawing/2014/main" id="{05CEE379-46CF-4995-A672-2710B1C1C3F7}"/>
                  </a:ext>
                </a:extLst>
              </p:cNvPr>
              <p:cNvSpPr/>
              <p:nvPr/>
            </p:nvSpPr>
            <p:spPr>
              <a:xfrm>
                <a:off x="4601778" y="1568654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88" name="Forme libre : forme 187">
                <a:extLst>
                  <a:ext uri="{FF2B5EF4-FFF2-40B4-BE49-F238E27FC236}">
                    <a16:creationId xmlns:a16="http://schemas.microsoft.com/office/drawing/2014/main" id="{3AE99A01-C9A9-4CD7-A25B-A59C0D05E08D}"/>
                  </a:ext>
                </a:extLst>
              </p:cNvPr>
              <p:cNvSpPr/>
              <p:nvPr/>
            </p:nvSpPr>
            <p:spPr>
              <a:xfrm>
                <a:off x="4653175" y="1180807"/>
                <a:ext cx="12700" cy="387846"/>
              </a:xfrm>
              <a:custGeom>
                <a:avLst/>
                <a:gdLst>
                  <a:gd name="connsiteX0" fmla="*/ 0 w 12700"/>
                  <a:gd name="connsiteY0" fmla="*/ 387847 h 387846"/>
                  <a:gd name="connsiteX1" fmla="*/ 0 w 12700"/>
                  <a:gd name="connsiteY1" fmla="*/ 0 h 3878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6">
                    <a:moveTo>
                      <a:pt x="0" y="387847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89" name="Forme libre : forme 188">
                <a:extLst>
                  <a:ext uri="{FF2B5EF4-FFF2-40B4-BE49-F238E27FC236}">
                    <a16:creationId xmlns:a16="http://schemas.microsoft.com/office/drawing/2014/main" id="{FC74B1FF-1504-4728-AC19-516B4A7CD53E}"/>
                  </a:ext>
                </a:extLst>
              </p:cNvPr>
              <p:cNvSpPr/>
              <p:nvPr/>
            </p:nvSpPr>
            <p:spPr>
              <a:xfrm>
                <a:off x="4601778" y="1180807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82835029-29D4-4A1A-9833-5E928DB8BC0B}"/>
                </a:ext>
              </a:extLst>
            </p:cNvPr>
            <p:cNvSpPr txBox="1"/>
            <p:nvPr/>
          </p:nvSpPr>
          <p:spPr>
            <a:xfrm>
              <a:off x="4660126" y="125508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190" name="Groupe 189">
            <a:extLst>
              <a:ext uri="{FF2B5EF4-FFF2-40B4-BE49-F238E27FC236}">
                <a16:creationId xmlns:a16="http://schemas.microsoft.com/office/drawing/2014/main" id="{3EEA917B-5733-4D39-802A-F208A2E949FA}"/>
              </a:ext>
            </a:extLst>
          </p:cNvPr>
          <p:cNvGrpSpPr/>
          <p:nvPr/>
        </p:nvGrpSpPr>
        <p:grpSpPr>
          <a:xfrm>
            <a:off x="4531220" y="5505953"/>
            <a:ext cx="683886" cy="400545"/>
            <a:chOff x="4606541" y="2344398"/>
            <a:chExt cx="683886" cy="400545"/>
          </a:xfrm>
        </p:grpSpPr>
        <p:grpSp>
          <p:nvGrpSpPr>
            <p:cNvPr id="191" name="Groupe 190">
              <a:extLst>
                <a:ext uri="{FF2B5EF4-FFF2-40B4-BE49-F238E27FC236}">
                  <a16:creationId xmlns:a16="http://schemas.microsoft.com/office/drawing/2014/main" id="{7FDC933D-37DF-4400-826A-730EE38D748B}"/>
                </a:ext>
              </a:extLst>
            </p:cNvPr>
            <p:cNvGrpSpPr/>
            <p:nvPr/>
          </p:nvGrpSpPr>
          <p:grpSpPr>
            <a:xfrm>
              <a:off x="4606541" y="2344398"/>
              <a:ext cx="64097" cy="400545"/>
              <a:chOff x="4601778" y="2344398"/>
              <a:chExt cx="64097" cy="400545"/>
            </a:xfrm>
          </p:grpSpPr>
          <p:sp>
            <p:nvSpPr>
              <p:cNvPr id="193" name="Forme libre : forme 192">
                <a:extLst>
                  <a:ext uri="{FF2B5EF4-FFF2-40B4-BE49-F238E27FC236}">
                    <a16:creationId xmlns:a16="http://schemas.microsoft.com/office/drawing/2014/main" id="{C0DF43ED-7E51-496E-AC46-2A494313889D}"/>
                  </a:ext>
                </a:extLst>
              </p:cNvPr>
              <p:cNvSpPr/>
              <p:nvPr/>
            </p:nvSpPr>
            <p:spPr>
              <a:xfrm>
                <a:off x="4601778" y="2732243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94" name="Forme libre : forme 193">
                <a:extLst>
                  <a:ext uri="{FF2B5EF4-FFF2-40B4-BE49-F238E27FC236}">
                    <a16:creationId xmlns:a16="http://schemas.microsoft.com/office/drawing/2014/main" id="{77A762CD-3593-4EE2-8038-E5AC0BA7B6F2}"/>
                  </a:ext>
                </a:extLst>
              </p:cNvPr>
              <p:cNvSpPr/>
              <p:nvPr/>
            </p:nvSpPr>
            <p:spPr>
              <a:xfrm>
                <a:off x="4653175" y="2344398"/>
                <a:ext cx="12700" cy="387845"/>
              </a:xfrm>
              <a:custGeom>
                <a:avLst/>
                <a:gdLst>
                  <a:gd name="connsiteX0" fmla="*/ 0 w 12700"/>
                  <a:gd name="connsiteY0" fmla="*/ 387845 h 387845"/>
                  <a:gd name="connsiteX1" fmla="*/ 0 w 12700"/>
                  <a:gd name="connsiteY1" fmla="*/ 0 h 3878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5">
                    <a:moveTo>
                      <a:pt x="0" y="387845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195" name="Forme libre : forme 194">
                <a:extLst>
                  <a:ext uri="{FF2B5EF4-FFF2-40B4-BE49-F238E27FC236}">
                    <a16:creationId xmlns:a16="http://schemas.microsoft.com/office/drawing/2014/main" id="{12410D37-15F5-426F-9669-DCD54F1236CD}"/>
                  </a:ext>
                </a:extLst>
              </p:cNvPr>
              <p:cNvSpPr/>
              <p:nvPr/>
            </p:nvSpPr>
            <p:spPr>
              <a:xfrm>
                <a:off x="4601778" y="2344398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92" name="ZoneTexte 191">
              <a:extLst>
                <a:ext uri="{FF2B5EF4-FFF2-40B4-BE49-F238E27FC236}">
                  <a16:creationId xmlns:a16="http://schemas.microsoft.com/office/drawing/2014/main" id="{FF3CD022-09B0-4302-8D47-CB64EE5847DB}"/>
                </a:ext>
              </a:extLst>
            </p:cNvPr>
            <p:cNvSpPr txBox="1"/>
            <p:nvPr/>
          </p:nvSpPr>
          <p:spPr>
            <a:xfrm>
              <a:off x="4660126" y="2418670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196" name="Groupe 195">
            <a:extLst>
              <a:ext uri="{FF2B5EF4-FFF2-40B4-BE49-F238E27FC236}">
                <a16:creationId xmlns:a16="http://schemas.microsoft.com/office/drawing/2014/main" id="{EE930F19-458F-4A6F-91A1-4782D9EB5560}"/>
              </a:ext>
            </a:extLst>
          </p:cNvPr>
          <p:cNvGrpSpPr/>
          <p:nvPr/>
        </p:nvGrpSpPr>
        <p:grpSpPr>
          <a:xfrm>
            <a:off x="4531220" y="6212632"/>
            <a:ext cx="683886" cy="400546"/>
            <a:chOff x="4606541" y="3507984"/>
            <a:chExt cx="683886" cy="400546"/>
          </a:xfrm>
        </p:grpSpPr>
        <p:grpSp>
          <p:nvGrpSpPr>
            <p:cNvPr id="197" name="Groupe 196">
              <a:extLst>
                <a:ext uri="{FF2B5EF4-FFF2-40B4-BE49-F238E27FC236}">
                  <a16:creationId xmlns:a16="http://schemas.microsoft.com/office/drawing/2014/main" id="{3C26C8A6-7E18-4D74-8FB2-88FB5A50EE23}"/>
                </a:ext>
              </a:extLst>
            </p:cNvPr>
            <p:cNvGrpSpPr/>
            <p:nvPr/>
          </p:nvGrpSpPr>
          <p:grpSpPr>
            <a:xfrm>
              <a:off x="4606541" y="3507984"/>
              <a:ext cx="64097" cy="400546"/>
              <a:chOff x="4601778" y="3507984"/>
              <a:chExt cx="64097" cy="400546"/>
            </a:xfrm>
          </p:grpSpPr>
          <p:sp>
            <p:nvSpPr>
              <p:cNvPr id="199" name="Forme libre : forme 198">
                <a:extLst>
                  <a:ext uri="{FF2B5EF4-FFF2-40B4-BE49-F238E27FC236}">
                    <a16:creationId xmlns:a16="http://schemas.microsoft.com/office/drawing/2014/main" id="{D8A58F6F-92A6-4EF4-B5CF-8FD8F7A5DF56}"/>
                  </a:ext>
                </a:extLst>
              </p:cNvPr>
              <p:cNvSpPr/>
              <p:nvPr/>
            </p:nvSpPr>
            <p:spPr>
              <a:xfrm>
                <a:off x="4601778" y="3895830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00" name="Forme libre : forme 199">
                <a:extLst>
                  <a:ext uri="{FF2B5EF4-FFF2-40B4-BE49-F238E27FC236}">
                    <a16:creationId xmlns:a16="http://schemas.microsoft.com/office/drawing/2014/main" id="{1C733A73-E274-46B4-95B2-9AE26B94748B}"/>
                  </a:ext>
                </a:extLst>
              </p:cNvPr>
              <p:cNvSpPr/>
              <p:nvPr/>
            </p:nvSpPr>
            <p:spPr>
              <a:xfrm>
                <a:off x="4653175" y="3507984"/>
                <a:ext cx="12700" cy="387845"/>
              </a:xfrm>
              <a:custGeom>
                <a:avLst/>
                <a:gdLst>
                  <a:gd name="connsiteX0" fmla="*/ 0 w 12700"/>
                  <a:gd name="connsiteY0" fmla="*/ 387845 h 387845"/>
                  <a:gd name="connsiteX1" fmla="*/ 0 w 12700"/>
                  <a:gd name="connsiteY1" fmla="*/ 0 h 3878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5">
                    <a:moveTo>
                      <a:pt x="0" y="387845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01" name="Forme libre : forme 200">
                <a:extLst>
                  <a:ext uri="{FF2B5EF4-FFF2-40B4-BE49-F238E27FC236}">
                    <a16:creationId xmlns:a16="http://schemas.microsoft.com/office/drawing/2014/main" id="{752E8298-393E-4BEC-BFD3-EFBD95D34588}"/>
                  </a:ext>
                </a:extLst>
              </p:cNvPr>
              <p:cNvSpPr/>
              <p:nvPr/>
            </p:nvSpPr>
            <p:spPr>
              <a:xfrm>
                <a:off x="4601778" y="3507984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198" name="ZoneTexte 197">
              <a:extLst>
                <a:ext uri="{FF2B5EF4-FFF2-40B4-BE49-F238E27FC236}">
                  <a16:creationId xmlns:a16="http://schemas.microsoft.com/office/drawing/2014/main" id="{64F71EEE-F111-4277-A224-9B86D0E30756}"/>
                </a:ext>
              </a:extLst>
            </p:cNvPr>
            <p:cNvSpPr txBox="1"/>
            <p:nvPr/>
          </p:nvSpPr>
          <p:spPr>
            <a:xfrm>
              <a:off x="4660126" y="3582257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202" name="Groupe 201">
            <a:extLst>
              <a:ext uri="{FF2B5EF4-FFF2-40B4-BE49-F238E27FC236}">
                <a16:creationId xmlns:a16="http://schemas.microsoft.com/office/drawing/2014/main" id="{92B4A189-7244-42F7-81FA-7A2FA8FEB6B5}"/>
              </a:ext>
            </a:extLst>
          </p:cNvPr>
          <p:cNvGrpSpPr/>
          <p:nvPr/>
        </p:nvGrpSpPr>
        <p:grpSpPr>
          <a:xfrm>
            <a:off x="4531220" y="6887182"/>
            <a:ext cx="683886" cy="400545"/>
            <a:chOff x="4606541" y="4671571"/>
            <a:chExt cx="683886" cy="400545"/>
          </a:xfrm>
        </p:grpSpPr>
        <p:grpSp>
          <p:nvGrpSpPr>
            <p:cNvPr id="204" name="Groupe 203">
              <a:extLst>
                <a:ext uri="{FF2B5EF4-FFF2-40B4-BE49-F238E27FC236}">
                  <a16:creationId xmlns:a16="http://schemas.microsoft.com/office/drawing/2014/main" id="{C44F4A7D-9F7F-4278-86AA-308BF3054928}"/>
                </a:ext>
              </a:extLst>
            </p:cNvPr>
            <p:cNvGrpSpPr/>
            <p:nvPr/>
          </p:nvGrpSpPr>
          <p:grpSpPr>
            <a:xfrm>
              <a:off x="4606541" y="4671571"/>
              <a:ext cx="64097" cy="400545"/>
              <a:chOff x="4601778" y="4671571"/>
              <a:chExt cx="64097" cy="400545"/>
            </a:xfrm>
          </p:grpSpPr>
          <p:sp>
            <p:nvSpPr>
              <p:cNvPr id="207" name="Forme libre : forme 206">
                <a:extLst>
                  <a:ext uri="{FF2B5EF4-FFF2-40B4-BE49-F238E27FC236}">
                    <a16:creationId xmlns:a16="http://schemas.microsoft.com/office/drawing/2014/main" id="{52DF33D2-1A65-4FB7-B498-8D845BDD8D10}"/>
                  </a:ext>
                </a:extLst>
              </p:cNvPr>
              <p:cNvSpPr/>
              <p:nvPr/>
            </p:nvSpPr>
            <p:spPr>
              <a:xfrm>
                <a:off x="4601778" y="5059416"/>
                <a:ext cx="51396" cy="12700"/>
              </a:xfrm>
              <a:custGeom>
                <a:avLst/>
                <a:gdLst>
                  <a:gd name="connsiteX0" fmla="*/ 0 w 51396"/>
                  <a:gd name="connsiteY0" fmla="*/ 0 h 12700"/>
                  <a:gd name="connsiteX1" fmla="*/ 51397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0" y="0"/>
                    </a:moveTo>
                    <a:lnTo>
                      <a:pt x="51397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09" name="Forme libre : forme 208">
                <a:extLst>
                  <a:ext uri="{FF2B5EF4-FFF2-40B4-BE49-F238E27FC236}">
                    <a16:creationId xmlns:a16="http://schemas.microsoft.com/office/drawing/2014/main" id="{8A529DCD-4308-4E28-83D9-57B37A6957C7}"/>
                  </a:ext>
                </a:extLst>
              </p:cNvPr>
              <p:cNvSpPr/>
              <p:nvPr/>
            </p:nvSpPr>
            <p:spPr>
              <a:xfrm>
                <a:off x="4653175" y="4671571"/>
                <a:ext cx="12700" cy="387845"/>
              </a:xfrm>
              <a:custGeom>
                <a:avLst/>
                <a:gdLst>
                  <a:gd name="connsiteX0" fmla="*/ 0 w 12700"/>
                  <a:gd name="connsiteY0" fmla="*/ 387845 h 387845"/>
                  <a:gd name="connsiteX1" fmla="*/ 0 w 12700"/>
                  <a:gd name="connsiteY1" fmla="*/ 0 h 3878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0" h="387845">
                    <a:moveTo>
                      <a:pt x="0" y="387845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  <p:sp>
            <p:nvSpPr>
              <p:cNvPr id="216" name="Forme libre : forme 215">
                <a:extLst>
                  <a:ext uri="{FF2B5EF4-FFF2-40B4-BE49-F238E27FC236}">
                    <a16:creationId xmlns:a16="http://schemas.microsoft.com/office/drawing/2014/main" id="{BBDB4EF5-7B14-49A4-AA51-817AAB56650C}"/>
                  </a:ext>
                </a:extLst>
              </p:cNvPr>
              <p:cNvSpPr/>
              <p:nvPr/>
            </p:nvSpPr>
            <p:spPr>
              <a:xfrm>
                <a:off x="4601778" y="4671571"/>
                <a:ext cx="51396" cy="12700"/>
              </a:xfrm>
              <a:custGeom>
                <a:avLst/>
                <a:gdLst>
                  <a:gd name="connsiteX0" fmla="*/ 51397 w 51396"/>
                  <a:gd name="connsiteY0" fmla="*/ 0 h 12700"/>
                  <a:gd name="connsiteX1" fmla="*/ 0 w 51396"/>
                  <a:gd name="connsiteY1" fmla="*/ 0 h 12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396" h="12700">
                    <a:moveTo>
                      <a:pt x="51397" y="0"/>
                    </a:moveTo>
                    <a:lnTo>
                      <a:pt x="0" y="0"/>
                    </a:lnTo>
                  </a:path>
                </a:pathLst>
              </a:custGeom>
              <a:noFill/>
              <a:ln w="813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fr-FR"/>
              </a:p>
            </p:txBody>
          </p:sp>
        </p:grp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7D266B1B-C94B-4E9A-9196-CA3AD62DD164}"/>
                </a:ext>
              </a:extLst>
            </p:cNvPr>
            <p:cNvSpPr txBox="1"/>
            <p:nvPr/>
          </p:nvSpPr>
          <p:spPr>
            <a:xfrm>
              <a:off x="4660126" y="4734688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i="1" dirty="0">
                  <a:cs typeface="Times New Roman" panose="02020603050405020304" pitchFamily="18" charset="0"/>
                </a:rPr>
                <a:t>&lt;0</a:t>
              </a:r>
              <a:r>
                <a:rPr lang="en-GB" sz="1050" i="1" dirty="0">
                  <a:cs typeface="Times New Roman" panose="02020603050405020304" pitchFamily="18" charset="0"/>
                </a:rPr>
                <a:t>.</a:t>
              </a:r>
              <a:r>
                <a:rPr lang="en-GB" sz="1050" i="1" dirty="0">
                  <a:ea typeface="Times New Roman" panose="02020603050405020304" pitchFamily="18" charset="0"/>
                </a:rPr>
                <a:t>0001</a:t>
              </a:r>
              <a:endParaRPr lang="fr-FR" sz="1050" i="1" dirty="0"/>
            </a:p>
          </p:txBody>
        </p:sp>
      </p:grpSp>
      <p:grpSp>
        <p:nvGrpSpPr>
          <p:cNvPr id="55" name="Groupe 54">
            <a:extLst>
              <a:ext uri="{FF2B5EF4-FFF2-40B4-BE49-F238E27FC236}">
                <a16:creationId xmlns:a16="http://schemas.microsoft.com/office/drawing/2014/main" id="{B0B5B628-90DD-415E-8933-C19518EC38BE}"/>
              </a:ext>
            </a:extLst>
          </p:cNvPr>
          <p:cNvGrpSpPr/>
          <p:nvPr/>
        </p:nvGrpSpPr>
        <p:grpSpPr>
          <a:xfrm>
            <a:off x="5397242" y="512186"/>
            <a:ext cx="858633" cy="607584"/>
            <a:chOff x="5252641" y="578900"/>
            <a:chExt cx="858632" cy="607584"/>
          </a:xfrm>
        </p:grpSpPr>
        <p:grpSp>
          <p:nvGrpSpPr>
            <p:cNvPr id="53" name="Groupe 52">
              <a:extLst>
                <a:ext uri="{FF2B5EF4-FFF2-40B4-BE49-F238E27FC236}">
                  <a16:creationId xmlns:a16="http://schemas.microsoft.com/office/drawing/2014/main" id="{AB2B94B1-E7EC-419D-840C-A994A08C2254}"/>
                </a:ext>
              </a:extLst>
            </p:cNvPr>
            <p:cNvGrpSpPr/>
            <p:nvPr/>
          </p:nvGrpSpPr>
          <p:grpSpPr>
            <a:xfrm>
              <a:off x="5320327" y="756783"/>
              <a:ext cx="650649" cy="276999"/>
              <a:chOff x="5320327" y="756783"/>
              <a:chExt cx="650649" cy="276999"/>
            </a:xfrm>
          </p:grpSpPr>
          <p:sp>
            <p:nvSpPr>
              <p:cNvPr id="298" name="ZoneTexte 297">
                <a:extLst>
                  <a:ext uri="{FF2B5EF4-FFF2-40B4-BE49-F238E27FC236}">
                    <a16:creationId xmlns:a16="http://schemas.microsoft.com/office/drawing/2014/main" id="{28EC3705-D859-B54A-2085-9B927259FC95}"/>
                  </a:ext>
                </a:extLst>
              </p:cNvPr>
              <p:cNvSpPr txBox="1"/>
              <p:nvPr/>
            </p:nvSpPr>
            <p:spPr>
              <a:xfrm>
                <a:off x="5399987" y="756783"/>
                <a:ext cx="5709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&lt; 2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lang="fr-FR" sz="1200" dirty="0">
                    <a:cs typeface="Times New Roman" panose="02020603050405020304" pitchFamily="18" charset="0"/>
                  </a:rPr>
                  <a:t>47</a:t>
                </a:r>
                <a:endParaRPr lang="fr-FR" sz="1200" dirty="0"/>
              </a:p>
            </p:txBody>
          </p:sp>
          <p:sp>
            <p:nvSpPr>
              <p:cNvPr id="52" name="Ellipse 51">
                <a:extLst>
                  <a:ext uri="{FF2B5EF4-FFF2-40B4-BE49-F238E27FC236}">
                    <a16:creationId xmlns:a16="http://schemas.microsoft.com/office/drawing/2014/main" id="{9CA9BDA0-7E2C-4786-AFF3-967EAC61AC22}"/>
                  </a:ext>
                </a:extLst>
              </p:cNvPr>
              <p:cNvSpPr/>
              <p:nvPr/>
            </p:nvSpPr>
            <p:spPr>
              <a:xfrm>
                <a:off x="5320327" y="841282"/>
                <a:ext cx="108000" cy="108000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54" name="Groupe 53">
              <a:extLst>
                <a:ext uri="{FF2B5EF4-FFF2-40B4-BE49-F238E27FC236}">
                  <a16:creationId xmlns:a16="http://schemas.microsoft.com/office/drawing/2014/main" id="{C3F92C4F-EA26-4A9A-9C1C-18DF5F0827DD}"/>
                </a:ext>
              </a:extLst>
            </p:cNvPr>
            <p:cNvGrpSpPr/>
            <p:nvPr/>
          </p:nvGrpSpPr>
          <p:grpSpPr>
            <a:xfrm>
              <a:off x="5323580" y="909485"/>
              <a:ext cx="647396" cy="276999"/>
              <a:chOff x="5323580" y="909485"/>
              <a:chExt cx="647396" cy="276999"/>
            </a:xfrm>
          </p:grpSpPr>
          <p:sp>
            <p:nvSpPr>
              <p:cNvPr id="299" name="ZoneTexte 298">
                <a:extLst>
                  <a:ext uri="{FF2B5EF4-FFF2-40B4-BE49-F238E27FC236}">
                    <a16:creationId xmlns:a16="http://schemas.microsoft.com/office/drawing/2014/main" id="{056B54E7-0204-3B27-D4C3-C7728FFB9F15}"/>
                  </a:ext>
                </a:extLst>
              </p:cNvPr>
              <p:cNvSpPr txBox="1"/>
              <p:nvPr/>
            </p:nvSpPr>
            <p:spPr>
              <a:xfrm>
                <a:off x="5399987" y="909485"/>
                <a:ext cx="5709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≥ 2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lang="fr-FR" sz="1200" dirty="0">
                    <a:cs typeface="Times New Roman" panose="02020603050405020304" pitchFamily="18" charset="0"/>
                  </a:rPr>
                  <a:t>47</a:t>
                </a:r>
                <a:endParaRPr lang="fr-FR" sz="1200" dirty="0"/>
              </a:p>
            </p:txBody>
          </p:sp>
          <p:sp>
            <p:nvSpPr>
              <p:cNvPr id="217" name="Ellipse 216">
                <a:extLst>
                  <a:ext uri="{FF2B5EF4-FFF2-40B4-BE49-F238E27FC236}">
                    <a16:creationId xmlns:a16="http://schemas.microsoft.com/office/drawing/2014/main" id="{42900EC3-6229-49B8-B562-DDC16E16C5DC}"/>
                  </a:ext>
                </a:extLst>
              </p:cNvPr>
              <p:cNvSpPr/>
              <p:nvPr/>
            </p:nvSpPr>
            <p:spPr>
              <a:xfrm>
                <a:off x="5323580" y="99398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218" name="ZoneTexte 217">
              <a:extLst>
                <a:ext uri="{FF2B5EF4-FFF2-40B4-BE49-F238E27FC236}">
                  <a16:creationId xmlns:a16="http://schemas.microsoft.com/office/drawing/2014/main" id="{A6F62C4A-2B71-4942-A079-9613D26C0CB4}"/>
                </a:ext>
              </a:extLst>
            </p:cNvPr>
            <p:cNvSpPr txBox="1"/>
            <p:nvPr/>
          </p:nvSpPr>
          <p:spPr>
            <a:xfrm>
              <a:off x="5252641" y="578900"/>
              <a:ext cx="8586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IFN-I score</a:t>
              </a:r>
            </a:p>
          </p:txBody>
        </p:sp>
      </p:grpSp>
      <p:grpSp>
        <p:nvGrpSpPr>
          <p:cNvPr id="219" name="Groupe 218">
            <a:extLst>
              <a:ext uri="{FF2B5EF4-FFF2-40B4-BE49-F238E27FC236}">
                <a16:creationId xmlns:a16="http://schemas.microsoft.com/office/drawing/2014/main" id="{436B9814-2975-4181-A7A8-21F382174589}"/>
              </a:ext>
            </a:extLst>
          </p:cNvPr>
          <p:cNvGrpSpPr/>
          <p:nvPr/>
        </p:nvGrpSpPr>
        <p:grpSpPr>
          <a:xfrm>
            <a:off x="5397241" y="4559778"/>
            <a:ext cx="966611" cy="607584"/>
            <a:chOff x="5245021" y="578900"/>
            <a:chExt cx="966611" cy="607584"/>
          </a:xfrm>
        </p:grpSpPr>
        <p:grpSp>
          <p:nvGrpSpPr>
            <p:cNvPr id="220" name="Groupe 219">
              <a:extLst>
                <a:ext uri="{FF2B5EF4-FFF2-40B4-BE49-F238E27FC236}">
                  <a16:creationId xmlns:a16="http://schemas.microsoft.com/office/drawing/2014/main" id="{92A9F819-064B-42FE-B766-ED52783AEE25}"/>
                </a:ext>
              </a:extLst>
            </p:cNvPr>
            <p:cNvGrpSpPr/>
            <p:nvPr/>
          </p:nvGrpSpPr>
          <p:grpSpPr>
            <a:xfrm>
              <a:off x="5320327" y="756783"/>
              <a:ext cx="813194" cy="276999"/>
              <a:chOff x="5320327" y="756783"/>
              <a:chExt cx="813194" cy="276999"/>
            </a:xfrm>
          </p:grpSpPr>
          <p:sp>
            <p:nvSpPr>
              <p:cNvPr id="225" name="ZoneTexte 224">
                <a:extLst>
                  <a:ext uri="{FF2B5EF4-FFF2-40B4-BE49-F238E27FC236}">
                    <a16:creationId xmlns:a16="http://schemas.microsoft.com/office/drawing/2014/main" id="{91CA221A-2980-4584-90CB-A4E00BA2251E}"/>
                  </a:ext>
                </a:extLst>
              </p:cNvPr>
              <p:cNvSpPr txBox="1"/>
              <p:nvPr/>
            </p:nvSpPr>
            <p:spPr>
              <a:xfrm>
                <a:off x="5399987" y="756783"/>
                <a:ext cx="7335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err="1">
                    <a:cs typeface="Times New Roman" panose="02020603050405020304" pitchFamily="18" charset="0"/>
                  </a:rPr>
                  <a:t>Negative</a:t>
                </a:r>
                <a:endParaRPr lang="fr-FR" sz="1200" dirty="0"/>
              </a:p>
            </p:txBody>
          </p:sp>
          <p:sp>
            <p:nvSpPr>
              <p:cNvPr id="226" name="Ellipse 225">
                <a:extLst>
                  <a:ext uri="{FF2B5EF4-FFF2-40B4-BE49-F238E27FC236}">
                    <a16:creationId xmlns:a16="http://schemas.microsoft.com/office/drawing/2014/main" id="{9AECB59A-1A83-48E5-B1E6-27B81753755A}"/>
                  </a:ext>
                </a:extLst>
              </p:cNvPr>
              <p:cNvSpPr/>
              <p:nvPr/>
            </p:nvSpPr>
            <p:spPr>
              <a:xfrm>
                <a:off x="5320327" y="841282"/>
                <a:ext cx="108000" cy="108000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21" name="Groupe 220">
              <a:extLst>
                <a:ext uri="{FF2B5EF4-FFF2-40B4-BE49-F238E27FC236}">
                  <a16:creationId xmlns:a16="http://schemas.microsoft.com/office/drawing/2014/main" id="{28D5CF0A-BDB6-4B12-96B9-C475F97F997F}"/>
                </a:ext>
              </a:extLst>
            </p:cNvPr>
            <p:cNvGrpSpPr/>
            <p:nvPr/>
          </p:nvGrpSpPr>
          <p:grpSpPr>
            <a:xfrm>
              <a:off x="5323580" y="909485"/>
              <a:ext cx="747040" cy="276999"/>
              <a:chOff x="5323580" y="909485"/>
              <a:chExt cx="747040" cy="276999"/>
            </a:xfrm>
          </p:grpSpPr>
          <p:sp>
            <p:nvSpPr>
              <p:cNvPr id="223" name="ZoneTexte 222">
                <a:extLst>
                  <a:ext uri="{FF2B5EF4-FFF2-40B4-BE49-F238E27FC236}">
                    <a16:creationId xmlns:a16="http://schemas.microsoft.com/office/drawing/2014/main" id="{0396D86A-B3CD-46CF-A9C3-C6D2ADB7E691}"/>
                  </a:ext>
                </a:extLst>
              </p:cNvPr>
              <p:cNvSpPr txBox="1"/>
              <p:nvPr/>
            </p:nvSpPr>
            <p:spPr>
              <a:xfrm>
                <a:off x="5399987" y="909485"/>
                <a:ext cx="6706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Positive</a:t>
                </a:r>
                <a:endParaRPr lang="fr-FR" sz="1200" dirty="0"/>
              </a:p>
            </p:txBody>
          </p:sp>
          <p:sp>
            <p:nvSpPr>
              <p:cNvPr id="224" name="Ellipse 223">
                <a:extLst>
                  <a:ext uri="{FF2B5EF4-FFF2-40B4-BE49-F238E27FC236}">
                    <a16:creationId xmlns:a16="http://schemas.microsoft.com/office/drawing/2014/main" id="{54F18C33-D62A-433C-9A16-1BFF17BB4E64}"/>
                  </a:ext>
                </a:extLst>
              </p:cNvPr>
              <p:cNvSpPr/>
              <p:nvPr/>
            </p:nvSpPr>
            <p:spPr>
              <a:xfrm>
                <a:off x="5323580" y="99398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222" name="ZoneTexte 221">
              <a:extLst>
                <a:ext uri="{FF2B5EF4-FFF2-40B4-BE49-F238E27FC236}">
                  <a16:creationId xmlns:a16="http://schemas.microsoft.com/office/drawing/2014/main" id="{ADDFA47E-A4E0-4AEE-A1DE-7CF8E201EC90}"/>
                </a:ext>
              </a:extLst>
            </p:cNvPr>
            <p:cNvSpPr txBox="1"/>
            <p:nvPr/>
          </p:nvSpPr>
          <p:spPr>
            <a:xfrm>
              <a:off x="5245021" y="578900"/>
              <a:ext cx="966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Viral culture</a:t>
              </a:r>
            </a:p>
          </p:txBody>
        </p:sp>
      </p:grpSp>
      <p:grpSp>
        <p:nvGrpSpPr>
          <p:cNvPr id="227" name="Groupe 226">
            <a:extLst>
              <a:ext uri="{FF2B5EF4-FFF2-40B4-BE49-F238E27FC236}">
                <a16:creationId xmlns:a16="http://schemas.microsoft.com/office/drawing/2014/main" id="{4829B8E0-4ADB-426F-A173-33DD0AB05812}"/>
              </a:ext>
            </a:extLst>
          </p:cNvPr>
          <p:cNvGrpSpPr/>
          <p:nvPr/>
        </p:nvGrpSpPr>
        <p:grpSpPr>
          <a:xfrm>
            <a:off x="11876299" y="512186"/>
            <a:ext cx="966611" cy="607584"/>
            <a:chOff x="5245021" y="578900"/>
            <a:chExt cx="966611" cy="607584"/>
          </a:xfrm>
        </p:grpSpPr>
        <p:grpSp>
          <p:nvGrpSpPr>
            <p:cNvPr id="228" name="Groupe 227">
              <a:extLst>
                <a:ext uri="{FF2B5EF4-FFF2-40B4-BE49-F238E27FC236}">
                  <a16:creationId xmlns:a16="http://schemas.microsoft.com/office/drawing/2014/main" id="{329AD323-68C9-4AA2-911F-18943757426F}"/>
                </a:ext>
              </a:extLst>
            </p:cNvPr>
            <p:cNvGrpSpPr/>
            <p:nvPr/>
          </p:nvGrpSpPr>
          <p:grpSpPr>
            <a:xfrm>
              <a:off x="5320327" y="756783"/>
              <a:ext cx="813194" cy="276999"/>
              <a:chOff x="5320327" y="756783"/>
              <a:chExt cx="813194" cy="276999"/>
            </a:xfrm>
          </p:grpSpPr>
          <p:sp>
            <p:nvSpPr>
              <p:cNvPr id="233" name="ZoneTexte 232">
                <a:extLst>
                  <a:ext uri="{FF2B5EF4-FFF2-40B4-BE49-F238E27FC236}">
                    <a16:creationId xmlns:a16="http://schemas.microsoft.com/office/drawing/2014/main" id="{D5867474-C9DF-49D3-9918-4ECA6AD03276}"/>
                  </a:ext>
                </a:extLst>
              </p:cNvPr>
              <p:cNvSpPr txBox="1"/>
              <p:nvPr/>
            </p:nvSpPr>
            <p:spPr>
              <a:xfrm>
                <a:off x="5399987" y="756783"/>
                <a:ext cx="7335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err="1">
                    <a:cs typeface="Times New Roman" panose="02020603050405020304" pitchFamily="18" charset="0"/>
                  </a:rPr>
                  <a:t>Negative</a:t>
                </a:r>
                <a:endParaRPr lang="fr-FR" sz="1200" dirty="0"/>
              </a:p>
            </p:txBody>
          </p:sp>
          <p:sp>
            <p:nvSpPr>
              <p:cNvPr id="234" name="Ellipse 233">
                <a:extLst>
                  <a:ext uri="{FF2B5EF4-FFF2-40B4-BE49-F238E27FC236}">
                    <a16:creationId xmlns:a16="http://schemas.microsoft.com/office/drawing/2014/main" id="{92264006-670A-4D40-A641-8681489F6B59}"/>
                  </a:ext>
                </a:extLst>
              </p:cNvPr>
              <p:cNvSpPr/>
              <p:nvPr/>
            </p:nvSpPr>
            <p:spPr>
              <a:xfrm>
                <a:off x="5320327" y="841282"/>
                <a:ext cx="108000" cy="108000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29" name="Groupe 228">
              <a:extLst>
                <a:ext uri="{FF2B5EF4-FFF2-40B4-BE49-F238E27FC236}">
                  <a16:creationId xmlns:a16="http://schemas.microsoft.com/office/drawing/2014/main" id="{59D3AC7A-D669-45F6-90F6-7984DA038148}"/>
                </a:ext>
              </a:extLst>
            </p:cNvPr>
            <p:cNvGrpSpPr/>
            <p:nvPr/>
          </p:nvGrpSpPr>
          <p:grpSpPr>
            <a:xfrm>
              <a:off x="5323580" y="909485"/>
              <a:ext cx="747040" cy="276999"/>
              <a:chOff x="5323580" y="909485"/>
              <a:chExt cx="747040" cy="276999"/>
            </a:xfrm>
          </p:grpSpPr>
          <p:sp>
            <p:nvSpPr>
              <p:cNvPr id="231" name="ZoneTexte 230">
                <a:extLst>
                  <a:ext uri="{FF2B5EF4-FFF2-40B4-BE49-F238E27FC236}">
                    <a16:creationId xmlns:a16="http://schemas.microsoft.com/office/drawing/2014/main" id="{98F5EAD7-CB1E-489B-B59E-7D8FD6207537}"/>
                  </a:ext>
                </a:extLst>
              </p:cNvPr>
              <p:cNvSpPr txBox="1"/>
              <p:nvPr/>
            </p:nvSpPr>
            <p:spPr>
              <a:xfrm>
                <a:off x="5399987" y="909485"/>
                <a:ext cx="6706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Positive</a:t>
                </a:r>
                <a:endParaRPr lang="fr-FR" sz="1200" dirty="0"/>
              </a:p>
            </p:txBody>
          </p:sp>
          <p:sp>
            <p:nvSpPr>
              <p:cNvPr id="232" name="Ellipse 231">
                <a:extLst>
                  <a:ext uri="{FF2B5EF4-FFF2-40B4-BE49-F238E27FC236}">
                    <a16:creationId xmlns:a16="http://schemas.microsoft.com/office/drawing/2014/main" id="{3123BBBD-3377-414C-AD24-A12EAC1571CF}"/>
                  </a:ext>
                </a:extLst>
              </p:cNvPr>
              <p:cNvSpPr/>
              <p:nvPr/>
            </p:nvSpPr>
            <p:spPr>
              <a:xfrm>
                <a:off x="5323580" y="99398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230" name="ZoneTexte 229">
              <a:extLst>
                <a:ext uri="{FF2B5EF4-FFF2-40B4-BE49-F238E27FC236}">
                  <a16:creationId xmlns:a16="http://schemas.microsoft.com/office/drawing/2014/main" id="{7C35CCB6-F29D-41C3-9CE0-773F044C0608}"/>
                </a:ext>
              </a:extLst>
            </p:cNvPr>
            <p:cNvSpPr txBox="1"/>
            <p:nvPr/>
          </p:nvSpPr>
          <p:spPr>
            <a:xfrm>
              <a:off x="5245021" y="578900"/>
              <a:ext cx="966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Viral culture</a:t>
              </a:r>
            </a:p>
          </p:txBody>
        </p:sp>
      </p:grpSp>
      <p:grpSp>
        <p:nvGrpSpPr>
          <p:cNvPr id="57" name="Groupe 56">
            <a:extLst>
              <a:ext uri="{FF2B5EF4-FFF2-40B4-BE49-F238E27FC236}">
                <a16:creationId xmlns:a16="http://schemas.microsoft.com/office/drawing/2014/main" id="{4655CD32-EDFB-4F6C-8BD7-452CADFADA26}"/>
              </a:ext>
            </a:extLst>
          </p:cNvPr>
          <p:cNvGrpSpPr/>
          <p:nvPr/>
        </p:nvGrpSpPr>
        <p:grpSpPr>
          <a:xfrm>
            <a:off x="11879446" y="4559778"/>
            <a:ext cx="1382557" cy="954609"/>
            <a:chOff x="11861056" y="4688977"/>
            <a:chExt cx="1382557" cy="954609"/>
          </a:xfrm>
        </p:grpSpPr>
        <p:grpSp>
          <p:nvGrpSpPr>
            <p:cNvPr id="243" name="Groupe 242">
              <a:extLst>
                <a:ext uri="{FF2B5EF4-FFF2-40B4-BE49-F238E27FC236}">
                  <a16:creationId xmlns:a16="http://schemas.microsoft.com/office/drawing/2014/main" id="{F075C82A-3A64-42B3-8055-7BB3A8A08258}"/>
                </a:ext>
              </a:extLst>
            </p:cNvPr>
            <p:cNvGrpSpPr/>
            <p:nvPr/>
          </p:nvGrpSpPr>
          <p:grpSpPr>
            <a:xfrm>
              <a:off x="11861056" y="4688977"/>
              <a:ext cx="1211765" cy="276999"/>
              <a:chOff x="5320327" y="756783"/>
              <a:chExt cx="1211765" cy="276999"/>
            </a:xfrm>
          </p:grpSpPr>
          <p:sp>
            <p:nvSpPr>
              <p:cNvPr id="244" name="ZoneTexte 243">
                <a:extLst>
                  <a:ext uri="{FF2B5EF4-FFF2-40B4-BE49-F238E27FC236}">
                    <a16:creationId xmlns:a16="http://schemas.microsoft.com/office/drawing/2014/main" id="{74CB35B9-0156-4A82-A876-4302802BD3F6}"/>
                  </a:ext>
                </a:extLst>
              </p:cNvPr>
              <p:cNvSpPr txBox="1"/>
              <p:nvPr/>
            </p:nvSpPr>
            <p:spPr>
              <a:xfrm>
                <a:off x="5399987" y="756783"/>
                <a:ext cx="11321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Nasal viral </a:t>
                </a:r>
                <a:r>
                  <a:rPr lang="fr-FR" sz="1200" dirty="0" err="1">
                    <a:cs typeface="Times New Roman" panose="02020603050405020304" pitchFamily="18" charset="0"/>
                  </a:rPr>
                  <a:t>load</a:t>
                </a:r>
                <a:endParaRPr lang="fr-FR" sz="1200" dirty="0"/>
              </a:p>
            </p:txBody>
          </p:sp>
          <p:sp>
            <p:nvSpPr>
              <p:cNvPr id="245" name="Ellipse 244">
                <a:extLst>
                  <a:ext uri="{FF2B5EF4-FFF2-40B4-BE49-F238E27FC236}">
                    <a16:creationId xmlns:a16="http://schemas.microsoft.com/office/drawing/2014/main" id="{399247B3-51AF-4782-BD16-7E77DE3976F3}"/>
                  </a:ext>
                </a:extLst>
              </p:cNvPr>
              <p:cNvSpPr/>
              <p:nvPr/>
            </p:nvSpPr>
            <p:spPr>
              <a:xfrm>
                <a:off x="5320327" y="84128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36" name="Groupe 235">
              <a:extLst>
                <a:ext uri="{FF2B5EF4-FFF2-40B4-BE49-F238E27FC236}">
                  <a16:creationId xmlns:a16="http://schemas.microsoft.com/office/drawing/2014/main" id="{3806C09D-3481-47C4-8EE4-318E623FC9E1}"/>
                </a:ext>
              </a:extLst>
            </p:cNvPr>
            <p:cNvGrpSpPr/>
            <p:nvPr/>
          </p:nvGrpSpPr>
          <p:grpSpPr>
            <a:xfrm>
              <a:off x="11861057" y="4843115"/>
              <a:ext cx="1306150" cy="276999"/>
              <a:chOff x="5320327" y="756783"/>
              <a:chExt cx="1306150" cy="276999"/>
            </a:xfrm>
          </p:grpSpPr>
          <p:sp>
            <p:nvSpPr>
              <p:cNvPr id="241" name="ZoneTexte 240">
                <a:extLst>
                  <a:ext uri="{FF2B5EF4-FFF2-40B4-BE49-F238E27FC236}">
                    <a16:creationId xmlns:a16="http://schemas.microsoft.com/office/drawing/2014/main" id="{F7703EEC-CB88-4BD7-8A6A-5A8351D30E7C}"/>
                  </a:ext>
                </a:extLst>
              </p:cNvPr>
              <p:cNvSpPr txBox="1"/>
              <p:nvPr/>
            </p:nvSpPr>
            <p:spPr>
              <a:xfrm>
                <a:off x="5399987" y="756783"/>
                <a:ext cx="12264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cs typeface="Times New Roman" panose="02020603050405020304" pitchFamily="18" charset="0"/>
                  </a:rPr>
                  <a:t>Nasal IFN-I score</a:t>
                </a:r>
                <a:endParaRPr lang="fr-FR" sz="1200" dirty="0"/>
              </a:p>
            </p:txBody>
          </p:sp>
          <p:sp>
            <p:nvSpPr>
              <p:cNvPr id="242" name="Ellipse 241">
                <a:extLst>
                  <a:ext uri="{FF2B5EF4-FFF2-40B4-BE49-F238E27FC236}">
                    <a16:creationId xmlns:a16="http://schemas.microsoft.com/office/drawing/2014/main" id="{1E98DB3D-7F6A-4FD1-9CC1-10C3731C7479}"/>
                  </a:ext>
                </a:extLst>
              </p:cNvPr>
              <p:cNvSpPr/>
              <p:nvPr/>
            </p:nvSpPr>
            <p:spPr>
              <a:xfrm>
                <a:off x="5320327" y="841282"/>
                <a:ext cx="108000" cy="108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37" name="Groupe 236">
              <a:extLst>
                <a:ext uri="{FF2B5EF4-FFF2-40B4-BE49-F238E27FC236}">
                  <a16:creationId xmlns:a16="http://schemas.microsoft.com/office/drawing/2014/main" id="{C00A6DA1-DE34-4653-A9A1-BE2FF4F8C1FF}"/>
                </a:ext>
              </a:extLst>
            </p:cNvPr>
            <p:cNvGrpSpPr/>
            <p:nvPr/>
          </p:nvGrpSpPr>
          <p:grpSpPr>
            <a:xfrm>
              <a:off x="11864311" y="4997255"/>
              <a:ext cx="1379302" cy="646331"/>
              <a:chOff x="5323580" y="909485"/>
              <a:chExt cx="1379302" cy="646331"/>
            </a:xfrm>
          </p:grpSpPr>
          <p:sp>
            <p:nvSpPr>
              <p:cNvPr id="239" name="ZoneTexte 238">
                <a:extLst>
                  <a:ext uri="{FF2B5EF4-FFF2-40B4-BE49-F238E27FC236}">
                    <a16:creationId xmlns:a16="http://schemas.microsoft.com/office/drawing/2014/main" id="{761D8172-54B5-444D-91E0-061386EA3F50}"/>
                  </a:ext>
                </a:extLst>
              </p:cNvPr>
              <p:cNvSpPr txBox="1"/>
              <p:nvPr/>
            </p:nvSpPr>
            <p:spPr>
              <a:xfrm>
                <a:off x="5399987" y="909485"/>
                <a:ext cx="130289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cs typeface="Times New Roman" panose="02020603050405020304" pitchFamily="18" charset="0"/>
                  </a:rPr>
                  <a:t>Combined</a:t>
                </a:r>
                <a:r>
                  <a:rPr lang="fr-FR" sz="1200" dirty="0">
                    <a:cs typeface="Times New Roman" panose="02020603050405020304" pitchFamily="18" charset="0"/>
                  </a:rPr>
                  <a:t> model </a:t>
                </a:r>
              </a:p>
              <a:p>
                <a:r>
                  <a:rPr lang="fr-FR" sz="1200" dirty="0">
                    <a:cs typeface="Times New Roman" panose="02020603050405020304" pitchFamily="18" charset="0"/>
                  </a:rPr>
                  <a:t>(viral </a:t>
                </a:r>
                <a:r>
                  <a:rPr lang="fr-FR" sz="1200" dirty="0" err="1">
                    <a:cs typeface="Times New Roman" panose="02020603050405020304" pitchFamily="18" charset="0"/>
                  </a:rPr>
                  <a:t>load</a:t>
                </a:r>
                <a:r>
                  <a:rPr lang="fr-FR" sz="1200" dirty="0">
                    <a:cs typeface="Times New Roman" panose="02020603050405020304" pitchFamily="18" charset="0"/>
                  </a:rPr>
                  <a:t> and nasal IFN-I score)</a:t>
                </a:r>
                <a:endParaRPr lang="fr-FR" sz="1200" dirty="0"/>
              </a:p>
            </p:txBody>
          </p:sp>
          <p:sp>
            <p:nvSpPr>
              <p:cNvPr id="240" name="Ellipse 239">
                <a:extLst>
                  <a:ext uri="{FF2B5EF4-FFF2-40B4-BE49-F238E27FC236}">
                    <a16:creationId xmlns:a16="http://schemas.microsoft.com/office/drawing/2014/main" id="{9F947A9E-DEC9-4153-B129-B58DE9B207B3}"/>
                  </a:ext>
                </a:extLst>
              </p:cNvPr>
              <p:cNvSpPr/>
              <p:nvPr/>
            </p:nvSpPr>
            <p:spPr>
              <a:xfrm>
                <a:off x="5323580" y="993984"/>
                <a:ext cx="108000" cy="108000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fr-FR"/>
              </a:p>
            </p:txBody>
          </p:sp>
        </p:grpSp>
      </p:grpSp>
      <p:sp>
        <p:nvSpPr>
          <p:cNvPr id="246" name="ZoneTexte 245">
            <a:extLst>
              <a:ext uri="{FF2B5EF4-FFF2-40B4-BE49-F238E27FC236}">
                <a16:creationId xmlns:a16="http://schemas.microsoft.com/office/drawing/2014/main" id="{68A23EC3-3318-4212-B56D-9529D152BF74}"/>
              </a:ext>
            </a:extLst>
          </p:cNvPr>
          <p:cNvSpPr txBox="1"/>
          <p:nvPr/>
        </p:nvSpPr>
        <p:spPr>
          <a:xfrm>
            <a:off x="6532927" y="4931569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SARS-CoV-2</a:t>
            </a:r>
          </a:p>
        </p:txBody>
      </p:sp>
      <p:sp>
        <p:nvSpPr>
          <p:cNvPr id="247" name="ZoneTexte 246">
            <a:extLst>
              <a:ext uri="{FF2B5EF4-FFF2-40B4-BE49-F238E27FC236}">
                <a16:creationId xmlns:a16="http://schemas.microsoft.com/office/drawing/2014/main" id="{8021D71A-BBC8-48CB-A5BB-4C206DF41F88}"/>
              </a:ext>
            </a:extLst>
          </p:cNvPr>
          <p:cNvSpPr txBox="1"/>
          <p:nvPr/>
        </p:nvSpPr>
        <p:spPr>
          <a:xfrm>
            <a:off x="7028125" y="5427957"/>
            <a:ext cx="4220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RSV</a:t>
            </a:r>
          </a:p>
        </p:txBody>
      </p:sp>
      <p:sp>
        <p:nvSpPr>
          <p:cNvPr id="248" name="ZoneTexte 247">
            <a:extLst>
              <a:ext uri="{FF2B5EF4-FFF2-40B4-BE49-F238E27FC236}">
                <a16:creationId xmlns:a16="http://schemas.microsoft.com/office/drawing/2014/main" id="{A82F2809-C19F-4DC6-8378-641888B982E9}"/>
              </a:ext>
            </a:extLst>
          </p:cNvPr>
          <p:cNvSpPr txBox="1"/>
          <p:nvPr/>
        </p:nvSpPr>
        <p:spPr>
          <a:xfrm>
            <a:off x="7058970" y="5925084"/>
            <a:ext cx="39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/>
              <a:t>IBV</a:t>
            </a:r>
          </a:p>
        </p:txBody>
      </p:sp>
      <p:sp>
        <p:nvSpPr>
          <p:cNvPr id="249" name="ZoneTexte 248">
            <a:extLst>
              <a:ext uri="{FF2B5EF4-FFF2-40B4-BE49-F238E27FC236}">
                <a16:creationId xmlns:a16="http://schemas.microsoft.com/office/drawing/2014/main" id="{4A3C65C6-1657-4A41-8B23-23DE6503DFF9}"/>
              </a:ext>
            </a:extLst>
          </p:cNvPr>
          <p:cNvSpPr txBox="1"/>
          <p:nvPr/>
        </p:nvSpPr>
        <p:spPr>
          <a:xfrm>
            <a:off x="7057364" y="6418653"/>
            <a:ext cx="392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IAV</a:t>
            </a:r>
          </a:p>
        </p:txBody>
      </p:sp>
      <p:sp>
        <p:nvSpPr>
          <p:cNvPr id="250" name="ZoneTexte 249">
            <a:extLst>
              <a:ext uri="{FF2B5EF4-FFF2-40B4-BE49-F238E27FC236}">
                <a16:creationId xmlns:a16="http://schemas.microsoft.com/office/drawing/2014/main" id="{EAC7D2EF-76C0-4A10-A426-F793C470D2E6}"/>
              </a:ext>
            </a:extLst>
          </p:cNvPr>
          <p:cNvSpPr txBox="1"/>
          <p:nvPr/>
        </p:nvSpPr>
        <p:spPr>
          <a:xfrm>
            <a:off x="6114225" y="6907800"/>
            <a:ext cx="1335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 virus </a:t>
            </a:r>
            <a:r>
              <a:rPr lang="fr-FR" sz="1200" dirty="0" err="1"/>
              <a:t>combined</a:t>
            </a:r>
            <a:endParaRPr lang="fr-FR" sz="1200" dirty="0"/>
          </a:p>
        </p:txBody>
      </p:sp>
      <p:sp>
        <p:nvSpPr>
          <p:cNvPr id="251" name="ZoneTexte 250">
            <a:extLst>
              <a:ext uri="{FF2B5EF4-FFF2-40B4-BE49-F238E27FC236}">
                <a16:creationId xmlns:a16="http://schemas.microsoft.com/office/drawing/2014/main" id="{4204D376-3AD2-4703-85A0-7F235A060EAA}"/>
              </a:ext>
            </a:extLst>
          </p:cNvPr>
          <p:cNvSpPr txBox="1"/>
          <p:nvPr/>
        </p:nvSpPr>
        <p:spPr>
          <a:xfrm>
            <a:off x="7510693" y="744857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ea typeface="Times New Roman" panose="02020603050405020304" pitchFamily="18" charset="0"/>
              </a:rPr>
              <a:t>0</a:t>
            </a:r>
            <a:r>
              <a:rPr lang="en-GB" sz="1200" dirty="0">
                <a:ea typeface="Times New Roman" panose="02020603050405020304" pitchFamily="18" charset="0"/>
              </a:rPr>
              <a:t>.</a:t>
            </a:r>
            <a:r>
              <a:rPr lang="fr-FR" sz="1200" dirty="0">
                <a:ea typeface="Times New Roman" panose="02020603050405020304" pitchFamily="18" charset="0"/>
              </a:rPr>
              <a:t>7</a:t>
            </a:r>
            <a:endParaRPr lang="fr-FR" sz="1200" dirty="0"/>
          </a:p>
        </p:txBody>
      </p:sp>
      <p:sp>
        <p:nvSpPr>
          <p:cNvPr id="252" name="ZoneTexte 251">
            <a:extLst>
              <a:ext uri="{FF2B5EF4-FFF2-40B4-BE49-F238E27FC236}">
                <a16:creationId xmlns:a16="http://schemas.microsoft.com/office/drawing/2014/main" id="{32DBF0D4-CE71-4BE2-B095-2DC938AA39DE}"/>
              </a:ext>
            </a:extLst>
          </p:cNvPr>
          <p:cNvSpPr txBox="1"/>
          <p:nvPr/>
        </p:nvSpPr>
        <p:spPr>
          <a:xfrm>
            <a:off x="8398581" y="744857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ea typeface="Times New Roman" panose="02020603050405020304" pitchFamily="18" charset="0"/>
              </a:rPr>
              <a:t>0</a:t>
            </a:r>
            <a:r>
              <a:rPr lang="en-GB" sz="1200" dirty="0">
                <a:ea typeface="Times New Roman" panose="02020603050405020304" pitchFamily="18" charset="0"/>
              </a:rPr>
              <a:t>.8</a:t>
            </a:r>
            <a:endParaRPr lang="fr-FR" sz="1200" dirty="0"/>
          </a:p>
        </p:txBody>
      </p:sp>
      <p:sp>
        <p:nvSpPr>
          <p:cNvPr id="253" name="ZoneTexte 252">
            <a:extLst>
              <a:ext uri="{FF2B5EF4-FFF2-40B4-BE49-F238E27FC236}">
                <a16:creationId xmlns:a16="http://schemas.microsoft.com/office/drawing/2014/main" id="{393BA158-12D7-4BD2-9F7C-F21B3420E63A}"/>
              </a:ext>
            </a:extLst>
          </p:cNvPr>
          <p:cNvSpPr txBox="1"/>
          <p:nvPr/>
        </p:nvSpPr>
        <p:spPr>
          <a:xfrm>
            <a:off x="9300366" y="744857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ea typeface="Times New Roman" panose="02020603050405020304" pitchFamily="18" charset="0"/>
              </a:rPr>
              <a:t>0</a:t>
            </a:r>
            <a:r>
              <a:rPr lang="en-GB" sz="1200" dirty="0">
                <a:ea typeface="Times New Roman" panose="02020603050405020304" pitchFamily="18" charset="0"/>
              </a:rPr>
              <a:t>.9</a:t>
            </a:r>
            <a:endParaRPr lang="fr-FR" sz="1200" dirty="0"/>
          </a:p>
        </p:txBody>
      </p:sp>
      <p:sp>
        <p:nvSpPr>
          <p:cNvPr id="254" name="ZoneTexte 253">
            <a:extLst>
              <a:ext uri="{FF2B5EF4-FFF2-40B4-BE49-F238E27FC236}">
                <a16:creationId xmlns:a16="http://schemas.microsoft.com/office/drawing/2014/main" id="{E99DB743-9F04-4F4B-A4EE-D5B60D47C3B0}"/>
              </a:ext>
            </a:extLst>
          </p:cNvPr>
          <p:cNvSpPr txBox="1"/>
          <p:nvPr/>
        </p:nvSpPr>
        <p:spPr>
          <a:xfrm>
            <a:off x="10183119" y="744857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ea typeface="Times New Roman" panose="02020603050405020304" pitchFamily="18" charset="0"/>
              </a:rPr>
              <a:t>1</a:t>
            </a:r>
            <a:r>
              <a:rPr lang="en-GB" sz="1200" dirty="0">
                <a:ea typeface="Times New Roman" panose="02020603050405020304" pitchFamily="18" charset="0"/>
              </a:rPr>
              <a:t>.</a:t>
            </a:r>
            <a:r>
              <a:rPr lang="fr-FR" sz="1200" dirty="0">
                <a:ea typeface="Times New Roman" panose="02020603050405020304" pitchFamily="18" charset="0"/>
              </a:rPr>
              <a:t>0</a:t>
            </a:r>
            <a:endParaRPr lang="fr-FR" sz="1200" dirty="0"/>
          </a:p>
        </p:txBody>
      </p:sp>
      <p:sp>
        <p:nvSpPr>
          <p:cNvPr id="255" name="ZoneTexte 254">
            <a:extLst>
              <a:ext uri="{FF2B5EF4-FFF2-40B4-BE49-F238E27FC236}">
                <a16:creationId xmlns:a16="http://schemas.microsoft.com/office/drawing/2014/main" id="{B33925C2-5BD2-424D-94B2-2B213613FB10}"/>
              </a:ext>
            </a:extLst>
          </p:cNvPr>
          <p:cNvSpPr txBox="1"/>
          <p:nvPr/>
        </p:nvSpPr>
        <p:spPr>
          <a:xfrm>
            <a:off x="8750605" y="7633235"/>
            <a:ext cx="990079" cy="2822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UC (95%CI)</a:t>
            </a:r>
          </a:p>
        </p:txBody>
      </p:sp>
      <p:sp>
        <p:nvSpPr>
          <p:cNvPr id="257" name="Forme libre : forme 256">
            <a:extLst>
              <a:ext uri="{FF2B5EF4-FFF2-40B4-BE49-F238E27FC236}">
                <a16:creationId xmlns:a16="http://schemas.microsoft.com/office/drawing/2014/main" id="{5D3C5BAB-BFA4-4C71-90C8-BD83FCC7B8EE}"/>
              </a:ext>
            </a:extLst>
          </p:cNvPr>
          <p:cNvSpPr/>
          <p:nvPr/>
        </p:nvSpPr>
        <p:spPr>
          <a:xfrm>
            <a:off x="8757941" y="7044620"/>
            <a:ext cx="683345" cy="6586"/>
          </a:xfrm>
          <a:custGeom>
            <a:avLst/>
            <a:gdLst>
              <a:gd name="connsiteX0" fmla="*/ 0 w 1101707"/>
              <a:gd name="connsiteY0" fmla="*/ 0 h 12700"/>
              <a:gd name="connsiteX1" fmla="*/ 1101708 w 1101707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01707" h="12700">
                <a:moveTo>
                  <a:pt x="0" y="0"/>
                </a:moveTo>
                <a:lnTo>
                  <a:pt x="1101708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58" name="Forme libre : forme 257">
            <a:extLst>
              <a:ext uri="{FF2B5EF4-FFF2-40B4-BE49-F238E27FC236}">
                <a16:creationId xmlns:a16="http://schemas.microsoft.com/office/drawing/2014/main" id="{F76F2EE8-B926-4808-BEBF-17506983A1BE}"/>
              </a:ext>
            </a:extLst>
          </p:cNvPr>
          <p:cNvSpPr/>
          <p:nvPr/>
        </p:nvSpPr>
        <p:spPr>
          <a:xfrm>
            <a:off x="8648377" y="5056549"/>
            <a:ext cx="966484" cy="6586"/>
          </a:xfrm>
          <a:custGeom>
            <a:avLst/>
            <a:gdLst>
              <a:gd name="connsiteX0" fmla="*/ 0 w 1558191"/>
              <a:gd name="connsiteY0" fmla="*/ 0 h 12700"/>
              <a:gd name="connsiteX1" fmla="*/ 1558191 w 1558191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558191" h="12700">
                <a:moveTo>
                  <a:pt x="0" y="0"/>
                </a:moveTo>
                <a:lnTo>
                  <a:pt x="1558191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59" name="Forme libre : forme 258">
            <a:extLst>
              <a:ext uri="{FF2B5EF4-FFF2-40B4-BE49-F238E27FC236}">
                <a16:creationId xmlns:a16="http://schemas.microsoft.com/office/drawing/2014/main" id="{7170A8AD-7B9E-4B30-885A-1258D2233C51}"/>
              </a:ext>
            </a:extLst>
          </p:cNvPr>
          <p:cNvSpPr/>
          <p:nvPr/>
        </p:nvSpPr>
        <p:spPr>
          <a:xfrm>
            <a:off x="7838396" y="6547588"/>
            <a:ext cx="2075288" cy="6586"/>
          </a:xfrm>
          <a:custGeom>
            <a:avLst/>
            <a:gdLst>
              <a:gd name="connsiteX0" fmla="*/ 0 w 3345836"/>
              <a:gd name="connsiteY0" fmla="*/ 0 h 12700"/>
              <a:gd name="connsiteX1" fmla="*/ 3345836 w 3345836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45836" h="12700">
                <a:moveTo>
                  <a:pt x="0" y="0"/>
                </a:moveTo>
                <a:lnTo>
                  <a:pt x="3345836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0" name="Forme libre : forme 259">
            <a:extLst>
              <a:ext uri="{FF2B5EF4-FFF2-40B4-BE49-F238E27FC236}">
                <a16:creationId xmlns:a16="http://schemas.microsoft.com/office/drawing/2014/main" id="{E0C8DE60-E313-469D-9261-FAB11803ECF6}"/>
              </a:ext>
            </a:extLst>
          </p:cNvPr>
          <p:cNvSpPr/>
          <p:nvPr/>
        </p:nvSpPr>
        <p:spPr>
          <a:xfrm>
            <a:off x="8137284" y="6050582"/>
            <a:ext cx="2233366" cy="6586"/>
          </a:xfrm>
          <a:custGeom>
            <a:avLst/>
            <a:gdLst>
              <a:gd name="connsiteX0" fmla="*/ 0 w 3600693"/>
              <a:gd name="connsiteY0" fmla="*/ 0 h 12700"/>
              <a:gd name="connsiteX1" fmla="*/ 3600693 w 360069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600693" h="12700">
                <a:moveTo>
                  <a:pt x="0" y="0"/>
                </a:moveTo>
                <a:lnTo>
                  <a:pt x="3600693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1" name="Forme libre : forme 260">
            <a:extLst>
              <a:ext uri="{FF2B5EF4-FFF2-40B4-BE49-F238E27FC236}">
                <a16:creationId xmlns:a16="http://schemas.microsoft.com/office/drawing/2014/main" id="{26C66A4C-F4C2-4B51-BA1A-2B5EA3D22E53}"/>
              </a:ext>
            </a:extLst>
          </p:cNvPr>
          <p:cNvSpPr/>
          <p:nvPr/>
        </p:nvSpPr>
        <p:spPr>
          <a:xfrm>
            <a:off x="7622001" y="5553550"/>
            <a:ext cx="1673522" cy="6586"/>
          </a:xfrm>
          <a:custGeom>
            <a:avLst/>
            <a:gdLst>
              <a:gd name="connsiteX0" fmla="*/ 0 w 2698098"/>
              <a:gd name="connsiteY0" fmla="*/ 0 h 12700"/>
              <a:gd name="connsiteX1" fmla="*/ 2698098 w 2698098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698098" h="12700">
                <a:moveTo>
                  <a:pt x="0" y="0"/>
                </a:moveTo>
                <a:lnTo>
                  <a:pt x="2698098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2" name="Forme libre : forme 261">
            <a:extLst>
              <a:ext uri="{FF2B5EF4-FFF2-40B4-BE49-F238E27FC236}">
                <a16:creationId xmlns:a16="http://schemas.microsoft.com/office/drawing/2014/main" id="{3F2D0820-2AC7-4CED-84EC-7E5B87B29B01}"/>
              </a:ext>
            </a:extLst>
          </p:cNvPr>
          <p:cNvSpPr/>
          <p:nvPr/>
        </p:nvSpPr>
        <p:spPr>
          <a:xfrm>
            <a:off x="9098042" y="6978350"/>
            <a:ext cx="584395" cy="6586"/>
          </a:xfrm>
          <a:custGeom>
            <a:avLst/>
            <a:gdLst>
              <a:gd name="connsiteX0" fmla="*/ 0 w 942178"/>
              <a:gd name="connsiteY0" fmla="*/ 0 h 12700"/>
              <a:gd name="connsiteX1" fmla="*/ 942179 w 942178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42178" h="12700">
                <a:moveTo>
                  <a:pt x="0" y="0"/>
                </a:moveTo>
                <a:lnTo>
                  <a:pt x="942179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3" name="Forme libre : forme 262">
            <a:extLst>
              <a:ext uri="{FF2B5EF4-FFF2-40B4-BE49-F238E27FC236}">
                <a16:creationId xmlns:a16="http://schemas.microsoft.com/office/drawing/2014/main" id="{1EC2BCCC-14EC-48AF-A75C-F5224EBB9932}"/>
              </a:ext>
            </a:extLst>
          </p:cNvPr>
          <p:cNvSpPr/>
          <p:nvPr/>
        </p:nvSpPr>
        <p:spPr>
          <a:xfrm>
            <a:off x="9374480" y="4990281"/>
            <a:ext cx="684266" cy="6586"/>
          </a:xfrm>
          <a:custGeom>
            <a:avLst/>
            <a:gdLst>
              <a:gd name="connsiteX0" fmla="*/ 0 w 1103192"/>
              <a:gd name="connsiteY0" fmla="*/ 0 h 12700"/>
              <a:gd name="connsiteX1" fmla="*/ 1103193 w 1103192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03192" h="12700">
                <a:moveTo>
                  <a:pt x="0" y="0"/>
                </a:moveTo>
                <a:lnTo>
                  <a:pt x="1103193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4" name="Forme libre : forme 263">
            <a:extLst>
              <a:ext uri="{FF2B5EF4-FFF2-40B4-BE49-F238E27FC236}">
                <a16:creationId xmlns:a16="http://schemas.microsoft.com/office/drawing/2014/main" id="{04A387EE-C8F7-4490-AC04-8188F0105843}"/>
              </a:ext>
            </a:extLst>
          </p:cNvPr>
          <p:cNvSpPr/>
          <p:nvPr/>
        </p:nvSpPr>
        <p:spPr>
          <a:xfrm>
            <a:off x="8896262" y="6481318"/>
            <a:ext cx="1474387" cy="6586"/>
          </a:xfrm>
          <a:custGeom>
            <a:avLst/>
            <a:gdLst>
              <a:gd name="connsiteX0" fmla="*/ 0 w 2377047"/>
              <a:gd name="connsiteY0" fmla="*/ 0 h 12700"/>
              <a:gd name="connsiteX1" fmla="*/ 2377048 w 2377047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377047" h="12700">
                <a:moveTo>
                  <a:pt x="0" y="0"/>
                </a:moveTo>
                <a:lnTo>
                  <a:pt x="2377048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5" name="Forme libre : forme 264">
            <a:extLst>
              <a:ext uri="{FF2B5EF4-FFF2-40B4-BE49-F238E27FC236}">
                <a16:creationId xmlns:a16="http://schemas.microsoft.com/office/drawing/2014/main" id="{74284657-6660-4634-B721-52376E3818B5}"/>
              </a:ext>
            </a:extLst>
          </p:cNvPr>
          <p:cNvSpPr/>
          <p:nvPr/>
        </p:nvSpPr>
        <p:spPr>
          <a:xfrm>
            <a:off x="8349277" y="5984318"/>
            <a:ext cx="2021372" cy="6586"/>
          </a:xfrm>
          <a:custGeom>
            <a:avLst/>
            <a:gdLst>
              <a:gd name="connsiteX0" fmla="*/ 0 w 3258911"/>
              <a:gd name="connsiteY0" fmla="*/ 0 h 12700"/>
              <a:gd name="connsiteX1" fmla="*/ 3258912 w 3258911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258911" h="12700">
                <a:moveTo>
                  <a:pt x="0" y="0"/>
                </a:moveTo>
                <a:lnTo>
                  <a:pt x="3258912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6" name="Forme libre : forme 265">
            <a:extLst>
              <a:ext uri="{FF2B5EF4-FFF2-40B4-BE49-F238E27FC236}">
                <a16:creationId xmlns:a16="http://schemas.microsoft.com/office/drawing/2014/main" id="{CB20FF09-69C3-4826-919A-85E1B92EE9BC}"/>
              </a:ext>
            </a:extLst>
          </p:cNvPr>
          <p:cNvSpPr/>
          <p:nvPr/>
        </p:nvSpPr>
        <p:spPr>
          <a:xfrm>
            <a:off x="8628722" y="5487286"/>
            <a:ext cx="1270079" cy="6586"/>
          </a:xfrm>
          <a:custGeom>
            <a:avLst/>
            <a:gdLst>
              <a:gd name="connsiteX0" fmla="*/ 0 w 2047656"/>
              <a:gd name="connsiteY0" fmla="*/ 0 h 12700"/>
              <a:gd name="connsiteX1" fmla="*/ 2047657 w 2047656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047656" h="12700">
                <a:moveTo>
                  <a:pt x="0" y="0"/>
                </a:moveTo>
                <a:lnTo>
                  <a:pt x="2047657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7" name="Forme libre : forme 266">
            <a:extLst>
              <a:ext uri="{FF2B5EF4-FFF2-40B4-BE49-F238E27FC236}">
                <a16:creationId xmlns:a16="http://schemas.microsoft.com/office/drawing/2014/main" id="{9BA13407-8010-4015-93CA-E85EF62DF48E}"/>
              </a:ext>
            </a:extLst>
          </p:cNvPr>
          <p:cNvSpPr/>
          <p:nvPr/>
        </p:nvSpPr>
        <p:spPr>
          <a:xfrm>
            <a:off x="9275160" y="7110884"/>
            <a:ext cx="532779" cy="6586"/>
          </a:xfrm>
          <a:custGeom>
            <a:avLst/>
            <a:gdLst>
              <a:gd name="connsiteX0" fmla="*/ 0 w 858961"/>
              <a:gd name="connsiteY0" fmla="*/ 0 h 12700"/>
              <a:gd name="connsiteX1" fmla="*/ 858961 w 858961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858961" h="12700">
                <a:moveTo>
                  <a:pt x="0" y="0"/>
                </a:moveTo>
                <a:lnTo>
                  <a:pt x="858961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8" name="Forme libre : forme 267">
            <a:extLst>
              <a:ext uri="{FF2B5EF4-FFF2-40B4-BE49-F238E27FC236}">
                <a16:creationId xmlns:a16="http://schemas.microsoft.com/office/drawing/2014/main" id="{1C5BECEF-3A0A-4FE4-8F47-3A7D504EFACA}"/>
              </a:ext>
            </a:extLst>
          </p:cNvPr>
          <p:cNvSpPr/>
          <p:nvPr/>
        </p:nvSpPr>
        <p:spPr>
          <a:xfrm>
            <a:off x="9415726" y="5122816"/>
            <a:ext cx="658926" cy="6586"/>
          </a:xfrm>
          <a:custGeom>
            <a:avLst/>
            <a:gdLst>
              <a:gd name="connsiteX0" fmla="*/ 0 w 1062339"/>
              <a:gd name="connsiteY0" fmla="*/ 0 h 12700"/>
              <a:gd name="connsiteX1" fmla="*/ 1062339 w 1062339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062339" h="12700">
                <a:moveTo>
                  <a:pt x="0" y="0"/>
                </a:moveTo>
                <a:lnTo>
                  <a:pt x="1062339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69" name="Forme libre : forme 268">
            <a:extLst>
              <a:ext uri="{FF2B5EF4-FFF2-40B4-BE49-F238E27FC236}">
                <a16:creationId xmlns:a16="http://schemas.microsoft.com/office/drawing/2014/main" id="{6F803A27-D870-408C-90C2-4DEC43392AF8}"/>
              </a:ext>
            </a:extLst>
          </p:cNvPr>
          <p:cNvSpPr/>
          <p:nvPr/>
        </p:nvSpPr>
        <p:spPr>
          <a:xfrm>
            <a:off x="9183124" y="6613852"/>
            <a:ext cx="1187524" cy="6586"/>
          </a:xfrm>
          <a:custGeom>
            <a:avLst/>
            <a:gdLst>
              <a:gd name="connsiteX0" fmla="*/ 0 w 1914559"/>
              <a:gd name="connsiteY0" fmla="*/ 0 h 12700"/>
              <a:gd name="connsiteX1" fmla="*/ 1914560 w 1914559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14559" h="12700">
                <a:moveTo>
                  <a:pt x="0" y="0"/>
                </a:moveTo>
                <a:lnTo>
                  <a:pt x="1914560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0" name="Forme libre : forme 269">
            <a:extLst>
              <a:ext uri="{FF2B5EF4-FFF2-40B4-BE49-F238E27FC236}">
                <a16:creationId xmlns:a16="http://schemas.microsoft.com/office/drawing/2014/main" id="{3330E3A9-028C-4F01-B1AB-DA43EBE04804}"/>
              </a:ext>
            </a:extLst>
          </p:cNvPr>
          <p:cNvSpPr/>
          <p:nvPr/>
        </p:nvSpPr>
        <p:spPr>
          <a:xfrm>
            <a:off x="9283767" y="6116853"/>
            <a:ext cx="1086882" cy="6586"/>
          </a:xfrm>
          <a:custGeom>
            <a:avLst/>
            <a:gdLst>
              <a:gd name="connsiteX0" fmla="*/ 0 w 1752301"/>
              <a:gd name="connsiteY0" fmla="*/ 0 h 12700"/>
              <a:gd name="connsiteX1" fmla="*/ 1752301 w 1752301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752301" h="12700">
                <a:moveTo>
                  <a:pt x="0" y="0"/>
                </a:moveTo>
                <a:lnTo>
                  <a:pt x="1752301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1" name="Forme libre : forme 270">
            <a:extLst>
              <a:ext uri="{FF2B5EF4-FFF2-40B4-BE49-F238E27FC236}">
                <a16:creationId xmlns:a16="http://schemas.microsoft.com/office/drawing/2014/main" id="{B047B7F4-6602-4A04-9A0A-B6057B837459}"/>
              </a:ext>
            </a:extLst>
          </p:cNvPr>
          <p:cNvSpPr/>
          <p:nvPr/>
        </p:nvSpPr>
        <p:spPr>
          <a:xfrm>
            <a:off x="8910507" y="5619847"/>
            <a:ext cx="1062055" cy="6586"/>
          </a:xfrm>
          <a:custGeom>
            <a:avLst/>
            <a:gdLst>
              <a:gd name="connsiteX0" fmla="*/ 0 w 1712273"/>
              <a:gd name="connsiteY0" fmla="*/ 0 h 12700"/>
              <a:gd name="connsiteX1" fmla="*/ 1712273 w 171227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712273" h="12700">
                <a:moveTo>
                  <a:pt x="0" y="0"/>
                </a:moveTo>
                <a:lnTo>
                  <a:pt x="1712273" y="0"/>
                </a:lnTo>
              </a:path>
            </a:pathLst>
          </a:custGeom>
          <a:noFill/>
          <a:ln w="3175" cap="flat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2" name="Forme libre : forme 271">
            <a:extLst>
              <a:ext uri="{FF2B5EF4-FFF2-40B4-BE49-F238E27FC236}">
                <a16:creationId xmlns:a16="http://schemas.microsoft.com/office/drawing/2014/main" id="{B3BAD5BE-1692-4E3E-97F8-F3696FFA8EB4}"/>
              </a:ext>
            </a:extLst>
          </p:cNvPr>
          <p:cNvSpPr/>
          <p:nvPr/>
        </p:nvSpPr>
        <p:spPr>
          <a:xfrm>
            <a:off x="9064522" y="6990976"/>
            <a:ext cx="108000" cy="108000"/>
          </a:xfrm>
          <a:custGeom>
            <a:avLst/>
            <a:gdLst>
              <a:gd name="connsiteX0" fmla="*/ 72198 w 72198"/>
              <a:gd name="connsiteY0" fmla="*/ 36100 h 72189"/>
              <a:gd name="connsiteX1" fmla="*/ 0 w 72198"/>
              <a:gd name="connsiteY1" fmla="*/ 36100 h 72189"/>
              <a:gd name="connsiteX2" fmla="*/ 72198 w 72198"/>
              <a:gd name="connsiteY2" fmla="*/ 36100 h 721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98" h="72189">
                <a:moveTo>
                  <a:pt x="72198" y="36100"/>
                </a:moveTo>
                <a:cubicBezTo>
                  <a:pt x="72198" y="84220"/>
                  <a:pt x="0" y="84220"/>
                  <a:pt x="0" y="36100"/>
                </a:cubicBezTo>
                <a:cubicBezTo>
                  <a:pt x="0" y="-12033"/>
                  <a:pt x="72198" y="-12033"/>
                  <a:pt x="72198" y="36100"/>
                </a:cubicBezTo>
              </a:path>
            </a:pathLst>
          </a:custGeom>
          <a:solidFill>
            <a:schemeClr val="bg1">
              <a:lumMod val="65000"/>
            </a:schemeClr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3" name="Forme libre : forme 272">
            <a:extLst>
              <a:ext uri="{FF2B5EF4-FFF2-40B4-BE49-F238E27FC236}">
                <a16:creationId xmlns:a16="http://schemas.microsoft.com/office/drawing/2014/main" id="{FAF3BB11-9429-4DA2-9772-3CD582E2BC87}"/>
              </a:ext>
            </a:extLst>
          </p:cNvPr>
          <p:cNvSpPr/>
          <p:nvPr/>
        </p:nvSpPr>
        <p:spPr>
          <a:xfrm>
            <a:off x="9096540" y="5002909"/>
            <a:ext cx="108000" cy="108000"/>
          </a:xfrm>
          <a:custGeom>
            <a:avLst/>
            <a:gdLst>
              <a:gd name="connsiteX0" fmla="*/ 72160 w 72159"/>
              <a:gd name="connsiteY0" fmla="*/ 36090 h 72181"/>
              <a:gd name="connsiteX1" fmla="*/ 0 w 72159"/>
              <a:gd name="connsiteY1" fmla="*/ 36090 h 72181"/>
              <a:gd name="connsiteX2" fmla="*/ 72160 w 72159"/>
              <a:gd name="connsiteY2" fmla="*/ 36090 h 721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181">
                <a:moveTo>
                  <a:pt x="72160" y="36090"/>
                </a:moveTo>
                <a:cubicBezTo>
                  <a:pt x="72160" y="84212"/>
                  <a:pt x="0" y="84212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bg1">
              <a:lumMod val="65000"/>
            </a:schemeClr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4" name="Forme libre : forme 273">
            <a:extLst>
              <a:ext uri="{FF2B5EF4-FFF2-40B4-BE49-F238E27FC236}">
                <a16:creationId xmlns:a16="http://schemas.microsoft.com/office/drawing/2014/main" id="{EE47CAFB-D7D6-47ED-8893-B1CB6332B41E}"/>
              </a:ext>
            </a:extLst>
          </p:cNvPr>
          <p:cNvSpPr/>
          <p:nvPr/>
        </p:nvSpPr>
        <p:spPr>
          <a:xfrm>
            <a:off x="8840962" y="6493949"/>
            <a:ext cx="108000" cy="108000"/>
          </a:xfrm>
          <a:custGeom>
            <a:avLst/>
            <a:gdLst>
              <a:gd name="connsiteX0" fmla="*/ 72160 w 72159"/>
              <a:gd name="connsiteY0" fmla="*/ 36090 h 72218"/>
              <a:gd name="connsiteX1" fmla="*/ 0 w 72159"/>
              <a:gd name="connsiteY1" fmla="*/ 36090 h 72218"/>
              <a:gd name="connsiteX2" fmla="*/ 72160 w 72159"/>
              <a:gd name="connsiteY2" fmla="*/ 36090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218">
                <a:moveTo>
                  <a:pt x="72160" y="36090"/>
                </a:moveTo>
                <a:cubicBezTo>
                  <a:pt x="72160" y="84261"/>
                  <a:pt x="0" y="84261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bg1">
              <a:lumMod val="65000"/>
            </a:schemeClr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5" name="Forme libre : forme 274">
            <a:extLst>
              <a:ext uri="{FF2B5EF4-FFF2-40B4-BE49-F238E27FC236}">
                <a16:creationId xmlns:a16="http://schemas.microsoft.com/office/drawing/2014/main" id="{3354A9E3-3746-4F58-85C9-23E2625331A5}"/>
              </a:ext>
            </a:extLst>
          </p:cNvPr>
          <p:cNvSpPr/>
          <p:nvPr/>
        </p:nvSpPr>
        <p:spPr>
          <a:xfrm>
            <a:off x="9526897" y="5996943"/>
            <a:ext cx="108000" cy="108000"/>
          </a:xfrm>
          <a:custGeom>
            <a:avLst/>
            <a:gdLst>
              <a:gd name="connsiteX0" fmla="*/ 72147 w 72147"/>
              <a:gd name="connsiteY0" fmla="*/ 36090 h 72180"/>
              <a:gd name="connsiteX1" fmla="*/ 0 w 72147"/>
              <a:gd name="connsiteY1" fmla="*/ 36090 h 72180"/>
              <a:gd name="connsiteX2" fmla="*/ 72147 w 72147"/>
              <a:gd name="connsiteY2" fmla="*/ 36090 h 721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47" h="72180">
                <a:moveTo>
                  <a:pt x="72147" y="36090"/>
                </a:moveTo>
                <a:cubicBezTo>
                  <a:pt x="72147" y="84211"/>
                  <a:pt x="0" y="84211"/>
                  <a:pt x="0" y="36090"/>
                </a:cubicBezTo>
                <a:cubicBezTo>
                  <a:pt x="0" y="-12030"/>
                  <a:pt x="72147" y="-12030"/>
                  <a:pt x="72147" y="36090"/>
                </a:cubicBezTo>
              </a:path>
            </a:pathLst>
          </a:custGeom>
          <a:solidFill>
            <a:schemeClr val="bg1">
              <a:lumMod val="65000"/>
            </a:schemeClr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6" name="Forme libre : forme 275">
            <a:extLst>
              <a:ext uri="{FF2B5EF4-FFF2-40B4-BE49-F238E27FC236}">
                <a16:creationId xmlns:a16="http://schemas.microsoft.com/office/drawing/2014/main" id="{505C8F93-D813-4A76-B0EE-33A5AB53892E}"/>
              </a:ext>
            </a:extLst>
          </p:cNvPr>
          <p:cNvSpPr/>
          <p:nvPr/>
        </p:nvSpPr>
        <p:spPr>
          <a:xfrm>
            <a:off x="8423683" y="5499910"/>
            <a:ext cx="108000" cy="108000"/>
          </a:xfrm>
          <a:custGeom>
            <a:avLst/>
            <a:gdLst>
              <a:gd name="connsiteX0" fmla="*/ 72160 w 72159"/>
              <a:gd name="connsiteY0" fmla="*/ 36090 h 72218"/>
              <a:gd name="connsiteX1" fmla="*/ 0 w 72159"/>
              <a:gd name="connsiteY1" fmla="*/ 36090 h 72218"/>
              <a:gd name="connsiteX2" fmla="*/ 72160 w 72159"/>
              <a:gd name="connsiteY2" fmla="*/ 36090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218">
                <a:moveTo>
                  <a:pt x="72160" y="36090"/>
                </a:moveTo>
                <a:cubicBezTo>
                  <a:pt x="72160" y="84261"/>
                  <a:pt x="0" y="84261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bg1">
              <a:lumMod val="65000"/>
            </a:schemeClr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7" name="Forme libre : forme 276">
            <a:extLst>
              <a:ext uri="{FF2B5EF4-FFF2-40B4-BE49-F238E27FC236}">
                <a16:creationId xmlns:a16="http://schemas.microsoft.com/office/drawing/2014/main" id="{FF70C809-F7D0-40E4-8D38-1760D89C1158}"/>
              </a:ext>
            </a:extLst>
          </p:cNvPr>
          <p:cNvSpPr/>
          <p:nvPr/>
        </p:nvSpPr>
        <p:spPr>
          <a:xfrm>
            <a:off x="9355165" y="6924691"/>
            <a:ext cx="108000" cy="108000"/>
          </a:xfrm>
          <a:custGeom>
            <a:avLst/>
            <a:gdLst>
              <a:gd name="connsiteX0" fmla="*/ 72160 w 72159"/>
              <a:gd name="connsiteY0" fmla="*/ 36128 h 72218"/>
              <a:gd name="connsiteX1" fmla="*/ 0 w 72159"/>
              <a:gd name="connsiteY1" fmla="*/ 36128 h 72218"/>
              <a:gd name="connsiteX2" fmla="*/ 72160 w 72159"/>
              <a:gd name="connsiteY2" fmla="*/ 36128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218">
                <a:moveTo>
                  <a:pt x="72160" y="36128"/>
                </a:moveTo>
                <a:cubicBezTo>
                  <a:pt x="72160" y="84249"/>
                  <a:pt x="0" y="84249"/>
                  <a:pt x="0" y="36128"/>
                </a:cubicBezTo>
                <a:cubicBezTo>
                  <a:pt x="0" y="-12043"/>
                  <a:pt x="72160" y="-12043"/>
                  <a:pt x="72160" y="36128"/>
                </a:cubicBezTo>
              </a:path>
            </a:pathLst>
          </a:custGeom>
          <a:solidFill>
            <a:schemeClr val="tx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78" name="Forme libre : forme 277">
            <a:extLst>
              <a:ext uri="{FF2B5EF4-FFF2-40B4-BE49-F238E27FC236}">
                <a16:creationId xmlns:a16="http://schemas.microsoft.com/office/drawing/2014/main" id="{2A6A3BC9-9398-4B41-8B8A-C2EE43961564}"/>
              </a:ext>
            </a:extLst>
          </p:cNvPr>
          <p:cNvSpPr/>
          <p:nvPr/>
        </p:nvSpPr>
        <p:spPr>
          <a:xfrm>
            <a:off x="9681550" y="4936642"/>
            <a:ext cx="108000" cy="108000"/>
          </a:xfrm>
          <a:custGeom>
            <a:avLst/>
            <a:gdLst>
              <a:gd name="connsiteX0" fmla="*/ 72160 w 72159"/>
              <a:gd name="connsiteY0" fmla="*/ 36090 h 72181"/>
              <a:gd name="connsiteX1" fmla="*/ 0 w 72159"/>
              <a:gd name="connsiteY1" fmla="*/ 36090 h 72181"/>
              <a:gd name="connsiteX2" fmla="*/ 72160 w 72159"/>
              <a:gd name="connsiteY2" fmla="*/ 36090 h 721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181">
                <a:moveTo>
                  <a:pt x="72160" y="36090"/>
                </a:moveTo>
                <a:cubicBezTo>
                  <a:pt x="72160" y="84212"/>
                  <a:pt x="0" y="84212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tx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83" name="Forme libre : forme 282">
            <a:extLst>
              <a:ext uri="{FF2B5EF4-FFF2-40B4-BE49-F238E27FC236}">
                <a16:creationId xmlns:a16="http://schemas.microsoft.com/office/drawing/2014/main" id="{B0E00F20-7DE6-422B-A240-910AA2E19496}"/>
              </a:ext>
            </a:extLst>
          </p:cNvPr>
          <p:cNvSpPr/>
          <p:nvPr/>
        </p:nvSpPr>
        <p:spPr>
          <a:xfrm>
            <a:off x="9612373" y="6427678"/>
            <a:ext cx="108000" cy="108000"/>
          </a:xfrm>
          <a:custGeom>
            <a:avLst/>
            <a:gdLst>
              <a:gd name="connsiteX0" fmla="*/ 72160 w 72159"/>
              <a:gd name="connsiteY0" fmla="*/ 36090 h 72218"/>
              <a:gd name="connsiteX1" fmla="*/ 0 w 72159"/>
              <a:gd name="connsiteY1" fmla="*/ 36090 h 72218"/>
              <a:gd name="connsiteX2" fmla="*/ 72160 w 72159"/>
              <a:gd name="connsiteY2" fmla="*/ 36090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218">
                <a:moveTo>
                  <a:pt x="72160" y="36090"/>
                </a:moveTo>
                <a:cubicBezTo>
                  <a:pt x="72160" y="84261"/>
                  <a:pt x="0" y="84261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tx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84" name="Forme libre : forme 283">
            <a:extLst>
              <a:ext uri="{FF2B5EF4-FFF2-40B4-BE49-F238E27FC236}">
                <a16:creationId xmlns:a16="http://schemas.microsoft.com/office/drawing/2014/main" id="{D3823949-ED41-4AAC-8FF1-1E0F4B3CE391}"/>
              </a:ext>
            </a:extLst>
          </p:cNvPr>
          <p:cNvSpPr/>
          <p:nvPr/>
        </p:nvSpPr>
        <p:spPr>
          <a:xfrm>
            <a:off x="9688629" y="5930679"/>
            <a:ext cx="108000" cy="108000"/>
          </a:xfrm>
          <a:custGeom>
            <a:avLst/>
            <a:gdLst>
              <a:gd name="connsiteX0" fmla="*/ 72147 w 72147"/>
              <a:gd name="connsiteY0" fmla="*/ 36090 h 72180"/>
              <a:gd name="connsiteX1" fmla="*/ 0 w 72147"/>
              <a:gd name="connsiteY1" fmla="*/ 36090 h 72180"/>
              <a:gd name="connsiteX2" fmla="*/ 72147 w 72147"/>
              <a:gd name="connsiteY2" fmla="*/ 36090 h 721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47" h="72180">
                <a:moveTo>
                  <a:pt x="72147" y="36090"/>
                </a:moveTo>
                <a:cubicBezTo>
                  <a:pt x="72147" y="84210"/>
                  <a:pt x="0" y="84210"/>
                  <a:pt x="0" y="36090"/>
                </a:cubicBezTo>
                <a:cubicBezTo>
                  <a:pt x="0" y="-12030"/>
                  <a:pt x="72147" y="-12030"/>
                  <a:pt x="72147" y="36090"/>
                </a:cubicBezTo>
              </a:path>
            </a:pathLst>
          </a:custGeom>
          <a:solidFill>
            <a:schemeClr val="tx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85" name="Forme libre : forme 284">
            <a:extLst>
              <a:ext uri="{FF2B5EF4-FFF2-40B4-BE49-F238E27FC236}">
                <a16:creationId xmlns:a16="http://schemas.microsoft.com/office/drawing/2014/main" id="{176D963A-2FAA-46F9-9D64-F8E8B307C2B7}"/>
              </a:ext>
            </a:extLst>
          </p:cNvPr>
          <p:cNvSpPr/>
          <p:nvPr/>
        </p:nvSpPr>
        <p:spPr>
          <a:xfrm>
            <a:off x="9228679" y="5433647"/>
            <a:ext cx="108000" cy="108000"/>
          </a:xfrm>
          <a:custGeom>
            <a:avLst/>
            <a:gdLst>
              <a:gd name="connsiteX0" fmla="*/ 72160 w 72159"/>
              <a:gd name="connsiteY0" fmla="*/ 36090 h 72218"/>
              <a:gd name="connsiteX1" fmla="*/ 0 w 72159"/>
              <a:gd name="connsiteY1" fmla="*/ 36090 h 72218"/>
              <a:gd name="connsiteX2" fmla="*/ 72160 w 72159"/>
              <a:gd name="connsiteY2" fmla="*/ 36090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218">
                <a:moveTo>
                  <a:pt x="72160" y="36090"/>
                </a:moveTo>
                <a:cubicBezTo>
                  <a:pt x="72160" y="84261"/>
                  <a:pt x="0" y="84261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tx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86" name="Forme libre : forme 285">
            <a:extLst>
              <a:ext uri="{FF2B5EF4-FFF2-40B4-BE49-F238E27FC236}">
                <a16:creationId xmlns:a16="http://schemas.microsoft.com/office/drawing/2014/main" id="{06E442BD-76BB-4995-A966-5F63EA060741}"/>
              </a:ext>
            </a:extLst>
          </p:cNvPr>
          <p:cNvSpPr/>
          <p:nvPr/>
        </p:nvSpPr>
        <p:spPr>
          <a:xfrm>
            <a:off x="9506471" y="7057245"/>
            <a:ext cx="108000" cy="108000"/>
          </a:xfrm>
          <a:custGeom>
            <a:avLst/>
            <a:gdLst>
              <a:gd name="connsiteX0" fmla="*/ 72147 w 72147"/>
              <a:gd name="connsiteY0" fmla="*/ 36090 h 72180"/>
              <a:gd name="connsiteX1" fmla="*/ 0 w 72147"/>
              <a:gd name="connsiteY1" fmla="*/ 36090 h 72180"/>
              <a:gd name="connsiteX2" fmla="*/ 72147 w 72147"/>
              <a:gd name="connsiteY2" fmla="*/ 36090 h 721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47" h="72180">
                <a:moveTo>
                  <a:pt x="72147" y="36090"/>
                </a:moveTo>
                <a:cubicBezTo>
                  <a:pt x="72147" y="84211"/>
                  <a:pt x="0" y="84211"/>
                  <a:pt x="0" y="36090"/>
                </a:cubicBezTo>
                <a:cubicBezTo>
                  <a:pt x="0" y="-12030"/>
                  <a:pt x="72147" y="-12030"/>
                  <a:pt x="72147" y="36090"/>
                </a:cubicBezTo>
              </a:path>
            </a:pathLst>
          </a:custGeom>
          <a:solidFill>
            <a:schemeClr val="bg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93" name="Forme libre : forme 292">
            <a:extLst>
              <a:ext uri="{FF2B5EF4-FFF2-40B4-BE49-F238E27FC236}">
                <a16:creationId xmlns:a16="http://schemas.microsoft.com/office/drawing/2014/main" id="{39E4C98B-E7DC-4FA5-ADBA-9540CBCD1E57}"/>
              </a:ext>
            </a:extLst>
          </p:cNvPr>
          <p:cNvSpPr/>
          <p:nvPr/>
        </p:nvSpPr>
        <p:spPr>
          <a:xfrm>
            <a:off x="9710126" y="5069177"/>
            <a:ext cx="108000" cy="108000"/>
          </a:xfrm>
          <a:custGeom>
            <a:avLst/>
            <a:gdLst>
              <a:gd name="connsiteX0" fmla="*/ 72160 w 72159"/>
              <a:gd name="connsiteY0" fmla="*/ 36090 h 72181"/>
              <a:gd name="connsiteX1" fmla="*/ 0 w 72159"/>
              <a:gd name="connsiteY1" fmla="*/ 36090 h 72181"/>
              <a:gd name="connsiteX2" fmla="*/ 72160 w 72159"/>
              <a:gd name="connsiteY2" fmla="*/ 36090 h 721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59" h="72181">
                <a:moveTo>
                  <a:pt x="72160" y="36090"/>
                </a:moveTo>
                <a:cubicBezTo>
                  <a:pt x="72160" y="84212"/>
                  <a:pt x="0" y="84212"/>
                  <a:pt x="0" y="36090"/>
                </a:cubicBezTo>
                <a:cubicBezTo>
                  <a:pt x="0" y="-12030"/>
                  <a:pt x="72160" y="-12030"/>
                  <a:pt x="72160" y="36090"/>
                </a:cubicBezTo>
              </a:path>
            </a:pathLst>
          </a:custGeom>
          <a:solidFill>
            <a:schemeClr val="bg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295" name="Forme libre : forme 294">
            <a:extLst>
              <a:ext uri="{FF2B5EF4-FFF2-40B4-BE49-F238E27FC236}">
                <a16:creationId xmlns:a16="http://schemas.microsoft.com/office/drawing/2014/main" id="{4C3FFDCF-8792-40AC-8C89-501B1B504066}"/>
              </a:ext>
            </a:extLst>
          </p:cNvPr>
          <p:cNvSpPr/>
          <p:nvPr/>
        </p:nvSpPr>
        <p:spPr>
          <a:xfrm>
            <a:off x="9805201" y="6560213"/>
            <a:ext cx="108000" cy="108000"/>
          </a:xfrm>
          <a:custGeom>
            <a:avLst/>
            <a:gdLst>
              <a:gd name="connsiteX0" fmla="*/ 72211 w 72210"/>
              <a:gd name="connsiteY0" fmla="*/ 36090 h 72218"/>
              <a:gd name="connsiteX1" fmla="*/ 0 w 72210"/>
              <a:gd name="connsiteY1" fmla="*/ 36090 h 72218"/>
              <a:gd name="connsiteX2" fmla="*/ 72211 w 72210"/>
              <a:gd name="connsiteY2" fmla="*/ 36090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210" h="72218">
                <a:moveTo>
                  <a:pt x="72211" y="36090"/>
                </a:moveTo>
                <a:cubicBezTo>
                  <a:pt x="72211" y="84261"/>
                  <a:pt x="0" y="84261"/>
                  <a:pt x="0" y="36090"/>
                </a:cubicBezTo>
                <a:cubicBezTo>
                  <a:pt x="0" y="-12030"/>
                  <a:pt x="72211" y="-12030"/>
                  <a:pt x="72211" y="36090"/>
                </a:cubicBezTo>
              </a:path>
            </a:pathLst>
          </a:custGeom>
          <a:solidFill>
            <a:schemeClr val="bg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1" name="Forme libre : forme 300">
            <a:extLst>
              <a:ext uri="{FF2B5EF4-FFF2-40B4-BE49-F238E27FC236}">
                <a16:creationId xmlns:a16="http://schemas.microsoft.com/office/drawing/2014/main" id="{EBE8DC44-36AA-47D4-B003-0B0A2301F51A}"/>
              </a:ext>
            </a:extLst>
          </p:cNvPr>
          <p:cNvSpPr/>
          <p:nvPr/>
        </p:nvSpPr>
        <p:spPr>
          <a:xfrm>
            <a:off x="10012092" y="6063214"/>
            <a:ext cx="108000" cy="108000"/>
          </a:xfrm>
          <a:custGeom>
            <a:avLst/>
            <a:gdLst>
              <a:gd name="connsiteX0" fmla="*/ 72147 w 72147"/>
              <a:gd name="connsiteY0" fmla="*/ 36090 h 72180"/>
              <a:gd name="connsiteX1" fmla="*/ 0 w 72147"/>
              <a:gd name="connsiteY1" fmla="*/ 36090 h 72180"/>
              <a:gd name="connsiteX2" fmla="*/ 72147 w 72147"/>
              <a:gd name="connsiteY2" fmla="*/ 36090 h 721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47" h="72180">
                <a:moveTo>
                  <a:pt x="72147" y="36090"/>
                </a:moveTo>
                <a:cubicBezTo>
                  <a:pt x="72147" y="84210"/>
                  <a:pt x="0" y="84210"/>
                  <a:pt x="0" y="36090"/>
                </a:cubicBezTo>
                <a:cubicBezTo>
                  <a:pt x="0" y="-12030"/>
                  <a:pt x="72147" y="-12030"/>
                  <a:pt x="72147" y="36090"/>
                </a:cubicBezTo>
              </a:path>
            </a:pathLst>
          </a:custGeom>
          <a:solidFill>
            <a:schemeClr val="bg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2" name="Forme libre : forme 301">
            <a:extLst>
              <a:ext uri="{FF2B5EF4-FFF2-40B4-BE49-F238E27FC236}">
                <a16:creationId xmlns:a16="http://schemas.microsoft.com/office/drawing/2014/main" id="{98D061DC-5D72-4D2F-B2AD-12CED065B65F}"/>
              </a:ext>
            </a:extLst>
          </p:cNvPr>
          <p:cNvSpPr/>
          <p:nvPr/>
        </p:nvSpPr>
        <p:spPr>
          <a:xfrm>
            <a:off x="9406443" y="5566188"/>
            <a:ext cx="108000" cy="108000"/>
          </a:xfrm>
          <a:custGeom>
            <a:avLst/>
            <a:gdLst>
              <a:gd name="connsiteX0" fmla="*/ 72198 w 72198"/>
              <a:gd name="connsiteY0" fmla="*/ 36128 h 72218"/>
              <a:gd name="connsiteX1" fmla="*/ 0 w 72198"/>
              <a:gd name="connsiteY1" fmla="*/ 36128 h 72218"/>
              <a:gd name="connsiteX2" fmla="*/ 72198 w 72198"/>
              <a:gd name="connsiteY2" fmla="*/ 36128 h 72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2198" h="72218">
                <a:moveTo>
                  <a:pt x="72198" y="36128"/>
                </a:moveTo>
                <a:cubicBezTo>
                  <a:pt x="72198" y="84249"/>
                  <a:pt x="0" y="84249"/>
                  <a:pt x="0" y="36128"/>
                </a:cubicBezTo>
                <a:cubicBezTo>
                  <a:pt x="0" y="-12043"/>
                  <a:pt x="72198" y="-12043"/>
                  <a:pt x="72198" y="36128"/>
                </a:cubicBezTo>
              </a:path>
            </a:pathLst>
          </a:custGeom>
          <a:solidFill>
            <a:schemeClr val="bg1"/>
          </a:solidFill>
          <a:ln w="3175" cap="rnd">
            <a:solidFill>
              <a:schemeClr val="tx1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3" name="Forme libre : forme 302">
            <a:extLst>
              <a:ext uri="{FF2B5EF4-FFF2-40B4-BE49-F238E27FC236}">
                <a16:creationId xmlns:a16="http://schemas.microsoft.com/office/drawing/2014/main" id="{B1182513-C92A-4025-AF33-19BE30038140}"/>
              </a:ext>
            </a:extLst>
          </p:cNvPr>
          <p:cNvSpPr/>
          <p:nvPr/>
        </p:nvSpPr>
        <p:spPr>
          <a:xfrm>
            <a:off x="7457871" y="4758346"/>
            <a:ext cx="7874" cy="2584475"/>
          </a:xfrm>
          <a:custGeom>
            <a:avLst/>
            <a:gdLst>
              <a:gd name="connsiteX0" fmla="*/ 0 w 12695"/>
              <a:gd name="connsiteY0" fmla="*/ 4984058 h 4984058"/>
              <a:gd name="connsiteX1" fmla="*/ 0 w 12695"/>
              <a:gd name="connsiteY1" fmla="*/ 0 h 49840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5" h="4984058">
                <a:moveTo>
                  <a:pt x="0" y="4984058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4" name="Forme libre : forme 303">
            <a:extLst>
              <a:ext uri="{FF2B5EF4-FFF2-40B4-BE49-F238E27FC236}">
                <a16:creationId xmlns:a16="http://schemas.microsoft.com/office/drawing/2014/main" id="{C7E60A14-8F68-4893-93DF-2D13DF860808}"/>
              </a:ext>
            </a:extLst>
          </p:cNvPr>
          <p:cNvSpPr/>
          <p:nvPr/>
        </p:nvSpPr>
        <p:spPr>
          <a:xfrm>
            <a:off x="7411745" y="7044620"/>
            <a:ext cx="54000" cy="6586"/>
          </a:xfrm>
          <a:custGeom>
            <a:avLst/>
            <a:gdLst>
              <a:gd name="connsiteX0" fmla="*/ 0 w 34763"/>
              <a:gd name="connsiteY0" fmla="*/ 0 h 12700"/>
              <a:gd name="connsiteX1" fmla="*/ 34763 w 3476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763" h="12700">
                <a:moveTo>
                  <a:pt x="0" y="0"/>
                </a:moveTo>
                <a:lnTo>
                  <a:pt x="34763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5" name="Forme libre : forme 304">
            <a:extLst>
              <a:ext uri="{FF2B5EF4-FFF2-40B4-BE49-F238E27FC236}">
                <a16:creationId xmlns:a16="http://schemas.microsoft.com/office/drawing/2014/main" id="{3F967CD2-63DB-42C6-BF0C-47B6F73D6BE3}"/>
              </a:ext>
            </a:extLst>
          </p:cNvPr>
          <p:cNvSpPr/>
          <p:nvPr/>
        </p:nvSpPr>
        <p:spPr>
          <a:xfrm>
            <a:off x="7411745" y="6547588"/>
            <a:ext cx="54000" cy="6586"/>
          </a:xfrm>
          <a:custGeom>
            <a:avLst/>
            <a:gdLst>
              <a:gd name="connsiteX0" fmla="*/ 0 w 34763"/>
              <a:gd name="connsiteY0" fmla="*/ 0 h 12700"/>
              <a:gd name="connsiteX1" fmla="*/ 34763 w 3476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763" h="12700">
                <a:moveTo>
                  <a:pt x="0" y="0"/>
                </a:moveTo>
                <a:lnTo>
                  <a:pt x="34763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6" name="Forme libre : forme 305">
            <a:extLst>
              <a:ext uri="{FF2B5EF4-FFF2-40B4-BE49-F238E27FC236}">
                <a16:creationId xmlns:a16="http://schemas.microsoft.com/office/drawing/2014/main" id="{6C85668C-B639-46A0-9FB7-2083B9B1AF82}"/>
              </a:ext>
            </a:extLst>
          </p:cNvPr>
          <p:cNvSpPr/>
          <p:nvPr/>
        </p:nvSpPr>
        <p:spPr>
          <a:xfrm>
            <a:off x="7411745" y="6050582"/>
            <a:ext cx="54000" cy="6586"/>
          </a:xfrm>
          <a:custGeom>
            <a:avLst/>
            <a:gdLst>
              <a:gd name="connsiteX0" fmla="*/ 0 w 34763"/>
              <a:gd name="connsiteY0" fmla="*/ 0 h 12700"/>
              <a:gd name="connsiteX1" fmla="*/ 34763 w 3476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763" h="12700">
                <a:moveTo>
                  <a:pt x="0" y="0"/>
                </a:moveTo>
                <a:lnTo>
                  <a:pt x="34763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7" name="Forme libre : forme 306">
            <a:extLst>
              <a:ext uri="{FF2B5EF4-FFF2-40B4-BE49-F238E27FC236}">
                <a16:creationId xmlns:a16="http://schemas.microsoft.com/office/drawing/2014/main" id="{BB5B21D6-67F6-4F27-8674-6F024E6F2E21}"/>
              </a:ext>
            </a:extLst>
          </p:cNvPr>
          <p:cNvSpPr/>
          <p:nvPr/>
        </p:nvSpPr>
        <p:spPr>
          <a:xfrm>
            <a:off x="7411745" y="5553550"/>
            <a:ext cx="54000" cy="6586"/>
          </a:xfrm>
          <a:custGeom>
            <a:avLst/>
            <a:gdLst>
              <a:gd name="connsiteX0" fmla="*/ 0 w 34763"/>
              <a:gd name="connsiteY0" fmla="*/ 0 h 12700"/>
              <a:gd name="connsiteX1" fmla="*/ 34763 w 3476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763" h="12700">
                <a:moveTo>
                  <a:pt x="0" y="0"/>
                </a:moveTo>
                <a:lnTo>
                  <a:pt x="34763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8" name="Forme libre : forme 307">
            <a:extLst>
              <a:ext uri="{FF2B5EF4-FFF2-40B4-BE49-F238E27FC236}">
                <a16:creationId xmlns:a16="http://schemas.microsoft.com/office/drawing/2014/main" id="{0F95709A-C62F-4525-A4FF-4D22A5BD56A4}"/>
              </a:ext>
            </a:extLst>
          </p:cNvPr>
          <p:cNvSpPr/>
          <p:nvPr/>
        </p:nvSpPr>
        <p:spPr>
          <a:xfrm>
            <a:off x="7411745" y="5056549"/>
            <a:ext cx="54000" cy="6586"/>
          </a:xfrm>
          <a:custGeom>
            <a:avLst/>
            <a:gdLst>
              <a:gd name="connsiteX0" fmla="*/ 0 w 34763"/>
              <a:gd name="connsiteY0" fmla="*/ 0 h 12700"/>
              <a:gd name="connsiteX1" fmla="*/ 34763 w 34763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763" h="12700">
                <a:moveTo>
                  <a:pt x="0" y="0"/>
                </a:moveTo>
                <a:lnTo>
                  <a:pt x="34763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09" name="Forme libre : forme 308">
            <a:extLst>
              <a:ext uri="{FF2B5EF4-FFF2-40B4-BE49-F238E27FC236}">
                <a16:creationId xmlns:a16="http://schemas.microsoft.com/office/drawing/2014/main" id="{A318AD7B-10AF-43EB-AC70-8C450856D695}"/>
              </a:ext>
            </a:extLst>
          </p:cNvPr>
          <p:cNvSpPr/>
          <p:nvPr/>
        </p:nvSpPr>
        <p:spPr>
          <a:xfrm>
            <a:off x="7457871" y="7342822"/>
            <a:ext cx="3610612" cy="6586"/>
          </a:xfrm>
          <a:custGeom>
            <a:avLst/>
            <a:gdLst>
              <a:gd name="connsiteX0" fmla="*/ 0 w 5821127"/>
              <a:gd name="connsiteY0" fmla="*/ 0 h 12700"/>
              <a:gd name="connsiteX1" fmla="*/ 5821128 w 5821127"/>
              <a:gd name="connsiteY1" fmla="*/ 0 h 12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21127" h="12700">
                <a:moveTo>
                  <a:pt x="0" y="0"/>
                </a:moveTo>
                <a:lnTo>
                  <a:pt x="5821128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10" name="Forme libre : forme 309">
            <a:extLst>
              <a:ext uri="{FF2B5EF4-FFF2-40B4-BE49-F238E27FC236}">
                <a16:creationId xmlns:a16="http://schemas.microsoft.com/office/drawing/2014/main" id="{34087322-4E05-4CA7-BA75-8C9AF98EBD11}"/>
              </a:ext>
            </a:extLst>
          </p:cNvPr>
          <p:cNvSpPr/>
          <p:nvPr/>
        </p:nvSpPr>
        <p:spPr>
          <a:xfrm>
            <a:off x="7702036" y="7342821"/>
            <a:ext cx="7874" cy="54000"/>
          </a:xfrm>
          <a:custGeom>
            <a:avLst/>
            <a:gdLst>
              <a:gd name="connsiteX0" fmla="*/ 0 w 12695"/>
              <a:gd name="connsiteY0" fmla="*/ 34773 h 34772"/>
              <a:gd name="connsiteX1" fmla="*/ 0 w 12695"/>
              <a:gd name="connsiteY1" fmla="*/ 0 h 347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5" h="34772">
                <a:moveTo>
                  <a:pt x="0" y="3477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11" name="Forme libre : forme 310">
            <a:extLst>
              <a:ext uri="{FF2B5EF4-FFF2-40B4-BE49-F238E27FC236}">
                <a16:creationId xmlns:a16="http://schemas.microsoft.com/office/drawing/2014/main" id="{40BA2D40-02A0-4A3E-823E-BC078F73325A}"/>
              </a:ext>
            </a:extLst>
          </p:cNvPr>
          <p:cNvSpPr/>
          <p:nvPr/>
        </p:nvSpPr>
        <p:spPr>
          <a:xfrm>
            <a:off x="8591595" y="7342821"/>
            <a:ext cx="7874" cy="54000"/>
          </a:xfrm>
          <a:custGeom>
            <a:avLst/>
            <a:gdLst>
              <a:gd name="connsiteX0" fmla="*/ 0 w 12695"/>
              <a:gd name="connsiteY0" fmla="*/ 34773 h 34772"/>
              <a:gd name="connsiteX1" fmla="*/ 0 w 12695"/>
              <a:gd name="connsiteY1" fmla="*/ 0 h 347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5" h="34772">
                <a:moveTo>
                  <a:pt x="0" y="3477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12" name="Forme libre : forme 311">
            <a:extLst>
              <a:ext uri="{FF2B5EF4-FFF2-40B4-BE49-F238E27FC236}">
                <a16:creationId xmlns:a16="http://schemas.microsoft.com/office/drawing/2014/main" id="{5198A386-187C-486F-A989-3E897FEA9C2A}"/>
              </a:ext>
            </a:extLst>
          </p:cNvPr>
          <p:cNvSpPr/>
          <p:nvPr/>
        </p:nvSpPr>
        <p:spPr>
          <a:xfrm>
            <a:off x="9481122" y="7342821"/>
            <a:ext cx="7874" cy="54000"/>
          </a:xfrm>
          <a:custGeom>
            <a:avLst/>
            <a:gdLst>
              <a:gd name="connsiteX0" fmla="*/ 0 w 12695"/>
              <a:gd name="connsiteY0" fmla="*/ 34773 h 34772"/>
              <a:gd name="connsiteX1" fmla="*/ 0 w 12695"/>
              <a:gd name="connsiteY1" fmla="*/ 0 h 347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5" h="34772">
                <a:moveTo>
                  <a:pt x="0" y="3477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313" name="Forme libre : forme 312">
            <a:extLst>
              <a:ext uri="{FF2B5EF4-FFF2-40B4-BE49-F238E27FC236}">
                <a16:creationId xmlns:a16="http://schemas.microsoft.com/office/drawing/2014/main" id="{AE7A106B-5412-4164-9895-A0144D1EEE26}"/>
              </a:ext>
            </a:extLst>
          </p:cNvPr>
          <p:cNvSpPr/>
          <p:nvPr/>
        </p:nvSpPr>
        <p:spPr>
          <a:xfrm>
            <a:off x="10370650" y="7342821"/>
            <a:ext cx="7874" cy="54000"/>
          </a:xfrm>
          <a:custGeom>
            <a:avLst/>
            <a:gdLst>
              <a:gd name="connsiteX0" fmla="*/ 0 w 12695"/>
              <a:gd name="connsiteY0" fmla="*/ 34773 h 34772"/>
              <a:gd name="connsiteX1" fmla="*/ 0 w 12695"/>
              <a:gd name="connsiteY1" fmla="*/ 0 h 347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5" h="34772">
                <a:moveTo>
                  <a:pt x="0" y="3477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grpSp>
        <p:nvGrpSpPr>
          <p:cNvPr id="315" name="Groupe 314">
            <a:extLst>
              <a:ext uri="{FF2B5EF4-FFF2-40B4-BE49-F238E27FC236}">
                <a16:creationId xmlns:a16="http://schemas.microsoft.com/office/drawing/2014/main" id="{581E1802-3AE6-44CD-BC69-7394970A9891}"/>
              </a:ext>
            </a:extLst>
          </p:cNvPr>
          <p:cNvGrpSpPr/>
          <p:nvPr/>
        </p:nvGrpSpPr>
        <p:grpSpPr>
          <a:xfrm>
            <a:off x="10437179" y="4989738"/>
            <a:ext cx="64097" cy="68830"/>
            <a:chOff x="4601778" y="1180807"/>
            <a:chExt cx="64097" cy="400547"/>
          </a:xfrm>
        </p:grpSpPr>
        <p:sp>
          <p:nvSpPr>
            <p:cNvPr id="317" name="Forme libre : forme 316">
              <a:extLst>
                <a:ext uri="{FF2B5EF4-FFF2-40B4-BE49-F238E27FC236}">
                  <a16:creationId xmlns:a16="http://schemas.microsoft.com/office/drawing/2014/main" id="{D6E47568-C678-43EB-B3F5-A4B8EF4DC2CB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18" name="Forme libre : forme 317">
              <a:extLst>
                <a:ext uri="{FF2B5EF4-FFF2-40B4-BE49-F238E27FC236}">
                  <a16:creationId xmlns:a16="http://schemas.microsoft.com/office/drawing/2014/main" id="{F2E0814B-CD95-446E-849E-945F46684A2B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19" name="Forme libre : forme 318">
              <a:extLst>
                <a:ext uri="{FF2B5EF4-FFF2-40B4-BE49-F238E27FC236}">
                  <a16:creationId xmlns:a16="http://schemas.microsoft.com/office/drawing/2014/main" id="{848A8E5B-FEAC-4222-9C5C-3DF2B370D9C6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16" name="ZoneTexte 315">
            <a:extLst>
              <a:ext uri="{FF2B5EF4-FFF2-40B4-BE49-F238E27FC236}">
                <a16:creationId xmlns:a16="http://schemas.microsoft.com/office/drawing/2014/main" id="{6B979BD4-8235-43D7-AB26-0E4C3F416160}"/>
              </a:ext>
            </a:extLst>
          </p:cNvPr>
          <p:cNvSpPr txBox="1"/>
          <p:nvPr/>
        </p:nvSpPr>
        <p:spPr>
          <a:xfrm>
            <a:off x="10431955" y="4883822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20</a:t>
            </a:r>
            <a:endParaRPr lang="fr-FR" sz="1050" i="1" dirty="0"/>
          </a:p>
        </p:txBody>
      </p:sp>
      <p:grpSp>
        <p:nvGrpSpPr>
          <p:cNvPr id="320" name="Groupe 319">
            <a:extLst>
              <a:ext uri="{FF2B5EF4-FFF2-40B4-BE49-F238E27FC236}">
                <a16:creationId xmlns:a16="http://schemas.microsoft.com/office/drawing/2014/main" id="{0BB5EDFF-280C-4019-BFCC-E3817642A21F}"/>
              </a:ext>
            </a:extLst>
          </p:cNvPr>
          <p:cNvGrpSpPr/>
          <p:nvPr/>
        </p:nvGrpSpPr>
        <p:grpSpPr>
          <a:xfrm>
            <a:off x="11308732" y="5054030"/>
            <a:ext cx="64097" cy="68830"/>
            <a:chOff x="4601778" y="1180807"/>
            <a:chExt cx="64097" cy="400547"/>
          </a:xfrm>
        </p:grpSpPr>
        <p:sp>
          <p:nvSpPr>
            <p:cNvPr id="321" name="Forme libre : forme 320">
              <a:extLst>
                <a:ext uri="{FF2B5EF4-FFF2-40B4-BE49-F238E27FC236}">
                  <a16:creationId xmlns:a16="http://schemas.microsoft.com/office/drawing/2014/main" id="{77158E2B-3D87-4199-93D1-5CE9177031D0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22" name="Forme libre : forme 321">
              <a:extLst>
                <a:ext uri="{FF2B5EF4-FFF2-40B4-BE49-F238E27FC236}">
                  <a16:creationId xmlns:a16="http://schemas.microsoft.com/office/drawing/2014/main" id="{92CBA24A-18A3-442B-A87F-0E7B058FDE73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23" name="Forme libre : forme 322">
              <a:extLst>
                <a:ext uri="{FF2B5EF4-FFF2-40B4-BE49-F238E27FC236}">
                  <a16:creationId xmlns:a16="http://schemas.microsoft.com/office/drawing/2014/main" id="{DD7D0B38-0EA8-4FFF-B43A-0AAD2C6E3415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24" name="ZoneTexte 323">
            <a:extLst>
              <a:ext uri="{FF2B5EF4-FFF2-40B4-BE49-F238E27FC236}">
                <a16:creationId xmlns:a16="http://schemas.microsoft.com/office/drawing/2014/main" id="{9644DFEE-DE5F-4895-BC9E-96D5FCD91289}"/>
              </a:ext>
            </a:extLst>
          </p:cNvPr>
          <p:cNvSpPr txBox="1"/>
          <p:nvPr/>
        </p:nvSpPr>
        <p:spPr>
          <a:xfrm>
            <a:off x="11308276" y="4952877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15</a:t>
            </a:r>
            <a:endParaRPr lang="fr-FR" sz="1050" i="1" dirty="0"/>
          </a:p>
        </p:txBody>
      </p:sp>
      <p:grpSp>
        <p:nvGrpSpPr>
          <p:cNvPr id="325" name="Groupe 324">
            <a:extLst>
              <a:ext uri="{FF2B5EF4-FFF2-40B4-BE49-F238E27FC236}">
                <a16:creationId xmlns:a16="http://schemas.microsoft.com/office/drawing/2014/main" id="{E63F8844-307E-47CD-B3D9-A6650ED4D7FD}"/>
              </a:ext>
            </a:extLst>
          </p:cNvPr>
          <p:cNvGrpSpPr/>
          <p:nvPr/>
        </p:nvGrpSpPr>
        <p:grpSpPr>
          <a:xfrm>
            <a:off x="10875346" y="4987405"/>
            <a:ext cx="64097" cy="135404"/>
            <a:chOff x="4601778" y="1180807"/>
            <a:chExt cx="64097" cy="400547"/>
          </a:xfrm>
        </p:grpSpPr>
        <p:sp>
          <p:nvSpPr>
            <p:cNvPr id="326" name="Forme libre : forme 325">
              <a:extLst>
                <a:ext uri="{FF2B5EF4-FFF2-40B4-BE49-F238E27FC236}">
                  <a16:creationId xmlns:a16="http://schemas.microsoft.com/office/drawing/2014/main" id="{AE2DCEC3-2744-400C-8BD5-3431AB23F2AA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27" name="Forme libre : forme 326">
              <a:extLst>
                <a:ext uri="{FF2B5EF4-FFF2-40B4-BE49-F238E27FC236}">
                  <a16:creationId xmlns:a16="http://schemas.microsoft.com/office/drawing/2014/main" id="{6F8F2250-A820-4C8E-8C4B-BC50B65A8690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28" name="Forme libre : forme 327">
              <a:extLst>
                <a:ext uri="{FF2B5EF4-FFF2-40B4-BE49-F238E27FC236}">
                  <a16:creationId xmlns:a16="http://schemas.microsoft.com/office/drawing/2014/main" id="{34902476-EAED-4C02-B32F-79482881035F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29" name="ZoneTexte 328">
            <a:extLst>
              <a:ext uri="{FF2B5EF4-FFF2-40B4-BE49-F238E27FC236}">
                <a16:creationId xmlns:a16="http://schemas.microsoft.com/office/drawing/2014/main" id="{9DBCD7B6-E096-4B5A-A8FA-083A5E2B96E0}"/>
              </a:ext>
            </a:extLst>
          </p:cNvPr>
          <p:cNvSpPr txBox="1"/>
          <p:nvPr/>
        </p:nvSpPr>
        <p:spPr>
          <a:xfrm>
            <a:off x="10870115" y="4914776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92</a:t>
            </a:r>
            <a:endParaRPr lang="fr-FR" sz="1050" i="1" dirty="0"/>
          </a:p>
        </p:txBody>
      </p:sp>
      <p:grpSp>
        <p:nvGrpSpPr>
          <p:cNvPr id="331" name="Groupe 330">
            <a:extLst>
              <a:ext uri="{FF2B5EF4-FFF2-40B4-BE49-F238E27FC236}">
                <a16:creationId xmlns:a16="http://schemas.microsoft.com/office/drawing/2014/main" id="{FCDD3047-F7D3-490B-A256-3BCBBD14F7C3}"/>
              </a:ext>
            </a:extLst>
          </p:cNvPr>
          <p:cNvGrpSpPr/>
          <p:nvPr/>
        </p:nvGrpSpPr>
        <p:grpSpPr>
          <a:xfrm>
            <a:off x="10437179" y="5489806"/>
            <a:ext cx="64097" cy="68830"/>
            <a:chOff x="4601778" y="1180807"/>
            <a:chExt cx="64097" cy="400547"/>
          </a:xfrm>
        </p:grpSpPr>
        <p:sp>
          <p:nvSpPr>
            <p:cNvPr id="333" name="Forme libre : forme 332">
              <a:extLst>
                <a:ext uri="{FF2B5EF4-FFF2-40B4-BE49-F238E27FC236}">
                  <a16:creationId xmlns:a16="http://schemas.microsoft.com/office/drawing/2014/main" id="{4C10E558-9DAD-45BF-903F-7E851B1BC49C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34" name="Forme libre : forme 333">
              <a:extLst>
                <a:ext uri="{FF2B5EF4-FFF2-40B4-BE49-F238E27FC236}">
                  <a16:creationId xmlns:a16="http://schemas.microsoft.com/office/drawing/2014/main" id="{EFE31CD0-B079-4DCC-893E-B4214878915E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35" name="Forme libre : forme 334">
              <a:extLst>
                <a:ext uri="{FF2B5EF4-FFF2-40B4-BE49-F238E27FC236}">
                  <a16:creationId xmlns:a16="http://schemas.microsoft.com/office/drawing/2014/main" id="{49319834-52E8-4C26-8B4F-25D99480A9D4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32" name="ZoneTexte 331">
            <a:extLst>
              <a:ext uri="{FF2B5EF4-FFF2-40B4-BE49-F238E27FC236}">
                <a16:creationId xmlns:a16="http://schemas.microsoft.com/office/drawing/2014/main" id="{866245C5-7A27-4636-8E7F-254E74280D84}"/>
              </a:ext>
            </a:extLst>
          </p:cNvPr>
          <p:cNvSpPr txBox="1"/>
          <p:nvPr/>
        </p:nvSpPr>
        <p:spPr>
          <a:xfrm>
            <a:off x="10431955" y="5383890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51</a:t>
            </a:r>
            <a:endParaRPr lang="fr-FR" sz="1050" i="1" dirty="0"/>
          </a:p>
        </p:txBody>
      </p:sp>
      <p:grpSp>
        <p:nvGrpSpPr>
          <p:cNvPr id="337" name="Groupe 336">
            <a:extLst>
              <a:ext uri="{FF2B5EF4-FFF2-40B4-BE49-F238E27FC236}">
                <a16:creationId xmlns:a16="http://schemas.microsoft.com/office/drawing/2014/main" id="{99074C45-B5B4-46A0-B157-34440691665A}"/>
              </a:ext>
            </a:extLst>
          </p:cNvPr>
          <p:cNvGrpSpPr/>
          <p:nvPr/>
        </p:nvGrpSpPr>
        <p:grpSpPr>
          <a:xfrm>
            <a:off x="11308732" y="5554098"/>
            <a:ext cx="64097" cy="68830"/>
            <a:chOff x="4601778" y="1180807"/>
            <a:chExt cx="64097" cy="400547"/>
          </a:xfrm>
        </p:grpSpPr>
        <p:sp>
          <p:nvSpPr>
            <p:cNvPr id="339" name="Forme libre : forme 338">
              <a:extLst>
                <a:ext uri="{FF2B5EF4-FFF2-40B4-BE49-F238E27FC236}">
                  <a16:creationId xmlns:a16="http://schemas.microsoft.com/office/drawing/2014/main" id="{0E0EE55E-57F6-4405-A5D8-C82267DD1E95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40" name="Forme libre : forme 339">
              <a:extLst>
                <a:ext uri="{FF2B5EF4-FFF2-40B4-BE49-F238E27FC236}">
                  <a16:creationId xmlns:a16="http://schemas.microsoft.com/office/drawing/2014/main" id="{FE592CB8-564E-4531-A32E-70196E4B37A9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41" name="Forme libre : forme 340">
              <a:extLst>
                <a:ext uri="{FF2B5EF4-FFF2-40B4-BE49-F238E27FC236}">
                  <a16:creationId xmlns:a16="http://schemas.microsoft.com/office/drawing/2014/main" id="{BE4D6510-5C78-4335-A06F-B6E99E8E4128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38" name="ZoneTexte 337">
            <a:extLst>
              <a:ext uri="{FF2B5EF4-FFF2-40B4-BE49-F238E27FC236}">
                <a16:creationId xmlns:a16="http://schemas.microsoft.com/office/drawing/2014/main" id="{B589C376-F291-4392-884F-7E72F6C53528}"/>
              </a:ext>
            </a:extLst>
          </p:cNvPr>
          <p:cNvSpPr txBox="1"/>
          <p:nvPr/>
        </p:nvSpPr>
        <p:spPr>
          <a:xfrm>
            <a:off x="11308276" y="5452945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51</a:t>
            </a:r>
            <a:endParaRPr lang="fr-FR" sz="1050" i="1" dirty="0"/>
          </a:p>
        </p:txBody>
      </p:sp>
      <p:grpSp>
        <p:nvGrpSpPr>
          <p:cNvPr id="343" name="Groupe 342">
            <a:extLst>
              <a:ext uri="{FF2B5EF4-FFF2-40B4-BE49-F238E27FC236}">
                <a16:creationId xmlns:a16="http://schemas.microsoft.com/office/drawing/2014/main" id="{FA696978-53A8-4B05-801B-D4225DDED9C8}"/>
              </a:ext>
            </a:extLst>
          </p:cNvPr>
          <p:cNvGrpSpPr/>
          <p:nvPr/>
        </p:nvGrpSpPr>
        <p:grpSpPr>
          <a:xfrm>
            <a:off x="10875346" y="5487473"/>
            <a:ext cx="64097" cy="135404"/>
            <a:chOff x="4601778" y="1180807"/>
            <a:chExt cx="64097" cy="400547"/>
          </a:xfrm>
        </p:grpSpPr>
        <p:sp>
          <p:nvSpPr>
            <p:cNvPr id="345" name="Forme libre : forme 344">
              <a:extLst>
                <a:ext uri="{FF2B5EF4-FFF2-40B4-BE49-F238E27FC236}">
                  <a16:creationId xmlns:a16="http://schemas.microsoft.com/office/drawing/2014/main" id="{F2290972-5F0F-4937-BFE4-EFA88A44B25A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46" name="Forme libre : forme 345">
              <a:extLst>
                <a:ext uri="{FF2B5EF4-FFF2-40B4-BE49-F238E27FC236}">
                  <a16:creationId xmlns:a16="http://schemas.microsoft.com/office/drawing/2014/main" id="{77B9C41D-D962-4F9A-A7D2-A21523B536D1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47" name="Forme libre : forme 346">
              <a:extLst>
                <a:ext uri="{FF2B5EF4-FFF2-40B4-BE49-F238E27FC236}">
                  <a16:creationId xmlns:a16="http://schemas.microsoft.com/office/drawing/2014/main" id="{BA78D441-4E90-44E7-8E80-4C6930229EFD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44" name="ZoneTexte 343">
            <a:extLst>
              <a:ext uri="{FF2B5EF4-FFF2-40B4-BE49-F238E27FC236}">
                <a16:creationId xmlns:a16="http://schemas.microsoft.com/office/drawing/2014/main" id="{6F973474-BC73-419B-97C7-74446F1B939D}"/>
              </a:ext>
            </a:extLst>
          </p:cNvPr>
          <p:cNvSpPr txBox="1"/>
          <p:nvPr/>
        </p:nvSpPr>
        <p:spPr>
          <a:xfrm>
            <a:off x="10870115" y="5414844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20</a:t>
            </a:r>
            <a:endParaRPr lang="fr-FR" sz="1050" i="1" dirty="0"/>
          </a:p>
        </p:txBody>
      </p:sp>
      <p:grpSp>
        <p:nvGrpSpPr>
          <p:cNvPr id="349" name="Groupe 348">
            <a:extLst>
              <a:ext uri="{FF2B5EF4-FFF2-40B4-BE49-F238E27FC236}">
                <a16:creationId xmlns:a16="http://schemas.microsoft.com/office/drawing/2014/main" id="{B0DD436B-67DD-44B8-82E1-4EF6DB803C86}"/>
              </a:ext>
            </a:extLst>
          </p:cNvPr>
          <p:cNvGrpSpPr/>
          <p:nvPr/>
        </p:nvGrpSpPr>
        <p:grpSpPr>
          <a:xfrm>
            <a:off x="10437179" y="5985118"/>
            <a:ext cx="64097" cy="68830"/>
            <a:chOff x="4601778" y="1180807"/>
            <a:chExt cx="64097" cy="400547"/>
          </a:xfrm>
        </p:grpSpPr>
        <p:sp>
          <p:nvSpPr>
            <p:cNvPr id="351" name="Forme libre : forme 350">
              <a:extLst>
                <a:ext uri="{FF2B5EF4-FFF2-40B4-BE49-F238E27FC236}">
                  <a16:creationId xmlns:a16="http://schemas.microsoft.com/office/drawing/2014/main" id="{CFD74121-1F4D-4EB6-ACD0-B32659170842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52" name="Forme libre : forme 351">
              <a:extLst>
                <a:ext uri="{FF2B5EF4-FFF2-40B4-BE49-F238E27FC236}">
                  <a16:creationId xmlns:a16="http://schemas.microsoft.com/office/drawing/2014/main" id="{69542BDA-B681-4314-9B1C-63A954B309D3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53" name="Forme libre : forme 352">
              <a:extLst>
                <a:ext uri="{FF2B5EF4-FFF2-40B4-BE49-F238E27FC236}">
                  <a16:creationId xmlns:a16="http://schemas.microsoft.com/office/drawing/2014/main" id="{BA66C6A9-7E66-4646-8EE5-5B2FED611CCF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50" name="ZoneTexte 349">
            <a:extLst>
              <a:ext uri="{FF2B5EF4-FFF2-40B4-BE49-F238E27FC236}">
                <a16:creationId xmlns:a16="http://schemas.microsoft.com/office/drawing/2014/main" id="{11B3844E-B807-4E1F-B2BA-624B1166E06D}"/>
              </a:ext>
            </a:extLst>
          </p:cNvPr>
          <p:cNvSpPr txBox="1"/>
          <p:nvPr/>
        </p:nvSpPr>
        <p:spPr>
          <a:xfrm>
            <a:off x="10431955" y="5879202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90</a:t>
            </a:r>
            <a:endParaRPr lang="fr-FR" sz="1050" i="1" dirty="0"/>
          </a:p>
        </p:txBody>
      </p:sp>
      <p:grpSp>
        <p:nvGrpSpPr>
          <p:cNvPr id="355" name="Groupe 354">
            <a:extLst>
              <a:ext uri="{FF2B5EF4-FFF2-40B4-BE49-F238E27FC236}">
                <a16:creationId xmlns:a16="http://schemas.microsoft.com/office/drawing/2014/main" id="{636606F9-2572-4C81-B593-0DC0DB078BAA}"/>
              </a:ext>
            </a:extLst>
          </p:cNvPr>
          <p:cNvGrpSpPr/>
          <p:nvPr/>
        </p:nvGrpSpPr>
        <p:grpSpPr>
          <a:xfrm>
            <a:off x="11308732" y="6049410"/>
            <a:ext cx="64097" cy="68830"/>
            <a:chOff x="4601778" y="1180807"/>
            <a:chExt cx="64097" cy="400547"/>
          </a:xfrm>
        </p:grpSpPr>
        <p:sp>
          <p:nvSpPr>
            <p:cNvPr id="357" name="Forme libre : forme 356">
              <a:extLst>
                <a:ext uri="{FF2B5EF4-FFF2-40B4-BE49-F238E27FC236}">
                  <a16:creationId xmlns:a16="http://schemas.microsoft.com/office/drawing/2014/main" id="{BA6EA3F7-9D3E-4CE1-97B1-C462E81D6029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58" name="Forme libre : forme 357">
              <a:extLst>
                <a:ext uri="{FF2B5EF4-FFF2-40B4-BE49-F238E27FC236}">
                  <a16:creationId xmlns:a16="http://schemas.microsoft.com/office/drawing/2014/main" id="{88E0BC34-CAE5-4B22-9F93-5A5BEBDA6BE7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59" name="Forme libre : forme 358">
              <a:extLst>
                <a:ext uri="{FF2B5EF4-FFF2-40B4-BE49-F238E27FC236}">
                  <a16:creationId xmlns:a16="http://schemas.microsoft.com/office/drawing/2014/main" id="{6FBAFA6A-1C61-461F-8F53-B0D23EBC599B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56" name="ZoneTexte 355">
            <a:extLst>
              <a:ext uri="{FF2B5EF4-FFF2-40B4-BE49-F238E27FC236}">
                <a16:creationId xmlns:a16="http://schemas.microsoft.com/office/drawing/2014/main" id="{191FA970-3D52-42B5-B857-EDB5FAF4283F}"/>
              </a:ext>
            </a:extLst>
          </p:cNvPr>
          <p:cNvSpPr txBox="1"/>
          <p:nvPr/>
        </p:nvSpPr>
        <p:spPr>
          <a:xfrm>
            <a:off x="11308276" y="5948257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68</a:t>
            </a:r>
            <a:endParaRPr lang="fr-FR" sz="1050" i="1" dirty="0"/>
          </a:p>
        </p:txBody>
      </p:sp>
      <p:grpSp>
        <p:nvGrpSpPr>
          <p:cNvPr id="361" name="Groupe 360">
            <a:extLst>
              <a:ext uri="{FF2B5EF4-FFF2-40B4-BE49-F238E27FC236}">
                <a16:creationId xmlns:a16="http://schemas.microsoft.com/office/drawing/2014/main" id="{B7ED99B8-56E0-405F-8877-E574140AD44F}"/>
              </a:ext>
            </a:extLst>
          </p:cNvPr>
          <p:cNvGrpSpPr/>
          <p:nvPr/>
        </p:nvGrpSpPr>
        <p:grpSpPr>
          <a:xfrm>
            <a:off x="10875346" y="5982785"/>
            <a:ext cx="64097" cy="135404"/>
            <a:chOff x="4601778" y="1180807"/>
            <a:chExt cx="64097" cy="400547"/>
          </a:xfrm>
        </p:grpSpPr>
        <p:sp>
          <p:nvSpPr>
            <p:cNvPr id="363" name="Forme libre : forme 362">
              <a:extLst>
                <a:ext uri="{FF2B5EF4-FFF2-40B4-BE49-F238E27FC236}">
                  <a16:creationId xmlns:a16="http://schemas.microsoft.com/office/drawing/2014/main" id="{6B4B9977-3D3E-496F-A0E8-4EC34D95C5EF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64" name="Forme libre : forme 363">
              <a:extLst>
                <a:ext uri="{FF2B5EF4-FFF2-40B4-BE49-F238E27FC236}">
                  <a16:creationId xmlns:a16="http://schemas.microsoft.com/office/drawing/2014/main" id="{37831894-B2AA-4965-A0E3-69DD0DC93C90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65" name="Forme libre : forme 364">
              <a:extLst>
                <a:ext uri="{FF2B5EF4-FFF2-40B4-BE49-F238E27FC236}">
                  <a16:creationId xmlns:a16="http://schemas.microsoft.com/office/drawing/2014/main" id="{2B611C2E-5A3B-46D1-BC51-9CDCD16086AD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62" name="ZoneTexte 361">
            <a:extLst>
              <a:ext uri="{FF2B5EF4-FFF2-40B4-BE49-F238E27FC236}">
                <a16:creationId xmlns:a16="http://schemas.microsoft.com/office/drawing/2014/main" id="{9876D56E-EBA6-456C-8379-FA80DE9E073F}"/>
              </a:ext>
            </a:extLst>
          </p:cNvPr>
          <p:cNvSpPr txBox="1"/>
          <p:nvPr/>
        </p:nvSpPr>
        <p:spPr>
          <a:xfrm>
            <a:off x="10870115" y="5910156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73</a:t>
            </a:r>
            <a:endParaRPr lang="fr-FR" sz="1050" i="1" dirty="0"/>
          </a:p>
        </p:txBody>
      </p:sp>
      <p:grpSp>
        <p:nvGrpSpPr>
          <p:cNvPr id="367" name="Groupe 366">
            <a:extLst>
              <a:ext uri="{FF2B5EF4-FFF2-40B4-BE49-F238E27FC236}">
                <a16:creationId xmlns:a16="http://schemas.microsoft.com/office/drawing/2014/main" id="{557009C0-383A-4A60-9FA5-108CBD6B982A}"/>
              </a:ext>
            </a:extLst>
          </p:cNvPr>
          <p:cNvGrpSpPr/>
          <p:nvPr/>
        </p:nvGrpSpPr>
        <p:grpSpPr>
          <a:xfrm>
            <a:off x="10437179" y="6480425"/>
            <a:ext cx="64097" cy="68830"/>
            <a:chOff x="4601778" y="1180807"/>
            <a:chExt cx="64097" cy="400547"/>
          </a:xfrm>
        </p:grpSpPr>
        <p:sp>
          <p:nvSpPr>
            <p:cNvPr id="369" name="Forme libre : forme 368">
              <a:extLst>
                <a:ext uri="{FF2B5EF4-FFF2-40B4-BE49-F238E27FC236}">
                  <a16:creationId xmlns:a16="http://schemas.microsoft.com/office/drawing/2014/main" id="{14DF0AD1-A225-4B82-8148-69D9F9DFFCA9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70" name="Forme libre : forme 369">
              <a:extLst>
                <a:ext uri="{FF2B5EF4-FFF2-40B4-BE49-F238E27FC236}">
                  <a16:creationId xmlns:a16="http://schemas.microsoft.com/office/drawing/2014/main" id="{3CC20B6F-1E68-47DB-8473-19C10EAD25C0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71" name="Forme libre : forme 370">
              <a:extLst>
                <a:ext uri="{FF2B5EF4-FFF2-40B4-BE49-F238E27FC236}">
                  <a16:creationId xmlns:a16="http://schemas.microsoft.com/office/drawing/2014/main" id="{75BCF1D6-A735-414A-82E1-526B1C4A3DA2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68" name="ZoneTexte 367">
            <a:extLst>
              <a:ext uri="{FF2B5EF4-FFF2-40B4-BE49-F238E27FC236}">
                <a16:creationId xmlns:a16="http://schemas.microsoft.com/office/drawing/2014/main" id="{2124057A-8525-47C0-B195-B1A6D2408FD9}"/>
              </a:ext>
            </a:extLst>
          </p:cNvPr>
          <p:cNvSpPr txBox="1"/>
          <p:nvPr/>
        </p:nvSpPr>
        <p:spPr>
          <a:xfrm>
            <a:off x="10431955" y="6374509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45</a:t>
            </a:r>
            <a:endParaRPr lang="fr-FR" sz="1050" i="1" dirty="0"/>
          </a:p>
        </p:txBody>
      </p:sp>
      <p:grpSp>
        <p:nvGrpSpPr>
          <p:cNvPr id="373" name="Groupe 372">
            <a:extLst>
              <a:ext uri="{FF2B5EF4-FFF2-40B4-BE49-F238E27FC236}">
                <a16:creationId xmlns:a16="http://schemas.microsoft.com/office/drawing/2014/main" id="{B7E41535-D710-401C-B794-547229481B60}"/>
              </a:ext>
            </a:extLst>
          </p:cNvPr>
          <p:cNvGrpSpPr/>
          <p:nvPr/>
        </p:nvGrpSpPr>
        <p:grpSpPr>
          <a:xfrm>
            <a:off x="11308732" y="6544717"/>
            <a:ext cx="64097" cy="68830"/>
            <a:chOff x="4601778" y="1180807"/>
            <a:chExt cx="64097" cy="400547"/>
          </a:xfrm>
        </p:grpSpPr>
        <p:sp>
          <p:nvSpPr>
            <p:cNvPr id="375" name="Forme libre : forme 374">
              <a:extLst>
                <a:ext uri="{FF2B5EF4-FFF2-40B4-BE49-F238E27FC236}">
                  <a16:creationId xmlns:a16="http://schemas.microsoft.com/office/drawing/2014/main" id="{BBA86734-B89B-4FD3-BEEF-A62177983D5B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76" name="Forme libre : forme 375">
              <a:extLst>
                <a:ext uri="{FF2B5EF4-FFF2-40B4-BE49-F238E27FC236}">
                  <a16:creationId xmlns:a16="http://schemas.microsoft.com/office/drawing/2014/main" id="{4FD56402-9AEB-4284-BDC0-5E7D11029443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77" name="Forme libre : forme 376">
              <a:extLst>
                <a:ext uri="{FF2B5EF4-FFF2-40B4-BE49-F238E27FC236}">
                  <a16:creationId xmlns:a16="http://schemas.microsoft.com/office/drawing/2014/main" id="{C4EC2395-D7B6-449E-8432-45B50F1D9D1F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74" name="ZoneTexte 373">
            <a:extLst>
              <a:ext uri="{FF2B5EF4-FFF2-40B4-BE49-F238E27FC236}">
                <a16:creationId xmlns:a16="http://schemas.microsoft.com/office/drawing/2014/main" id="{A5A35CD8-16BF-40C8-91B0-07DE2C3AE53C}"/>
              </a:ext>
            </a:extLst>
          </p:cNvPr>
          <p:cNvSpPr txBox="1"/>
          <p:nvPr/>
        </p:nvSpPr>
        <p:spPr>
          <a:xfrm>
            <a:off x="11308276" y="6443564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15</a:t>
            </a:r>
            <a:endParaRPr lang="fr-FR" sz="1050" i="1" dirty="0"/>
          </a:p>
        </p:txBody>
      </p:sp>
      <p:grpSp>
        <p:nvGrpSpPr>
          <p:cNvPr id="379" name="Groupe 378">
            <a:extLst>
              <a:ext uri="{FF2B5EF4-FFF2-40B4-BE49-F238E27FC236}">
                <a16:creationId xmlns:a16="http://schemas.microsoft.com/office/drawing/2014/main" id="{8DA29246-B42F-4ADB-A26E-1C9C30E08A93}"/>
              </a:ext>
            </a:extLst>
          </p:cNvPr>
          <p:cNvGrpSpPr/>
          <p:nvPr/>
        </p:nvGrpSpPr>
        <p:grpSpPr>
          <a:xfrm>
            <a:off x="10875346" y="6478092"/>
            <a:ext cx="64097" cy="135404"/>
            <a:chOff x="4601778" y="1180807"/>
            <a:chExt cx="64097" cy="400547"/>
          </a:xfrm>
        </p:grpSpPr>
        <p:sp>
          <p:nvSpPr>
            <p:cNvPr id="381" name="Forme libre : forme 380">
              <a:extLst>
                <a:ext uri="{FF2B5EF4-FFF2-40B4-BE49-F238E27FC236}">
                  <a16:creationId xmlns:a16="http://schemas.microsoft.com/office/drawing/2014/main" id="{6F2D428E-442D-4B59-ADF6-5A29553B091B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82" name="Forme libre : forme 381">
              <a:extLst>
                <a:ext uri="{FF2B5EF4-FFF2-40B4-BE49-F238E27FC236}">
                  <a16:creationId xmlns:a16="http://schemas.microsoft.com/office/drawing/2014/main" id="{4DC84751-CC08-44A7-9344-6EAE26057A8D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83" name="Forme libre : forme 382">
              <a:extLst>
                <a:ext uri="{FF2B5EF4-FFF2-40B4-BE49-F238E27FC236}">
                  <a16:creationId xmlns:a16="http://schemas.microsoft.com/office/drawing/2014/main" id="{E00079FB-0285-425D-ABF4-897FF0C4B432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80" name="ZoneTexte 379">
            <a:extLst>
              <a:ext uri="{FF2B5EF4-FFF2-40B4-BE49-F238E27FC236}">
                <a16:creationId xmlns:a16="http://schemas.microsoft.com/office/drawing/2014/main" id="{E70562C4-C719-46D1-9D2F-31E0D0566FE3}"/>
              </a:ext>
            </a:extLst>
          </p:cNvPr>
          <p:cNvSpPr txBox="1"/>
          <p:nvPr/>
        </p:nvSpPr>
        <p:spPr>
          <a:xfrm>
            <a:off x="10870115" y="6405463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58</a:t>
            </a:r>
            <a:endParaRPr lang="fr-FR" sz="1050" i="1" dirty="0"/>
          </a:p>
        </p:txBody>
      </p:sp>
      <p:grpSp>
        <p:nvGrpSpPr>
          <p:cNvPr id="385" name="Groupe 384">
            <a:extLst>
              <a:ext uri="{FF2B5EF4-FFF2-40B4-BE49-F238E27FC236}">
                <a16:creationId xmlns:a16="http://schemas.microsoft.com/office/drawing/2014/main" id="{BBE7E66E-B320-491E-8EDC-A57F453F019E}"/>
              </a:ext>
            </a:extLst>
          </p:cNvPr>
          <p:cNvGrpSpPr/>
          <p:nvPr/>
        </p:nvGrpSpPr>
        <p:grpSpPr>
          <a:xfrm>
            <a:off x="10437179" y="6980496"/>
            <a:ext cx="64097" cy="68830"/>
            <a:chOff x="4601778" y="1180807"/>
            <a:chExt cx="64097" cy="400547"/>
          </a:xfrm>
        </p:grpSpPr>
        <p:sp>
          <p:nvSpPr>
            <p:cNvPr id="387" name="Forme libre : forme 386">
              <a:extLst>
                <a:ext uri="{FF2B5EF4-FFF2-40B4-BE49-F238E27FC236}">
                  <a16:creationId xmlns:a16="http://schemas.microsoft.com/office/drawing/2014/main" id="{4A334F93-AD4E-4EF5-904F-84CB98021A02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88" name="Forme libre : forme 387">
              <a:extLst>
                <a:ext uri="{FF2B5EF4-FFF2-40B4-BE49-F238E27FC236}">
                  <a16:creationId xmlns:a16="http://schemas.microsoft.com/office/drawing/2014/main" id="{279BF057-EAF5-45B1-B12D-D99C4BF9115F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89" name="Forme libre : forme 388">
              <a:extLst>
                <a:ext uri="{FF2B5EF4-FFF2-40B4-BE49-F238E27FC236}">
                  <a16:creationId xmlns:a16="http://schemas.microsoft.com/office/drawing/2014/main" id="{ABCADDF9-D8C9-4653-B7C6-AEAA7A0E954E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86" name="ZoneTexte 385">
            <a:extLst>
              <a:ext uri="{FF2B5EF4-FFF2-40B4-BE49-F238E27FC236}">
                <a16:creationId xmlns:a16="http://schemas.microsoft.com/office/drawing/2014/main" id="{27D77ACE-BF8B-4611-8DD5-720F50120C69}"/>
              </a:ext>
            </a:extLst>
          </p:cNvPr>
          <p:cNvSpPr txBox="1"/>
          <p:nvPr/>
        </p:nvSpPr>
        <p:spPr>
          <a:xfrm>
            <a:off x="10431955" y="6874580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53</a:t>
            </a:r>
            <a:endParaRPr lang="fr-FR" sz="1050" i="1" dirty="0"/>
          </a:p>
        </p:txBody>
      </p:sp>
      <p:grpSp>
        <p:nvGrpSpPr>
          <p:cNvPr id="391" name="Groupe 390">
            <a:extLst>
              <a:ext uri="{FF2B5EF4-FFF2-40B4-BE49-F238E27FC236}">
                <a16:creationId xmlns:a16="http://schemas.microsoft.com/office/drawing/2014/main" id="{E93B9E4B-AD0C-46DF-AFE0-E2408730A88A}"/>
              </a:ext>
            </a:extLst>
          </p:cNvPr>
          <p:cNvGrpSpPr/>
          <p:nvPr/>
        </p:nvGrpSpPr>
        <p:grpSpPr>
          <a:xfrm>
            <a:off x="11308732" y="7044788"/>
            <a:ext cx="64097" cy="68830"/>
            <a:chOff x="4601778" y="1180807"/>
            <a:chExt cx="64097" cy="400547"/>
          </a:xfrm>
        </p:grpSpPr>
        <p:sp>
          <p:nvSpPr>
            <p:cNvPr id="393" name="Forme libre : forme 392">
              <a:extLst>
                <a:ext uri="{FF2B5EF4-FFF2-40B4-BE49-F238E27FC236}">
                  <a16:creationId xmlns:a16="http://schemas.microsoft.com/office/drawing/2014/main" id="{282ABC08-6EB0-4D00-BFC0-C83344EF2F50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94" name="Forme libre : forme 393">
              <a:extLst>
                <a:ext uri="{FF2B5EF4-FFF2-40B4-BE49-F238E27FC236}">
                  <a16:creationId xmlns:a16="http://schemas.microsoft.com/office/drawing/2014/main" id="{CB42C6C4-C5CC-44BF-A96D-721171BAB5ED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95" name="Forme libre : forme 394">
              <a:extLst>
                <a:ext uri="{FF2B5EF4-FFF2-40B4-BE49-F238E27FC236}">
                  <a16:creationId xmlns:a16="http://schemas.microsoft.com/office/drawing/2014/main" id="{E1E4F9CA-18CC-4FE4-BC12-603F20018BD0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92" name="ZoneTexte 391">
            <a:extLst>
              <a:ext uri="{FF2B5EF4-FFF2-40B4-BE49-F238E27FC236}">
                <a16:creationId xmlns:a16="http://schemas.microsoft.com/office/drawing/2014/main" id="{7DE5677D-0F34-4A46-A929-00EEFBB3172E}"/>
              </a:ext>
            </a:extLst>
          </p:cNvPr>
          <p:cNvSpPr txBox="1"/>
          <p:nvPr/>
        </p:nvSpPr>
        <p:spPr>
          <a:xfrm>
            <a:off x="11308276" y="6943635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>
                <a:ea typeface="Times New Roman" panose="02020603050405020304" pitchFamily="18" charset="0"/>
              </a:rPr>
              <a:t>15</a:t>
            </a:r>
            <a:endParaRPr lang="fr-FR" sz="1050" i="1" dirty="0"/>
          </a:p>
        </p:txBody>
      </p:sp>
      <p:grpSp>
        <p:nvGrpSpPr>
          <p:cNvPr id="397" name="Groupe 396">
            <a:extLst>
              <a:ext uri="{FF2B5EF4-FFF2-40B4-BE49-F238E27FC236}">
                <a16:creationId xmlns:a16="http://schemas.microsoft.com/office/drawing/2014/main" id="{0A077996-4968-42EF-9EEF-AFC959D4E978}"/>
              </a:ext>
            </a:extLst>
          </p:cNvPr>
          <p:cNvGrpSpPr/>
          <p:nvPr/>
        </p:nvGrpSpPr>
        <p:grpSpPr>
          <a:xfrm>
            <a:off x="10875346" y="6978163"/>
            <a:ext cx="64097" cy="135404"/>
            <a:chOff x="4601778" y="1180807"/>
            <a:chExt cx="64097" cy="400547"/>
          </a:xfrm>
        </p:grpSpPr>
        <p:sp>
          <p:nvSpPr>
            <p:cNvPr id="399" name="Forme libre : forme 398">
              <a:extLst>
                <a:ext uri="{FF2B5EF4-FFF2-40B4-BE49-F238E27FC236}">
                  <a16:creationId xmlns:a16="http://schemas.microsoft.com/office/drawing/2014/main" id="{2E7AE23F-01B0-4C97-BEB7-0ACFB22D3856}"/>
                </a:ext>
              </a:extLst>
            </p:cNvPr>
            <p:cNvSpPr/>
            <p:nvPr/>
          </p:nvSpPr>
          <p:spPr>
            <a:xfrm>
              <a:off x="4601778" y="1568654"/>
              <a:ext cx="51396" cy="12700"/>
            </a:xfrm>
            <a:custGeom>
              <a:avLst/>
              <a:gdLst>
                <a:gd name="connsiteX0" fmla="*/ 0 w 51396"/>
                <a:gd name="connsiteY0" fmla="*/ 0 h 12700"/>
                <a:gd name="connsiteX1" fmla="*/ 51397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0" y="0"/>
                  </a:moveTo>
                  <a:lnTo>
                    <a:pt x="51397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00" name="Forme libre : forme 399">
              <a:extLst>
                <a:ext uri="{FF2B5EF4-FFF2-40B4-BE49-F238E27FC236}">
                  <a16:creationId xmlns:a16="http://schemas.microsoft.com/office/drawing/2014/main" id="{8F75C875-603E-4B68-AA12-DF420C9C8793}"/>
                </a:ext>
              </a:extLst>
            </p:cNvPr>
            <p:cNvSpPr/>
            <p:nvPr/>
          </p:nvSpPr>
          <p:spPr>
            <a:xfrm>
              <a:off x="4653175" y="1180807"/>
              <a:ext cx="12700" cy="387846"/>
            </a:xfrm>
            <a:custGeom>
              <a:avLst/>
              <a:gdLst>
                <a:gd name="connsiteX0" fmla="*/ 0 w 12700"/>
                <a:gd name="connsiteY0" fmla="*/ 387847 h 387846"/>
                <a:gd name="connsiteX1" fmla="*/ 0 w 12700"/>
                <a:gd name="connsiteY1" fmla="*/ 0 h 3878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0" h="387846">
                  <a:moveTo>
                    <a:pt x="0" y="387847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01" name="Forme libre : forme 400">
              <a:extLst>
                <a:ext uri="{FF2B5EF4-FFF2-40B4-BE49-F238E27FC236}">
                  <a16:creationId xmlns:a16="http://schemas.microsoft.com/office/drawing/2014/main" id="{18690082-DE1E-4AF6-A2F7-F13B37D52B1F}"/>
                </a:ext>
              </a:extLst>
            </p:cNvPr>
            <p:cNvSpPr/>
            <p:nvPr/>
          </p:nvSpPr>
          <p:spPr>
            <a:xfrm>
              <a:off x="4601778" y="1180807"/>
              <a:ext cx="51396" cy="12700"/>
            </a:xfrm>
            <a:custGeom>
              <a:avLst/>
              <a:gdLst>
                <a:gd name="connsiteX0" fmla="*/ 51397 w 51396"/>
                <a:gd name="connsiteY0" fmla="*/ 0 h 12700"/>
                <a:gd name="connsiteX1" fmla="*/ 0 w 51396"/>
                <a:gd name="connsiteY1" fmla="*/ 0 h 12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396" h="12700">
                  <a:moveTo>
                    <a:pt x="51397" y="0"/>
                  </a:moveTo>
                  <a:lnTo>
                    <a:pt x="0" y="0"/>
                  </a:lnTo>
                </a:path>
              </a:pathLst>
            </a:custGeom>
            <a:noFill/>
            <a:ln w="8130" cap="rnd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398" name="ZoneTexte 397">
            <a:extLst>
              <a:ext uri="{FF2B5EF4-FFF2-40B4-BE49-F238E27FC236}">
                <a16:creationId xmlns:a16="http://schemas.microsoft.com/office/drawing/2014/main" id="{6E6AFEA2-01AB-4AD4-9692-2A3BC752D830}"/>
              </a:ext>
            </a:extLst>
          </p:cNvPr>
          <p:cNvSpPr txBox="1"/>
          <p:nvPr/>
        </p:nvSpPr>
        <p:spPr>
          <a:xfrm>
            <a:off x="10870115" y="6905534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i="1" dirty="0">
                <a:cs typeface="Times New Roman" panose="02020603050405020304" pitchFamily="18" charset="0"/>
              </a:rPr>
              <a:t>0</a:t>
            </a:r>
            <a:r>
              <a:rPr lang="en-GB" sz="1050" i="1" dirty="0">
                <a:cs typeface="Times New Roman" panose="02020603050405020304" pitchFamily="18" charset="0"/>
              </a:rPr>
              <a:t>.</a:t>
            </a:r>
            <a:r>
              <a:rPr lang="en-GB" sz="1050" i="1" dirty="0">
                <a:ea typeface="Times New Roman" panose="02020603050405020304" pitchFamily="18" charset="0"/>
              </a:rPr>
              <a:t>26</a:t>
            </a:r>
            <a:endParaRPr lang="fr-FR" sz="1050" i="1" dirty="0"/>
          </a:p>
        </p:txBody>
      </p:sp>
    </p:spTree>
    <p:extLst>
      <p:ext uri="{BB962C8B-B14F-4D97-AF65-F5344CB8AC3E}">
        <p14:creationId xmlns:p14="http://schemas.microsoft.com/office/powerpoint/2010/main" val="10047860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0</TotalTime>
  <Words>189</Words>
  <Application>Microsoft Office PowerPoint</Application>
  <PresentationFormat>Personnalisé</PresentationFormat>
  <Paragraphs>8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ism 8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ROSBOIS Cloé</dc:creator>
  <cp:lastModifiedBy>GROSBOIS Cloé</cp:lastModifiedBy>
  <cp:revision>48</cp:revision>
  <dcterms:created xsi:type="dcterms:W3CDTF">2024-07-26T07:49:44Z</dcterms:created>
  <dcterms:modified xsi:type="dcterms:W3CDTF">2024-11-13T15:18:07Z</dcterms:modified>
</cp:coreProperties>
</file>